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4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bccfile1.louisville.edu\share\Park%20Lab\Paper\AF1q%20+%20ICAM-1\FPKMs.MLLT11.ICAM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[FPKMs.MLLT11.ICAM1.xlsx]Sheet1!$D$1</c:f>
              <c:strCache>
                <c:ptCount val="1"/>
                <c:pt idx="0">
                  <c:v>ICAM1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[FPKMs.MLLT11.ICAM1.xlsx]Sheet1!$C$2:$C$1223</c:f>
              <c:numCache>
                <c:formatCode>General</c:formatCode>
                <c:ptCount val="1222"/>
                <c:pt idx="0">
                  <c:v>2.6229473789900002</c:v>
                </c:pt>
                <c:pt idx="1">
                  <c:v>3.6544748926700001</c:v>
                </c:pt>
                <c:pt idx="2">
                  <c:v>1.8296533909799999</c:v>
                </c:pt>
                <c:pt idx="3">
                  <c:v>4.2140980679600002</c:v>
                </c:pt>
                <c:pt idx="4">
                  <c:v>4.7234573544199998</c:v>
                </c:pt>
                <c:pt idx="5">
                  <c:v>3.5100865729000001</c:v>
                </c:pt>
                <c:pt idx="6">
                  <c:v>2.9546003326500001</c:v>
                </c:pt>
                <c:pt idx="7">
                  <c:v>0.89542297156799999</c:v>
                </c:pt>
                <c:pt idx="8">
                  <c:v>4.5015932528400002</c:v>
                </c:pt>
                <c:pt idx="9">
                  <c:v>2.7745463190400002</c:v>
                </c:pt>
                <c:pt idx="10">
                  <c:v>2.0157920244700001</c:v>
                </c:pt>
                <c:pt idx="11">
                  <c:v>2.5952846379099999</c:v>
                </c:pt>
                <c:pt idx="12">
                  <c:v>2.1088009296400001</c:v>
                </c:pt>
                <c:pt idx="13">
                  <c:v>2.8408897337300001</c:v>
                </c:pt>
                <c:pt idx="14">
                  <c:v>0.97905440957000001</c:v>
                </c:pt>
                <c:pt idx="15">
                  <c:v>2.18080373958</c:v>
                </c:pt>
                <c:pt idx="16">
                  <c:v>7.9838527244500002</c:v>
                </c:pt>
                <c:pt idx="17">
                  <c:v>2.9475663725499999</c:v>
                </c:pt>
                <c:pt idx="18">
                  <c:v>2.1485422412599999</c:v>
                </c:pt>
                <c:pt idx="19">
                  <c:v>1.2790406087399999</c:v>
                </c:pt>
                <c:pt idx="20">
                  <c:v>2.3782933332199998</c:v>
                </c:pt>
                <c:pt idx="21">
                  <c:v>2.8176147026899998</c:v>
                </c:pt>
                <c:pt idx="22">
                  <c:v>3.55646260898</c:v>
                </c:pt>
                <c:pt idx="23">
                  <c:v>4.8114182328900004</c:v>
                </c:pt>
                <c:pt idx="24">
                  <c:v>2.99579548007</c:v>
                </c:pt>
                <c:pt idx="25">
                  <c:v>4.2894723817299996</c:v>
                </c:pt>
                <c:pt idx="26">
                  <c:v>2.1025603477899999</c:v>
                </c:pt>
                <c:pt idx="27">
                  <c:v>2.64629556051</c:v>
                </c:pt>
                <c:pt idx="28">
                  <c:v>2.2640519028699999</c:v>
                </c:pt>
                <c:pt idx="29">
                  <c:v>1.45992908293</c:v>
                </c:pt>
                <c:pt idx="30">
                  <c:v>2.4716859478100002</c:v>
                </c:pt>
                <c:pt idx="31">
                  <c:v>3.2794028557199999</c:v>
                </c:pt>
                <c:pt idx="32">
                  <c:v>1.6341708197</c:v>
                </c:pt>
                <c:pt idx="33">
                  <c:v>1.23896585173</c:v>
                </c:pt>
                <c:pt idx="34">
                  <c:v>2.0754789353500001</c:v>
                </c:pt>
                <c:pt idx="35">
                  <c:v>1.8646527498300001</c:v>
                </c:pt>
                <c:pt idx="36">
                  <c:v>3.8279045272299999</c:v>
                </c:pt>
                <c:pt idx="37">
                  <c:v>3.7973109303300001</c:v>
                </c:pt>
                <c:pt idx="38">
                  <c:v>2.8227806753000002</c:v>
                </c:pt>
                <c:pt idx="39">
                  <c:v>1.78622921934</c:v>
                </c:pt>
                <c:pt idx="40">
                  <c:v>3.4032351415200002</c:v>
                </c:pt>
                <c:pt idx="41">
                  <c:v>0.79180340340400002</c:v>
                </c:pt>
                <c:pt idx="42">
                  <c:v>1.6853263643</c:v>
                </c:pt>
                <c:pt idx="43">
                  <c:v>2.4163367657900001</c:v>
                </c:pt>
                <c:pt idx="44">
                  <c:v>2.8141829328500001</c:v>
                </c:pt>
                <c:pt idx="45">
                  <c:v>16.182310145900001</c:v>
                </c:pt>
                <c:pt idx="46">
                  <c:v>1.5254441060299999</c:v>
                </c:pt>
                <c:pt idx="47">
                  <c:v>3.2080536203099999</c:v>
                </c:pt>
                <c:pt idx="48">
                  <c:v>1.5061118758300001</c:v>
                </c:pt>
                <c:pt idx="49">
                  <c:v>3.2111895453199999</c:v>
                </c:pt>
                <c:pt idx="50">
                  <c:v>4.7055647762200001</c:v>
                </c:pt>
                <c:pt idx="51">
                  <c:v>1.9358629912700001</c:v>
                </c:pt>
                <c:pt idx="52">
                  <c:v>1.4627928828400001</c:v>
                </c:pt>
                <c:pt idx="53">
                  <c:v>2.2630036444199999</c:v>
                </c:pt>
                <c:pt idx="54">
                  <c:v>2.0441578599599999</c:v>
                </c:pt>
                <c:pt idx="55">
                  <c:v>2.6155358763600001</c:v>
                </c:pt>
                <c:pt idx="56">
                  <c:v>1.35430225903</c:v>
                </c:pt>
                <c:pt idx="57">
                  <c:v>4.0970632081899998</c:v>
                </c:pt>
                <c:pt idx="58">
                  <c:v>12.25671803</c:v>
                </c:pt>
                <c:pt idx="59">
                  <c:v>2.11872976085</c:v>
                </c:pt>
                <c:pt idx="60">
                  <c:v>2.2324068781099999</c:v>
                </c:pt>
                <c:pt idx="61">
                  <c:v>2.7046185753900001</c:v>
                </c:pt>
                <c:pt idx="62">
                  <c:v>1.89440273359</c:v>
                </c:pt>
                <c:pt idx="63">
                  <c:v>1.1077038747600001</c:v>
                </c:pt>
                <c:pt idx="64">
                  <c:v>1.82231827217</c:v>
                </c:pt>
                <c:pt idx="65">
                  <c:v>1.6985040841100001</c:v>
                </c:pt>
                <c:pt idx="66">
                  <c:v>2.9762841770600001</c:v>
                </c:pt>
                <c:pt idx="67">
                  <c:v>5.2059825155799997</c:v>
                </c:pt>
                <c:pt idx="68">
                  <c:v>2.83012740682</c:v>
                </c:pt>
                <c:pt idx="69">
                  <c:v>1.40329862553</c:v>
                </c:pt>
                <c:pt idx="70">
                  <c:v>1.7924043438399999</c:v>
                </c:pt>
                <c:pt idx="71">
                  <c:v>2.5058119788100002</c:v>
                </c:pt>
                <c:pt idx="72">
                  <c:v>1.7483889967299999</c:v>
                </c:pt>
                <c:pt idx="73">
                  <c:v>2.3703254019100002</c:v>
                </c:pt>
                <c:pt idx="74">
                  <c:v>3.5869444337399998</c:v>
                </c:pt>
                <c:pt idx="75">
                  <c:v>3.04938761856</c:v>
                </c:pt>
                <c:pt idx="76">
                  <c:v>11.223264567399999</c:v>
                </c:pt>
                <c:pt idx="77">
                  <c:v>2.2730179026499999</c:v>
                </c:pt>
                <c:pt idx="78">
                  <c:v>1.89870898982</c:v>
                </c:pt>
                <c:pt idx="79">
                  <c:v>3.1287414172000001</c:v>
                </c:pt>
                <c:pt idx="80">
                  <c:v>5.03583586344</c:v>
                </c:pt>
                <c:pt idx="81">
                  <c:v>1.8927310703</c:v>
                </c:pt>
                <c:pt idx="82">
                  <c:v>1.76393064464</c:v>
                </c:pt>
                <c:pt idx="83">
                  <c:v>1.5289338618599999</c:v>
                </c:pt>
                <c:pt idx="84">
                  <c:v>1.45992638281</c:v>
                </c:pt>
                <c:pt idx="85">
                  <c:v>2.2949817503199998</c:v>
                </c:pt>
                <c:pt idx="86">
                  <c:v>2.7162560010300001</c:v>
                </c:pt>
                <c:pt idx="87">
                  <c:v>3.5387220032100002</c:v>
                </c:pt>
                <c:pt idx="88">
                  <c:v>3.70622540938</c:v>
                </c:pt>
                <c:pt idx="89">
                  <c:v>2.65388109995</c:v>
                </c:pt>
                <c:pt idx="90">
                  <c:v>7.1324991125499997</c:v>
                </c:pt>
                <c:pt idx="91">
                  <c:v>3.3349486610999999</c:v>
                </c:pt>
                <c:pt idx="92">
                  <c:v>3.5862628301899999</c:v>
                </c:pt>
                <c:pt idx="93">
                  <c:v>2.2617091240699998</c:v>
                </c:pt>
                <c:pt idx="94">
                  <c:v>1.7090362727499999</c:v>
                </c:pt>
                <c:pt idx="95">
                  <c:v>8.3099059986100006</c:v>
                </c:pt>
                <c:pt idx="96">
                  <c:v>2.1100242045700002</c:v>
                </c:pt>
                <c:pt idx="97">
                  <c:v>4.2973135469699999</c:v>
                </c:pt>
                <c:pt idx="98">
                  <c:v>2.7286094057899999</c:v>
                </c:pt>
                <c:pt idx="99">
                  <c:v>2.9354563275999999</c:v>
                </c:pt>
                <c:pt idx="100">
                  <c:v>2.9843176643099998</c:v>
                </c:pt>
                <c:pt idx="101">
                  <c:v>2.0683987986100001</c:v>
                </c:pt>
                <c:pt idx="102">
                  <c:v>4.2933491257499998</c:v>
                </c:pt>
                <c:pt idx="103">
                  <c:v>2.9863811284700001</c:v>
                </c:pt>
                <c:pt idx="104">
                  <c:v>1.9755603874100001</c:v>
                </c:pt>
                <c:pt idx="105">
                  <c:v>9.1951650605400008</c:v>
                </c:pt>
                <c:pt idx="106">
                  <c:v>2.99210392644</c:v>
                </c:pt>
                <c:pt idx="107">
                  <c:v>0.76183611796399997</c:v>
                </c:pt>
                <c:pt idx="108">
                  <c:v>1.6203562332599999</c:v>
                </c:pt>
                <c:pt idx="109">
                  <c:v>3.7869255807200002</c:v>
                </c:pt>
                <c:pt idx="110">
                  <c:v>2.7304724995199998</c:v>
                </c:pt>
                <c:pt idx="111">
                  <c:v>1.1781222821299999</c:v>
                </c:pt>
                <c:pt idx="112">
                  <c:v>3.5046223533399998</c:v>
                </c:pt>
                <c:pt idx="113">
                  <c:v>1.13708606983</c:v>
                </c:pt>
                <c:pt idx="114">
                  <c:v>17.608709492199999</c:v>
                </c:pt>
                <c:pt idx="115">
                  <c:v>1.9196402212200001</c:v>
                </c:pt>
                <c:pt idx="116">
                  <c:v>2.59486168857</c:v>
                </c:pt>
                <c:pt idx="117">
                  <c:v>1.2322660782699999</c:v>
                </c:pt>
                <c:pt idx="118">
                  <c:v>1.75618583277</c:v>
                </c:pt>
                <c:pt idx="119">
                  <c:v>3.4594529062600001</c:v>
                </c:pt>
                <c:pt idx="120">
                  <c:v>2.47471981744</c:v>
                </c:pt>
                <c:pt idx="121">
                  <c:v>3.5462084787200001</c:v>
                </c:pt>
                <c:pt idx="122">
                  <c:v>2.0039331547699999</c:v>
                </c:pt>
                <c:pt idx="123">
                  <c:v>2.6675365433999998</c:v>
                </c:pt>
                <c:pt idx="124">
                  <c:v>2.3265319390300001</c:v>
                </c:pt>
                <c:pt idx="125">
                  <c:v>1.8280322119100001</c:v>
                </c:pt>
                <c:pt idx="126">
                  <c:v>7.5936419188500004</c:v>
                </c:pt>
                <c:pt idx="127">
                  <c:v>2.32562418919</c:v>
                </c:pt>
                <c:pt idx="128">
                  <c:v>9.3307079915299997</c:v>
                </c:pt>
                <c:pt idx="129">
                  <c:v>1.6917111461600001</c:v>
                </c:pt>
                <c:pt idx="130">
                  <c:v>3.2617567162999999</c:v>
                </c:pt>
                <c:pt idx="131">
                  <c:v>1.97652178141</c:v>
                </c:pt>
                <c:pt idx="132">
                  <c:v>1.0262798341199999</c:v>
                </c:pt>
                <c:pt idx="133">
                  <c:v>2.8117449274599999</c:v>
                </c:pt>
                <c:pt idx="134">
                  <c:v>7.1667973577300002</c:v>
                </c:pt>
                <c:pt idx="135">
                  <c:v>2.7278746098500002</c:v>
                </c:pt>
                <c:pt idx="136">
                  <c:v>3.5301180525000002</c:v>
                </c:pt>
                <c:pt idx="137">
                  <c:v>1.31502633016</c:v>
                </c:pt>
                <c:pt idx="138">
                  <c:v>3.88985131949</c:v>
                </c:pt>
                <c:pt idx="139">
                  <c:v>1.2869793543200001</c:v>
                </c:pt>
                <c:pt idx="140">
                  <c:v>2.0220292638999999</c:v>
                </c:pt>
                <c:pt idx="141">
                  <c:v>5.0036981094800002</c:v>
                </c:pt>
                <c:pt idx="142">
                  <c:v>6.4107154468600003</c:v>
                </c:pt>
                <c:pt idx="143">
                  <c:v>2.6995696205500002</c:v>
                </c:pt>
                <c:pt idx="144">
                  <c:v>2.9225391419300002</c:v>
                </c:pt>
                <c:pt idx="145">
                  <c:v>2.5709533435999998</c:v>
                </c:pt>
                <c:pt idx="146">
                  <c:v>1.93349265018</c:v>
                </c:pt>
                <c:pt idx="147">
                  <c:v>1.65040038049</c:v>
                </c:pt>
                <c:pt idx="148">
                  <c:v>1.9584317589</c:v>
                </c:pt>
                <c:pt idx="149">
                  <c:v>2.2949786510700001</c:v>
                </c:pt>
                <c:pt idx="150">
                  <c:v>2.2680283669499999</c:v>
                </c:pt>
                <c:pt idx="151">
                  <c:v>1.72095080474</c:v>
                </c:pt>
                <c:pt idx="152">
                  <c:v>1.09459324468</c:v>
                </c:pt>
                <c:pt idx="153">
                  <c:v>3.18009053259</c:v>
                </c:pt>
                <c:pt idx="154">
                  <c:v>2.8999946469500002</c:v>
                </c:pt>
                <c:pt idx="155">
                  <c:v>4.3680657350200001</c:v>
                </c:pt>
                <c:pt idx="156">
                  <c:v>3.5220886513999998</c:v>
                </c:pt>
                <c:pt idx="157">
                  <c:v>2.35542966563</c:v>
                </c:pt>
                <c:pt idx="158">
                  <c:v>2.3148795334300001</c:v>
                </c:pt>
                <c:pt idx="159">
                  <c:v>11.8985653947</c:v>
                </c:pt>
                <c:pt idx="160">
                  <c:v>4.2365183877100003</c:v>
                </c:pt>
                <c:pt idx="161">
                  <c:v>0.68860703354399999</c:v>
                </c:pt>
                <c:pt idx="162">
                  <c:v>2.7114979415699998</c:v>
                </c:pt>
                <c:pt idx="163">
                  <c:v>1.92175492596</c:v>
                </c:pt>
                <c:pt idx="164">
                  <c:v>3.42594932623</c:v>
                </c:pt>
                <c:pt idx="165">
                  <c:v>3.7968043524000001</c:v>
                </c:pt>
                <c:pt idx="166">
                  <c:v>3.4199382165099999</c:v>
                </c:pt>
                <c:pt idx="167">
                  <c:v>3.6138733040600002</c:v>
                </c:pt>
                <c:pt idx="168">
                  <c:v>1.44739763277</c:v>
                </c:pt>
                <c:pt idx="169">
                  <c:v>11.489811298899999</c:v>
                </c:pt>
                <c:pt idx="170">
                  <c:v>5.5767167015399997</c:v>
                </c:pt>
                <c:pt idx="171">
                  <c:v>3.5783758265099999</c:v>
                </c:pt>
                <c:pt idx="172">
                  <c:v>1.17251345176</c:v>
                </c:pt>
                <c:pt idx="173">
                  <c:v>3.0994638979200002</c:v>
                </c:pt>
                <c:pt idx="174">
                  <c:v>0.56559529607799996</c:v>
                </c:pt>
                <c:pt idx="175">
                  <c:v>2.4945483478499999</c:v>
                </c:pt>
                <c:pt idx="176">
                  <c:v>3.6925742113800002</c:v>
                </c:pt>
                <c:pt idx="177">
                  <c:v>4.4144409607100004</c:v>
                </c:pt>
                <c:pt idx="178">
                  <c:v>2.4930339694599999</c:v>
                </c:pt>
                <c:pt idx="179">
                  <c:v>3.44436303202</c:v>
                </c:pt>
                <c:pt idx="180">
                  <c:v>17.5681136209</c:v>
                </c:pt>
                <c:pt idx="181">
                  <c:v>2.5418917952500002</c:v>
                </c:pt>
                <c:pt idx="182">
                  <c:v>2.4895353236800002</c:v>
                </c:pt>
                <c:pt idx="183">
                  <c:v>2.3411391844499998</c:v>
                </c:pt>
                <c:pt idx="184">
                  <c:v>1.68496471518</c:v>
                </c:pt>
                <c:pt idx="185">
                  <c:v>3.7942356843199998</c:v>
                </c:pt>
                <c:pt idx="186">
                  <c:v>9.3054119261799997</c:v>
                </c:pt>
                <c:pt idx="187">
                  <c:v>2.9664641328400001</c:v>
                </c:pt>
                <c:pt idx="188">
                  <c:v>0.30587722754800001</c:v>
                </c:pt>
                <c:pt idx="189">
                  <c:v>1.7151476594899999</c:v>
                </c:pt>
                <c:pt idx="190">
                  <c:v>1.44947362265</c:v>
                </c:pt>
                <c:pt idx="191">
                  <c:v>10.403552021099999</c:v>
                </c:pt>
                <c:pt idx="192">
                  <c:v>3.3340077662700001</c:v>
                </c:pt>
                <c:pt idx="193">
                  <c:v>3.5934142629600001</c:v>
                </c:pt>
                <c:pt idx="194">
                  <c:v>1.0971963759100001</c:v>
                </c:pt>
                <c:pt idx="195">
                  <c:v>1.1727409306500001</c:v>
                </c:pt>
                <c:pt idx="196">
                  <c:v>5.4212125445100003</c:v>
                </c:pt>
                <c:pt idx="197">
                  <c:v>2.3243831937900001</c:v>
                </c:pt>
                <c:pt idx="198">
                  <c:v>4.2698864316999998</c:v>
                </c:pt>
                <c:pt idx="199">
                  <c:v>2.83263837893</c:v>
                </c:pt>
                <c:pt idx="200">
                  <c:v>5.9577433601400003</c:v>
                </c:pt>
                <c:pt idx="201">
                  <c:v>0.95853145871099998</c:v>
                </c:pt>
                <c:pt idx="202">
                  <c:v>2.4836259482099998</c:v>
                </c:pt>
                <c:pt idx="203">
                  <c:v>2.0438913990200001</c:v>
                </c:pt>
                <c:pt idx="204">
                  <c:v>0.88792032249800001</c:v>
                </c:pt>
                <c:pt idx="205">
                  <c:v>4.0343103291600002</c:v>
                </c:pt>
                <c:pt idx="206">
                  <c:v>2.0768047632400002</c:v>
                </c:pt>
                <c:pt idx="207">
                  <c:v>2.63411198965</c:v>
                </c:pt>
                <c:pt idx="208">
                  <c:v>1.6190308062700001</c:v>
                </c:pt>
                <c:pt idx="209">
                  <c:v>2.6713277449500001</c:v>
                </c:pt>
                <c:pt idx="210">
                  <c:v>3.34980887022</c:v>
                </c:pt>
                <c:pt idx="211">
                  <c:v>3.3508930906800001</c:v>
                </c:pt>
                <c:pt idx="212">
                  <c:v>2.1212973975099998</c:v>
                </c:pt>
                <c:pt idx="213">
                  <c:v>2.0869097752800001</c:v>
                </c:pt>
                <c:pt idx="214">
                  <c:v>22.696884714500001</c:v>
                </c:pt>
                <c:pt idx="215">
                  <c:v>0.77216776661800002</c:v>
                </c:pt>
                <c:pt idx="216">
                  <c:v>2.0844424570100002</c:v>
                </c:pt>
                <c:pt idx="217">
                  <c:v>1.3019349413900001</c:v>
                </c:pt>
                <c:pt idx="218">
                  <c:v>22.074665490299999</c:v>
                </c:pt>
                <c:pt idx="219">
                  <c:v>1.7293777251</c:v>
                </c:pt>
                <c:pt idx="220">
                  <c:v>2.9376873845299998</c:v>
                </c:pt>
                <c:pt idx="221">
                  <c:v>1.5680113228599999</c:v>
                </c:pt>
                <c:pt idx="222">
                  <c:v>13.6756206812</c:v>
                </c:pt>
                <c:pt idx="223">
                  <c:v>2.4641356132899999</c:v>
                </c:pt>
                <c:pt idx="224">
                  <c:v>2.9427641220099998</c:v>
                </c:pt>
                <c:pt idx="225">
                  <c:v>1.32952568564</c:v>
                </c:pt>
                <c:pt idx="226">
                  <c:v>8.3928120611299999</c:v>
                </c:pt>
                <c:pt idx="227">
                  <c:v>0.92617608312300004</c:v>
                </c:pt>
                <c:pt idx="228">
                  <c:v>3.26474898238</c:v>
                </c:pt>
                <c:pt idx="229">
                  <c:v>2.8586439611099999</c:v>
                </c:pt>
                <c:pt idx="230">
                  <c:v>2.0712577098499998</c:v>
                </c:pt>
                <c:pt idx="231">
                  <c:v>4.9356617286500004</c:v>
                </c:pt>
                <c:pt idx="232">
                  <c:v>0.57277128473100003</c:v>
                </c:pt>
                <c:pt idx="233">
                  <c:v>1.37400098866</c:v>
                </c:pt>
                <c:pt idx="234">
                  <c:v>3.0618106454</c:v>
                </c:pt>
                <c:pt idx="235">
                  <c:v>5.2317542285099998</c:v>
                </c:pt>
                <c:pt idx="236">
                  <c:v>3.2083348418400002</c:v>
                </c:pt>
                <c:pt idx="237">
                  <c:v>5.4668126486000004</c:v>
                </c:pt>
                <c:pt idx="238">
                  <c:v>1.2402620018899999</c:v>
                </c:pt>
                <c:pt idx="239">
                  <c:v>1.98679934403</c:v>
                </c:pt>
                <c:pt idx="240">
                  <c:v>1.8691114524100001</c:v>
                </c:pt>
                <c:pt idx="241">
                  <c:v>0.82752093154700002</c:v>
                </c:pt>
                <c:pt idx="242">
                  <c:v>3.2655863578200002</c:v>
                </c:pt>
                <c:pt idx="243">
                  <c:v>3.3271655948699999</c:v>
                </c:pt>
                <c:pt idx="244">
                  <c:v>1.57775530516</c:v>
                </c:pt>
                <c:pt idx="245">
                  <c:v>1.4112866932000001</c:v>
                </c:pt>
                <c:pt idx="246">
                  <c:v>2.0925859499800001</c:v>
                </c:pt>
                <c:pt idx="247">
                  <c:v>0.89619504397500005</c:v>
                </c:pt>
                <c:pt idx="248">
                  <c:v>4.85858417749</c:v>
                </c:pt>
                <c:pt idx="249">
                  <c:v>2.0458171549499999</c:v>
                </c:pt>
                <c:pt idx="250">
                  <c:v>5.6099847538700001</c:v>
                </c:pt>
                <c:pt idx="251">
                  <c:v>2.27156588283</c:v>
                </c:pt>
                <c:pt idx="252">
                  <c:v>1.9412379896500001</c:v>
                </c:pt>
                <c:pt idx="253">
                  <c:v>4.6490487166900003</c:v>
                </c:pt>
                <c:pt idx="254">
                  <c:v>2.3024927309800001</c:v>
                </c:pt>
                <c:pt idx="255">
                  <c:v>1.1569197987099999</c:v>
                </c:pt>
                <c:pt idx="256">
                  <c:v>2.1057018738200002</c:v>
                </c:pt>
                <c:pt idx="257">
                  <c:v>1.4027357929499999</c:v>
                </c:pt>
                <c:pt idx="258">
                  <c:v>2.0244113009400002</c:v>
                </c:pt>
                <c:pt idx="259">
                  <c:v>1.72442885236</c:v>
                </c:pt>
                <c:pt idx="260">
                  <c:v>3.1566442464</c:v>
                </c:pt>
                <c:pt idx="261">
                  <c:v>1.1934946120700001</c:v>
                </c:pt>
                <c:pt idx="262">
                  <c:v>2.0157438062300002</c:v>
                </c:pt>
                <c:pt idx="263">
                  <c:v>2.3408576976700002</c:v>
                </c:pt>
                <c:pt idx="264">
                  <c:v>2.7964480908599998</c:v>
                </c:pt>
                <c:pt idx="265">
                  <c:v>7.2875805441599999</c:v>
                </c:pt>
                <c:pt idx="266">
                  <c:v>3.58850202034</c:v>
                </c:pt>
                <c:pt idx="267">
                  <c:v>3.3641350645800001</c:v>
                </c:pt>
                <c:pt idx="268">
                  <c:v>2.0219113496499999</c:v>
                </c:pt>
                <c:pt idx="269">
                  <c:v>1.5848124380599999</c:v>
                </c:pt>
                <c:pt idx="270">
                  <c:v>24.200813227200001</c:v>
                </c:pt>
                <c:pt idx="271">
                  <c:v>2.7090925565199999</c:v>
                </c:pt>
                <c:pt idx="272">
                  <c:v>2.03059851073</c:v>
                </c:pt>
                <c:pt idx="273">
                  <c:v>5.5489049586599997</c:v>
                </c:pt>
                <c:pt idx="274">
                  <c:v>3.2559466807400002</c:v>
                </c:pt>
                <c:pt idx="275">
                  <c:v>1.7338518732999999</c:v>
                </c:pt>
                <c:pt idx="276">
                  <c:v>2.0977953194899999</c:v>
                </c:pt>
                <c:pt idx="277">
                  <c:v>1.1463230578400001</c:v>
                </c:pt>
                <c:pt idx="278">
                  <c:v>4.6100629697700004</c:v>
                </c:pt>
                <c:pt idx="279">
                  <c:v>1.3156684571899999</c:v>
                </c:pt>
                <c:pt idx="280">
                  <c:v>2.9593485294500002</c:v>
                </c:pt>
                <c:pt idx="281">
                  <c:v>3.8958974244700002</c:v>
                </c:pt>
                <c:pt idx="282">
                  <c:v>1.99334130799</c:v>
                </c:pt>
                <c:pt idx="283">
                  <c:v>1.7757457803500001</c:v>
                </c:pt>
                <c:pt idx="284">
                  <c:v>3.3027727976699999</c:v>
                </c:pt>
                <c:pt idx="285">
                  <c:v>1.8145279166999999</c:v>
                </c:pt>
                <c:pt idx="286">
                  <c:v>1.7183717897999999</c:v>
                </c:pt>
                <c:pt idx="287">
                  <c:v>3.5772705166900001</c:v>
                </c:pt>
                <c:pt idx="288">
                  <c:v>1.71600983893</c:v>
                </c:pt>
                <c:pt idx="289">
                  <c:v>2.5958050535699999</c:v>
                </c:pt>
                <c:pt idx="290">
                  <c:v>1.21597192711</c:v>
                </c:pt>
                <c:pt idx="291">
                  <c:v>1.8826365431000001</c:v>
                </c:pt>
                <c:pt idx="292">
                  <c:v>18.911804870800001</c:v>
                </c:pt>
                <c:pt idx="293">
                  <c:v>1.2236782181800001</c:v>
                </c:pt>
                <c:pt idx="294">
                  <c:v>3.01740511132</c:v>
                </c:pt>
                <c:pt idx="295">
                  <c:v>2.0148906108000002</c:v>
                </c:pt>
                <c:pt idx="296">
                  <c:v>2.6474561190000001</c:v>
                </c:pt>
                <c:pt idx="297">
                  <c:v>3.2221149909300002</c:v>
                </c:pt>
                <c:pt idx="298">
                  <c:v>2.60046279658</c:v>
                </c:pt>
                <c:pt idx="299">
                  <c:v>2.2633988671099998</c:v>
                </c:pt>
                <c:pt idx="300">
                  <c:v>3.60391151382</c:v>
                </c:pt>
                <c:pt idx="301">
                  <c:v>2.0674365966699999</c:v>
                </c:pt>
                <c:pt idx="302">
                  <c:v>6.8310666396600004</c:v>
                </c:pt>
                <c:pt idx="303">
                  <c:v>1.9384179187699999</c:v>
                </c:pt>
                <c:pt idx="304">
                  <c:v>2.0105850516600001</c:v>
                </c:pt>
                <c:pt idx="305">
                  <c:v>3.1473624095999999</c:v>
                </c:pt>
                <c:pt idx="306">
                  <c:v>3.12452097785</c:v>
                </c:pt>
                <c:pt idx="307">
                  <c:v>2.1441591075700002</c:v>
                </c:pt>
                <c:pt idx="308">
                  <c:v>2.12422520863</c:v>
                </c:pt>
                <c:pt idx="309">
                  <c:v>5.2368923587199996</c:v>
                </c:pt>
                <c:pt idx="310">
                  <c:v>2.4627888796900002</c:v>
                </c:pt>
                <c:pt idx="311">
                  <c:v>4.1752476221199997</c:v>
                </c:pt>
                <c:pt idx="312">
                  <c:v>2.8564152426399998</c:v>
                </c:pt>
                <c:pt idx="313">
                  <c:v>4.2340622479699999</c:v>
                </c:pt>
                <c:pt idx="314">
                  <c:v>1.85300028222</c:v>
                </c:pt>
                <c:pt idx="315">
                  <c:v>1.6227867763099999</c:v>
                </c:pt>
                <c:pt idx="316">
                  <c:v>2.90012364138</c:v>
                </c:pt>
                <c:pt idx="317">
                  <c:v>2.5504300387200001</c:v>
                </c:pt>
                <c:pt idx="318">
                  <c:v>1.98822583311</c:v>
                </c:pt>
                <c:pt idx="319">
                  <c:v>2.0151800800899999</c:v>
                </c:pt>
                <c:pt idx="320">
                  <c:v>6.2598923269200002</c:v>
                </c:pt>
                <c:pt idx="321">
                  <c:v>3.9344955264800001</c:v>
                </c:pt>
                <c:pt idx="322">
                  <c:v>1.65038167821</c:v>
                </c:pt>
                <c:pt idx="323">
                  <c:v>2.9015752146899998</c:v>
                </c:pt>
                <c:pt idx="324">
                  <c:v>2.36376660554</c:v>
                </c:pt>
                <c:pt idx="325">
                  <c:v>2.95777059041</c:v>
                </c:pt>
                <c:pt idx="326">
                  <c:v>2.4337447165600001</c:v>
                </c:pt>
                <c:pt idx="327">
                  <c:v>1.94460065385</c:v>
                </c:pt>
                <c:pt idx="328">
                  <c:v>3.1876969201100001</c:v>
                </c:pt>
                <c:pt idx="329">
                  <c:v>1.9763470008899999</c:v>
                </c:pt>
                <c:pt idx="330">
                  <c:v>2.1109215045799998</c:v>
                </c:pt>
                <c:pt idx="331">
                  <c:v>3.93983109336</c:v>
                </c:pt>
                <c:pt idx="332">
                  <c:v>4.3110655379300002</c:v>
                </c:pt>
                <c:pt idx="333">
                  <c:v>1.0918024609999999</c:v>
                </c:pt>
                <c:pt idx="334">
                  <c:v>2.2669561853000002</c:v>
                </c:pt>
                <c:pt idx="335">
                  <c:v>2.6792604716000001</c:v>
                </c:pt>
                <c:pt idx="336">
                  <c:v>1.90785537979</c:v>
                </c:pt>
                <c:pt idx="337">
                  <c:v>1.0463938016100001</c:v>
                </c:pt>
                <c:pt idx="338">
                  <c:v>2.3200291953700001</c:v>
                </c:pt>
                <c:pt idx="339">
                  <c:v>2.9590718843100001</c:v>
                </c:pt>
                <c:pt idx="340">
                  <c:v>6.8433120240000003</c:v>
                </c:pt>
                <c:pt idx="341">
                  <c:v>3.4996038571799999</c:v>
                </c:pt>
                <c:pt idx="342">
                  <c:v>2.7666144748499999</c:v>
                </c:pt>
                <c:pt idx="343">
                  <c:v>3.38831988461</c:v>
                </c:pt>
                <c:pt idx="344">
                  <c:v>1.7076192294000001</c:v>
                </c:pt>
                <c:pt idx="345">
                  <c:v>3.72795200296</c:v>
                </c:pt>
                <c:pt idx="346">
                  <c:v>3.2059419169000001</c:v>
                </c:pt>
                <c:pt idx="347">
                  <c:v>2.2322660160200001</c:v>
                </c:pt>
                <c:pt idx="348">
                  <c:v>2.2474806839400001</c:v>
                </c:pt>
                <c:pt idx="349">
                  <c:v>7.1011040157399998</c:v>
                </c:pt>
                <c:pt idx="350">
                  <c:v>4.6348779343500004</c:v>
                </c:pt>
                <c:pt idx="351">
                  <c:v>1.9555382113499999</c:v>
                </c:pt>
                <c:pt idx="352">
                  <c:v>0.76711394404599997</c:v>
                </c:pt>
                <c:pt idx="353">
                  <c:v>2.0093668334400001</c:v>
                </c:pt>
                <c:pt idx="354">
                  <c:v>2.0322474217600002</c:v>
                </c:pt>
                <c:pt idx="355">
                  <c:v>2.29386488395</c:v>
                </c:pt>
                <c:pt idx="356">
                  <c:v>11.965443517900001</c:v>
                </c:pt>
                <c:pt idx="357">
                  <c:v>1.6544244207200001</c:v>
                </c:pt>
                <c:pt idx="358">
                  <c:v>1.74033268401</c:v>
                </c:pt>
                <c:pt idx="359">
                  <c:v>3.2135227361299998</c:v>
                </c:pt>
                <c:pt idx="360">
                  <c:v>1.6345465267599999</c:v>
                </c:pt>
                <c:pt idx="361">
                  <c:v>3.3538731583199999</c:v>
                </c:pt>
                <c:pt idx="362">
                  <c:v>2.4673073011</c:v>
                </c:pt>
                <c:pt idx="363">
                  <c:v>3.6771182179799999</c:v>
                </c:pt>
                <c:pt idx="364">
                  <c:v>3.1107260822399998</c:v>
                </c:pt>
                <c:pt idx="365">
                  <c:v>3.2546977801499999</c:v>
                </c:pt>
                <c:pt idx="366">
                  <c:v>2.3800667439100001</c:v>
                </c:pt>
                <c:pt idx="367">
                  <c:v>4.04925152733</c:v>
                </c:pt>
                <c:pt idx="368">
                  <c:v>4.6603218113400002</c:v>
                </c:pt>
                <c:pt idx="369">
                  <c:v>3.0216914506800001</c:v>
                </c:pt>
                <c:pt idx="370">
                  <c:v>3.1896261471299998</c:v>
                </c:pt>
                <c:pt idx="371">
                  <c:v>1.2183978558899999</c:v>
                </c:pt>
                <c:pt idx="372">
                  <c:v>3.6500404846899999</c:v>
                </c:pt>
                <c:pt idx="373">
                  <c:v>3.2209980270399998</c:v>
                </c:pt>
                <c:pt idx="374">
                  <c:v>3.1577424986099998</c:v>
                </c:pt>
                <c:pt idx="375">
                  <c:v>1.9192608948500001</c:v>
                </c:pt>
                <c:pt idx="376">
                  <c:v>5.2716637003500004</c:v>
                </c:pt>
                <c:pt idx="377">
                  <c:v>1.8486021674799999</c:v>
                </c:pt>
                <c:pt idx="378">
                  <c:v>1.51563548253</c:v>
                </c:pt>
                <c:pt idx="379">
                  <c:v>2.9640875395999999</c:v>
                </c:pt>
                <c:pt idx="380">
                  <c:v>3.5984466461000002</c:v>
                </c:pt>
                <c:pt idx="381">
                  <c:v>10.3684892773</c:v>
                </c:pt>
                <c:pt idx="382">
                  <c:v>1.0552108605199999</c:v>
                </c:pt>
                <c:pt idx="383">
                  <c:v>3.8386100804800001</c:v>
                </c:pt>
                <c:pt idx="384">
                  <c:v>3.4554831528299998</c:v>
                </c:pt>
                <c:pt idx="385">
                  <c:v>2.8141498182300002</c:v>
                </c:pt>
                <c:pt idx="386">
                  <c:v>4.9110192140100004</c:v>
                </c:pt>
                <c:pt idx="387">
                  <c:v>2.03061175775</c:v>
                </c:pt>
                <c:pt idx="388">
                  <c:v>2.6254116030299999</c:v>
                </c:pt>
                <c:pt idx="389">
                  <c:v>2.7991513652200002</c:v>
                </c:pt>
                <c:pt idx="390">
                  <c:v>3.1054204217299999</c:v>
                </c:pt>
                <c:pt idx="391">
                  <c:v>1.96223748553</c:v>
                </c:pt>
                <c:pt idx="392">
                  <c:v>1.6271462212900001</c:v>
                </c:pt>
                <c:pt idx="393">
                  <c:v>2.8686920678400001</c:v>
                </c:pt>
                <c:pt idx="394">
                  <c:v>4.2081358157300004</c:v>
                </c:pt>
                <c:pt idx="395">
                  <c:v>3.5296873386400001</c:v>
                </c:pt>
                <c:pt idx="396">
                  <c:v>1.6107564863599999</c:v>
                </c:pt>
                <c:pt idx="397">
                  <c:v>2.7696331489000001</c:v>
                </c:pt>
                <c:pt idx="398">
                  <c:v>1.9231300435200001</c:v>
                </c:pt>
                <c:pt idx="399">
                  <c:v>1.15117311798</c:v>
                </c:pt>
                <c:pt idx="400">
                  <c:v>2.2106525184299999</c:v>
                </c:pt>
                <c:pt idx="401">
                  <c:v>1.3876803226300001</c:v>
                </c:pt>
                <c:pt idx="402">
                  <c:v>3.7050890702300001</c:v>
                </c:pt>
                <c:pt idx="403">
                  <c:v>1.97030866088</c:v>
                </c:pt>
                <c:pt idx="404">
                  <c:v>3.75680689022</c:v>
                </c:pt>
                <c:pt idx="405">
                  <c:v>2.1728890613999998</c:v>
                </c:pt>
                <c:pt idx="406">
                  <c:v>11.606247403799999</c:v>
                </c:pt>
                <c:pt idx="407">
                  <c:v>0.68810297641700002</c:v>
                </c:pt>
                <c:pt idx="408">
                  <c:v>1.7104422239099999</c:v>
                </c:pt>
                <c:pt idx="409">
                  <c:v>3.4517152360600001</c:v>
                </c:pt>
                <c:pt idx="410">
                  <c:v>2.0955729179799998</c:v>
                </c:pt>
                <c:pt idx="411">
                  <c:v>2.0815716263400001</c:v>
                </c:pt>
                <c:pt idx="412">
                  <c:v>2.2253254194199998</c:v>
                </c:pt>
                <c:pt idx="413">
                  <c:v>1.9898568484000001</c:v>
                </c:pt>
                <c:pt idx="414">
                  <c:v>2.9379880523800002</c:v>
                </c:pt>
                <c:pt idx="415">
                  <c:v>1.8763741216600001</c:v>
                </c:pt>
                <c:pt idx="416">
                  <c:v>1.1584113308599999</c:v>
                </c:pt>
                <c:pt idx="417">
                  <c:v>3.6421766158</c:v>
                </c:pt>
                <c:pt idx="418">
                  <c:v>2.8899974508900002</c:v>
                </c:pt>
                <c:pt idx="419">
                  <c:v>4.6532681364200004</c:v>
                </c:pt>
                <c:pt idx="420">
                  <c:v>1.3822222216</c:v>
                </c:pt>
                <c:pt idx="421">
                  <c:v>1.7990898229600001</c:v>
                </c:pt>
                <c:pt idx="422">
                  <c:v>1.6359449320199999</c:v>
                </c:pt>
                <c:pt idx="423">
                  <c:v>1.3743529724100001</c:v>
                </c:pt>
                <c:pt idx="424">
                  <c:v>1.9632628372300001</c:v>
                </c:pt>
                <c:pt idx="425">
                  <c:v>2.5478772142500001</c:v>
                </c:pt>
                <c:pt idx="426">
                  <c:v>2.6034919911999999</c:v>
                </c:pt>
                <c:pt idx="427">
                  <c:v>2.2886515620600001</c:v>
                </c:pt>
                <c:pt idx="428">
                  <c:v>1.34783051662</c:v>
                </c:pt>
                <c:pt idx="429">
                  <c:v>3.2520933086100001</c:v>
                </c:pt>
                <c:pt idx="430">
                  <c:v>2.59928344314</c:v>
                </c:pt>
                <c:pt idx="431">
                  <c:v>5.0009685661200001</c:v>
                </c:pt>
                <c:pt idx="432">
                  <c:v>1.9956694858499999</c:v>
                </c:pt>
                <c:pt idx="433">
                  <c:v>2.3387298849299998</c:v>
                </c:pt>
                <c:pt idx="434">
                  <c:v>2.9676462743299998</c:v>
                </c:pt>
                <c:pt idx="435">
                  <c:v>2.78483385955</c:v>
                </c:pt>
                <c:pt idx="436">
                  <c:v>1.6308309566999999</c:v>
                </c:pt>
                <c:pt idx="437">
                  <c:v>3.4916328664799998</c:v>
                </c:pt>
                <c:pt idx="438">
                  <c:v>2.8080392946799999</c:v>
                </c:pt>
                <c:pt idx="439">
                  <c:v>2.50049143678</c:v>
                </c:pt>
                <c:pt idx="440">
                  <c:v>4.55429988763</c:v>
                </c:pt>
                <c:pt idx="441">
                  <c:v>2.7568037669100001</c:v>
                </c:pt>
                <c:pt idx="442">
                  <c:v>1.21972997094</c:v>
                </c:pt>
                <c:pt idx="443">
                  <c:v>3.4497267849200002</c:v>
                </c:pt>
                <c:pt idx="444">
                  <c:v>3.9890456912299999</c:v>
                </c:pt>
                <c:pt idx="445">
                  <c:v>2.4411742626100001</c:v>
                </c:pt>
                <c:pt idx="446">
                  <c:v>2.53293077917</c:v>
                </c:pt>
                <c:pt idx="447">
                  <c:v>2.0370154864900001</c:v>
                </c:pt>
                <c:pt idx="448">
                  <c:v>3.4432183421400002</c:v>
                </c:pt>
                <c:pt idx="449">
                  <c:v>2.59697171458</c:v>
                </c:pt>
                <c:pt idx="450">
                  <c:v>5.4191570690899997</c:v>
                </c:pt>
                <c:pt idx="451">
                  <c:v>2.1139793931400002</c:v>
                </c:pt>
                <c:pt idx="452">
                  <c:v>8.0493901439499993</c:v>
                </c:pt>
                <c:pt idx="453">
                  <c:v>4.8202658174500002</c:v>
                </c:pt>
                <c:pt idx="454">
                  <c:v>12.699466298400001</c:v>
                </c:pt>
                <c:pt idx="455">
                  <c:v>2.0768873025399999</c:v>
                </c:pt>
                <c:pt idx="456">
                  <c:v>2.67164612373</c:v>
                </c:pt>
                <c:pt idx="457">
                  <c:v>2.4898077644300001</c:v>
                </c:pt>
                <c:pt idx="458">
                  <c:v>1.1249653046300001</c:v>
                </c:pt>
                <c:pt idx="459">
                  <c:v>2.3155952428800002</c:v>
                </c:pt>
                <c:pt idx="460">
                  <c:v>2.60216079456</c:v>
                </c:pt>
                <c:pt idx="461">
                  <c:v>0.39024453698299999</c:v>
                </c:pt>
                <c:pt idx="462">
                  <c:v>2.47393855341</c:v>
                </c:pt>
                <c:pt idx="463">
                  <c:v>1.9880032218100001</c:v>
                </c:pt>
                <c:pt idx="464">
                  <c:v>1.9079811504599999</c:v>
                </c:pt>
                <c:pt idx="465">
                  <c:v>1.8688041236299999</c:v>
                </c:pt>
                <c:pt idx="466">
                  <c:v>1.4520682594300001</c:v>
                </c:pt>
                <c:pt idx="467">
                  <c:v>5.2172777395400001</c:v>
                </c:pt>
                <c:pt idx="468">
                  <c:v>1.3500287336700001</c:v>
                </c:pt>
                <c:pt idx="469">
                  <c:v>1.2100225999800001</c:v>
                </c:pt>
                <c:pt idx="470">
                  <c:v>2.1972439141</c:v>
                </c:pt>
                <c:pt idx="471">
                  <c:v>1.16124442437</c:v>
                </c:pt>
                <c:pt idx="472">
                  <c:v>3.2063295115899999</c:v>
                </c:pt>
                <c:pt idx="473">
                  <c:v>2.63904010173</c:v>
                </c:pt>
                <c:pt idx="474">
                  <c:v>2.6330515299899999</c:v>
                </c:pt>
                <c:pt idx="475">
                  <c:v>1.60214994431</c:v>
                </c:pt>
                <c:pt idx="476">
                  <c:v>1.5077098847599999</c:v>
                </c:pt>
                <c:pt idx="477">
                  <c:v>2.1942017838300001</c:v>
                </c:pt>
                <c:pt idx="478">
                  <c:v>1.26492493427</c:v>
                </c:pt>
                <c:pt idx="479">
                  <c:v>2.7308275071999999</c:v>
                </c:pt>
                <c:pt idx="480">
                  <c:v>1.3547602516799999</c:v>
                </c:pt>
                <c:pt idx="481">
                  <c:v>1.4822294788399999</c:v>
                </c:pt>
                <c:pt idx="482">
                  <c:v>2.37056240705</c:v>
                </c:pt>
                <c:pt idx="483">
                  <c:v>1.97666088784</c:v>
                </c:pt>
                <c:pt idx="484">
                  <c:v>1.0401806539</c:v>
                </c:pt>
                <c:pt idx="485">
                  <c:v>2.9407973142400001</c:v>
                </c:pt>
                <c:pt idx="486">
                  <c:v>2.2243475891300002</c:v>
                </c:pt>
                <c:pt idx="487">
                  <c:v>2.3206765785700001</c:v>
                </c:pt>
                <c:pt idx="488">
                  <c:v>1.9153709856400001</c:v>
                </c:pt>
                <c:pt idx="489">
                  <c:v>2.9073993999300001</c:v>
                </c:pt>
                <c:pt idx="490">
                  <c:v>1.7790205728099999</c:v>
                </c:pt>
                <c:pt idx="491">
                  <c:v>1.3504838675599999</c:v>
                </c:pt>
                <c:pt idx="492">
                  <c:v>3.9603026956399998</c:v>
                </c:pt>
                <c:pt idx="493">
                  <c:v>1.7673330808200001</c:v>
                </c:pt>
                <c:pt idx="494">
                  <c:v>3.2624443475999998</c:v>
                </c:pt>
                <c:pt idx="495">
                  <c:v>2.56282072098</c:v>
                </c:pt>
                <c:pt idx="496">
                  <c:v>2.2769053025199999</c:v>
                </c:pt>
                <c:pt idx="497">
                  <c:v>2.9909252257899999</c:v>
                </c:pt>
                <c:pt idx="498">
                  <c:v>3.2354655718299998</c:v>
                </c:pt>
                <c:pt idx="499">
                  <c:v>4.8730860383500003</c:v>
                </c:pt>
                <c:pt idx="500">
                  <c:v>1.4795096273099999</c:v>
                </c:pt>
                <c:pt idx="501">
                  <c:v>0.80392752291000003</c:v>
                </c:pt>
                <c:pt idx="502">
                  <c:v>1.6781614920700001</c:v>
                </c:pt>
                <c:pt idx="503">
                  <c:v>7.3442748125200001</c:v>
                </c:pt>
                <c:pt idx="504">
                  <c:v>0.631694243687</c:v>
                </c:pt>
                <c:pt idx="505">
                  <c:v>2.97047992745</c:v>
                </c:pt>
                <c:pt idx="506">
                  <c:v>5.1918767526199998</c:v>
                </c:pt>
                <c:pt idx="507">
                  <c:v>2.0717762020600001</c:v>
                </c:pt>
                <c:pt idx="508">
                  <c:v>2.1198428038000001</c:v>
                </c:pt>
                <c:pt idx="509">
                  <c:v>2.83239347521</c:v>
                </c:pt>
                <c:pt idx="510">
                  <c:v>4.2462353372299999</c:v>
                </c:pt>
                <c:pt idx="511">
                  <c:v>2.1501484227500001</c:v>
                </c:pt>
                <c:pt idx="512">
                  <c:v>1.5461370913600001</c:v>
                </c:pt>
                <c:pt idx="513">
                  <c:v>1.12580085974</c:v>
                </c:pt>
                <c:pt idx="514">
                  <c:v>1.03671343972</c:v>
                </c:pt>
                <c:pt idx="515">
                  <c:v>2.7085537356299998</c:v>
                </c:pt>
                <c:pt idx="516">
                  <c:v>1.17384102818</c:v>
                </c:pt>
                <c:pt idx="517">
                  <c:v>0.93349592054999997</c:v>
                </c:pt>
                <c:pt idx="518">
                  <c:v>2.76416249605</c:v>
                </c:pt>
                <c:pt idx="519">
                  <c:v>0.91380942979000002</c:v>
                </c:pt>
                <c:pt idx="520">
                  <c:v>23.961784178399999</c:v>
                </c:pt>
                <c:pt idx="521">
                  <c:v>2.36142287887</c:v>
                </c:pt>
                <c:pt idx="522">
                  <c:v>3.7626576966499998</c:v>
                </c:pt>
                <c:pt idx="523">
                  <c:v>1.3386968080599999</c:v>
                </c:pt>
                <c:pt idx="524">
                  <c:v>11.9708681198</c:v>
                </c:pt>
                <c:pt idx="525">
                  <c:v>2.8008023683099998</c:v>
                </c:pt>
                <c:pt idx="526">
                  <c:v>2.6628122584299998</c:v>
                </c:pt>
                <c:pt idx="527">
                  <c:v>2.2285120099000002</c:v>
                </c:pt>
                <c:pt idx="528">
                  <c:v>3.1167726506600002</c:v>
                </c:pt>
                <c:pt idx="529">
                  <c:v>2.0240364313799999</c:v>
                </c:pt>
                <c:pt idx="530">
                  <c:v>4.24444011849</c:v>
                </c:pt>
                <c:pt idx="531">
                  <c:v>2.0707231677500002</c:v>
                </c:pt>
                <c:pt idx="532">
                  <c:v>4.5958141823199998</c:v>
                </c:pt>
                <c:pt idx="533">
                  <c:v>1.0790340674100001</c:v>
                </c:pt>
                <c:pt idx="534">
                  <c:v>2.6282391524499999</c:v>
                </c:pt>
                <c:pt idx="535">
                  <c:v>3.71073745165</c:v>
                </c:pt>
                <c:pt idx="536">
                  <c:v>6.0588911210200003</c:v>
                </c:pt>
                <c:pt idx="537">
                  <c:v>3.0240209414199999</c:v>
                </c:pt>
                <c:pt idx="538">
                  <c:v>1.3288585418300001</c:v>
                </c:pt>
                <c:pt idx="539">
                  <c:v>1.3941940768400001</c:v>
                </c:pt>
                <c:pt idx="540">
                  <c:v>5.3030362232300003</c:v>
                </c:pt>
                <c:pt idx="541">
                  <c:v>3.34144409025</c:v>
                </c:pt>
                <c:pt idx="542">
                  <c:v>2.5557552754100001</c:v>
                </c:pt>
                <c:pt idx="543">
                  <c:v>2.95767025442</c:v>
                </c:pt>
                <c:pt idx="544">
                  <c:v>2.7679152041599999</c:v>
                </c:pt>
                <c:pt idx="545">
                  <c:v>2.2282684052400001</c:v>
                </c:pt>
                <c:pt idx="546">
                  <c:v>3.0129639407100002</c:v>
                </c:pt>
                <c:pt idx="547">
                  <c:v>2.9246863476599998</c:v>
                </c:pt>
                <c:pt idx="548">
                  <c:v>2.7474340650100002</c:v>
                </c:pt>
                <c:pt idx="549">
                  <c:v>14.6773657291</c:v>
                </c:pt>
                <c:pt idx="550">
                  <c:v>6.7644483286900003</c:v>
                </c:pt>
                <c:pt idx="551">
                  <c:v>2.3855277264199999</c:v>
                </c:pt>
                <c:pt idx="552">
                  <c:v>2.4193392710200001</c:v>
                </c:pt>
                <c:pt idx="553">
                  <c:v>3.3046927085200002</c:v>
                </c:pt>
                <c:pt idx="554">
                  <c:v>68.739059843700005</c:v>
                </c:pt>
                <c:pt idx="555">
                  <c:v>0.84341064642999997</c:v>
                </c:pt>
                <c:pt idx="556">
                  <c:v>3.8530534803299998</c:v>
                </c:pt>
                <c:pt idx="557">
                  <c:v>3.66299026583</c:v>
                </c:pt>
                <c:pt idx="558">
                  <c:v>1.84217978409</c:v>
                </c:pt>
                <c:pt idx="559">
                  <c:v>3.2322740537799999</c:v>
                </c:pt>
                <c:pt idx="560">
                  <c:v>1.97216867743</c:v>
                </c:pt>
                <c:pt idx="561">
                  <c:v>6.4569374055199997</c:v>
                </c:pt>
                <c:pt idx="562">
                  <c:v>2.2201925715100002</c:v>
                </c:pt>
                <c:pt idx="563">
                  <c:v>1.8041272481099999</c:v>
                </c:pt>
                <c:pt idx="564">
                  <c:v>1.8559901502</c:v>
                </c:pt>
                <c:pt idx="565">
                  <c:v>2.4367585270499998</c:v>
                </c:pt>
                <c:pt idx="566">
                  <c:v>0.88722972169600001</c:v>
                </c:pt>
                <c:pt idx="567">
                  <c:v>2.7385195141100001</c:v>
                </c:pt>
                <c:pt idx="568">
                  <c:v>15.4806350484</c:v>
                </c:pt>
                <c:pt idx="569">
                  <c:v>4.5381509476600002</c:v>
                </c:pt>
                <c:pt idx="570">
                  <c:v>3.8213967965200002</c:v>
                </c:pt>
                <c:pt idx="571">
                  <c:v>2.43242601092</c:v>
                </c:pt>
                <c:pt idx="572">
                  <c:v>2.98843829553</c:v>
                </c:pt>
                <c:pt idx="573">
                  <c:v>1.5849659304599999</c:v>
                </c:pt>
                <c:pt idx="574">
                  <c:v>1.84908308281</c:v>
                </c:pt>
                <c:pt idx="575">
                  <c:v>3.71535623185</c:v>
                </c:pt>
                <c:pt idx="576">
                  <c:v>2.63646884545</c:v>
                </c:pt>
                <c:pt idx="577">
                  <c:v>2.0796630188299998</c:v>
                </c:pt>
                <c:pt idx="578">
                  <c:v>6.0435012421899996</c:v>
                </c:pt>
                <c:pt idx="579">
                  <c:v>1.63781320698</c:v>
                </c:pt>
                <c:pt idx="580">
                  <c:v>4.6920501087600002</c:v>
                </c:pt>
                <c:pt idx="581">
                  <c:v>3.2590003165599999</c:v>
                </c:pt>
                <c:pt idx="582">
                  <c:v>2.5651610799700002</c:v>
                </c:pt>
                <c:pt idx="583">
                  <c:v>1.38126488004</c:v>
                </c:pt>
                <c:pt idx="584">
                  <c:v>2.0495499219600002</c:v>
                </c:pt>
                <c:pt idx="585">
                  <c:v>2.6549877677099998</c:v>
                </c:pt>
                <c:pt idx="586">
                  <c:v>0.90100544573899999</c:v>
                </c:pt>
                <c:pt idx="587">
                  <c:v>3.8939521032500002</c:v>
                </c:pt>
                <c:pt idx="588">
                  <c:v>4.2035016781400003</c:v>
                </c:pt>
                <c:pt idx="589">
                  <c:v>14.2741099376</c:v>
                </c:pt>
                <c:pt idx="590">
                  <c:v>4.3120251962099996</c:v>
                </c:pt>
                <c:pt idx="591">
                  <c:v>2.9228602270000001</c:v>
                </c:pt>
                <c:pt idx="592">
                  <c:v>4.8199793080899997</c:v>
                </c:pt>
                <c:pt idx="593">
                  <c:v>2.1687777325900002</c:v>
                </c:pt>
                <c:pt idx="594">
                  <c:v>1.0188492031900001</c:v>
                </c:pt>
                <c:pt idx="595">
                  <c:v>1.83537792273</c:v>
                </c:pt>
                <c:pt idx="596">
                  <c:v>2.3980211169999999</c:v>
                </c:pt>
                <c:pt idx="597">
                  <c:v>1.79356056804</c:v>
                </c:pt>
                <c:pt idx="598">
                  <c:v>3.4682693005499998</c:v>
                </c:pt>
                <c:pt idx="599">
                  <c:v>0.67298435444899996</c:v>
                </c:pt>
                <c:pt idx="600">
                  <c:v>1.0876499777799999</c:v>
                </c:pt>
                <c:pt idx="601">
                  <c:v>3.5860330571699999</c:v>
                </c:pt>
                <c:pt idx="602">
                  <c:v>1.1408738949999999</c:v>
                </c:pt>
                <c:pt idx="603">
                  <c:v>2.8361672359900001</c:v>
                </c:pt>
                <c:pt idx="604">
                  <c:v>4.2655170225900001</c:v>
                </c:pt>
                <c:pt idx="605">
                  <c:v>2.9976859237300002</c:v>
                </c:pt>
                <c:pt idx="606">
                  <c:v>2.5388388183399999</c:v>
                </c:pt>
                <c:pt idx="607">
                  <c:v>0.49312538162699998</c:v>
                </c:pt>
                <c:pt idx="608">
                  <c:v>3.3181588420599999</c:v>
                </c:pt>
                <c:pt idx="609">
                  <c:v>1.29995248528</c:v>
                </c:pt>
                <c:pt idx="610">
                  <c:v>6.6638506344500001</c:v>
                </c:pt>
                <c:pt idx="611">
                  <c:v>1.5984546711200001</c:v>
                </c:pt>
                <c:pt idx="612">
                  <c:v>5.5933699167500004</c:v>
                </c:pt>
                <c:pt idx="613">
                  <c:v>1.97839483731</c:v>
                </c:pt>
                <c:pt idx="614">
                  <c:v>2.4729219751099998</c:v>
                </c:pt>
                <c:pt idx="615">
                  <c:v>1.6100997876600001</c:v>
                </c:pt>
                <c:pt idx="616">
                  <c:v>1.8071565835700001</c:v>
                </c:pt>
                <c:pt idx="617">
                  <c:v>1.7366533398799999</c:v>
                </c:pt>
                <c:pt idx="618">
                  <c:v>8.0284782279200009</c:v>
                </c:pt>
                <c:pt idx="619">
                  <c:v>2.9276539774699999</c:v>
                </c:pt>
                <c:pt idx="620">
                  <c:v>1.9769900063200001</c:v>
                </c:pt>
                <c:pt idx="621">
                  <c:v>7.7089945848600001</c:v>
                </c:pt>
                <c:pt idx="622">
                  <c:v>1.7717609915800001</c:v>
                </c:pt>
                <c:pt idx="623">
                  <c:v>1.82999757068</c:v>
                </c:pt>
                <c:pt idx="624">
                  <c:v>6.1493647091500003</c:v>
                </c:pt>
                <c:pt idx="625">
                  <c:v>2.6240350815500002</c:v>
                </c:pt>
                <c:pt idx="626">
                  <c:v>2.0527339815299999</c:v>
                </c:pt>
                <c:pt idx="627">
                  <c:v>3.0404086128199999</c:v>
                </c:pt>
                <c:pt idx="628">
                  <c:v>3.4463492423400002</c:v>
                </c:pt>
                <c:pt idx="629">
                  <c:v>2.50657713941</c:v>
                </c:pt>
                <c:pt idx="630">
                  <c:v>2.7526464265300001</c:v>
                </c:pt>
                <c:pt idx="631">
                  <c:v>2.4823626870500002</c:v>
                </c:pt>
                <c:pt idx="632">
                  <c:v>4.6375922138999996</c:v>
                </c:pt>
                <c:pt idx="633">
                  <c:v>2.3107967658000002</c:v>
                </c:pt>
                <c:pt idx="634">
                  <c:v>3.34071790473</c:v>
                </c:pt>
                <c:pt idx="635">
                  <c:v>3.44632978358</c:v>
                </c:pt>
                <c:pt idx="636">
                  <c:v>2.9505171681300002</c:v>
                </c:pt>
                <c:pt idx="637">
                  <c:v>33.9519770721</c:v>
                </c:pt>
                <c:pt idx="638">
                  <c:v>3.58825637712</c:v>
                </c:pt>
                <c:pt idx="639">
                  <c:v>2.0497858524099999</c:v>
                </c:pt>
                <c:pt idx="640">
                  <c:v>3.1948647185899999</c:v>
                </c:pt>
                <c:pt idx="641">
                  <c:v>2.20200133658</c:v>
                </c:pt>
                <c:pt idx="642">
                  <c:v>0.67841132966499995</c:v>
                </c:pt>
                <c:pt idx="643">
                  <c:v>2.5434267080800002</c:v>
                </c:pt>
                <c:pt idx="644">
                  <c:v>2.5843600213700002</c:v>
                </c:pt>
                <c:pt idx="645">
                  <c:v>24.404700008599999</c:v>
                </c:pt>
                <c:pt idx="646">
                  <c:v>1.2787450660399999</c:v>
                </c:pt>
                <c:pt idx="647">
                  <c:v>2.84319337239</c:v>
                </c:pt>
                <c:pt idx="648">
                  <c:v>12.0742095228</c:v>
                </c:pt>
                <c:pt idx="649">
                  <c:v>2.5727797949600002</c:v>
                </c:pt>
                <c:pt idx="650">
                  <c:v>3.5445124162899999</c:v>
                </c:pt>
                <c:pt idx="651">
                  <c:v>2.1355505849699998</c:v>
                </c:pt>
                <c:pt idx="652">
                  <c:v>4.3667198897199997</c:v>
                </c:pt>
                <c:pt idx="653">
                  <c:v>2.3387821707200001</c:v>
                </c:pt>
                <c:pt idx="654">
                  <c:v>3.60203503922</c:v>
                </c:pt>
                <c:pt idx="655">
                  <c:v>3.8895767881499999</c:v>
                </c:pt>
                <c:pt idx="656">
                  <c:v>1.8899973212600001</c:v>
                </c:pt>
                <c:pt idx="657">
                  <c:v>1.6589972290299999</c:v>
                </c:pt>
                <c:pt idx="658">
                  <c:v>1.43647835469</c:v>
                </c:pt>
                <c:pt idx="659">
                  <c:v>1.72178382639</c:v>
                </c:pt>
                <c:pt idx="660">
                  <c:v>3.6627896634599999</c:v>
                </c:pt>
                <c:pt idx="661">
                  <c:v>4.4916021855799997</c:v>
                </c:pt>
                <c:pt idx="662">
                  <c:v>3.8407113686400001</c:v>
                </c:pt>
                <c:pt idx="663">
                  <c:v>6.5445150120299997</c:v>
                </c:pt>
                <c:pt idx="664">
                  <c:v>2.12434303111</c:v>
                </c:pt>
                <c:pt idx="665">
                  <c:v>2.9298334938499999</c:v>
                </c:pt>
                <c:pt idx="666">
                  <c:v>2.1141701095299998</c:v>
                </c:pt>
                <c:pt idx="667">
                  <c:v>2.3366766292699999</c:v>
                </c:pt>
                <c:pt idx="668">
                  <c:v>2.2744008334900001</c:v>
                </c:pt>
                <c:pt idx="669">
                  <c:v>2.3437760128599998</c:v>
                </c:pt>
                <c:pt idx="670">
                  <c:v>2.3484796210400001</c:v>
                </c:pt>
                <c:pt idx="671">
                  <c:v>1.0478115370500001</c:v>
                </c:pt>
                <c:pt idx="672">
                  <c:v>2.2581657448499999</c:v>
                </c:pt>
                <c:pt idx="673">
                  <c:v>2.2818243252700001</c:v>
                </c:pt>
                <c:pt idx="674">
                  <c:v>2.7523785987</c:v>
                </c:pt>
                <c:pt idx="675">
                  <c:v>3.3723195327900002</c:v>
                </c:pt>
                <c:pt idx="676">
                  <c:v>6.1003198156599998</c:v>
                </c:pt>
                <c:pt idx="677">
                  <c:v>0.712485102308</c:v>
                </c:pt>
                <c:pt idx="678">
                  <c:v>1.69234041094</c:v>
                </c:pt>
                <c:pt idx="679">
                  <c:v>1.8255990474399999</c:v>
                </c:pt>
                <c:pt idx="680">
                  <c:v>2.1873008568299999</c:v>
                </c:pt>
                <c:pt idx="681">
                  <c:v>2.0199622543800002</c:v>
                </c:pt>
                <c:pt idx="682">
                  <c:v>1.4720970046799999</c:v>
                </c:pt>
                <c:pt idx="683">
                  <c:v>3.2813682249</c:v>
                </c:pt>
                <c:pt idx="684">
                  <c:v>1.6122275374999999</c:v>
                </c:pt>
                <c:pt idx="685">
                  <c:v>0.539717565673</c:v>
                </c:pt>
                <c:pt idx="686">
                  <c:v>6.6741577220900004</c:v>
                </c:pt>
                <c:pt idx="687">
                  <c:v>4.1474077043599999</c:v>
                </c:pt>
                <c:pt idx="688">
                  <c:v>1.9311748099499999</c:v>
                </c:pt>
                <c:pt idx="689">
                  <c:v>3.04982580807</c:v>
                </c:pt>
                <c:pt idx="690">
                  <c:v>3.41837504049</c:v>
                </c:pt>
                <c:pt idx="691">
                  <c:v>2.39954301037</c:v>
                </c:pt>
                <c:pt idx="692">
                  <c:v>5.6295844967199997</c:v>
                </c:pt>
                <c:pt idx="693">
                  <c:v>0.22785495483900001</c:v>
                </c:pt>
                <c:pt idx="694">
                  <c:v>3.3641363596999998</c:v>
                </c:pt>
                <c:pt idx="695">
                  <c:v>4.4109074482799997</c:v>
                </c:pt>
                <c:pt idx="696">
                  <c:v>2.01255049806</c:v>
                </c:pt>
                <c:pt idx="697">
                  <c:v>1.21532133974</c:v>
                </c:pt>
                <c:pt idx="698">
                  <c:v>1.9950683892200001</c:v>
                </c:pt>
                <c:pt idx="699">
                  <c:v>1.5838937585699999</c:v>
                </c:pt>
                <c:pt idx="700">
                  <c:v>1.51051767251</c:v>
                </c:pt>
                <c:pt idx="701">
                  <c:v>2.3607885208399999</c:v>
                </c:pt>
                <c:pt idx="702">
                  <c:v>2.0989814441800001</c:v>
                </c:pt>
                <c:pt idx="703">
                  <c:v>2.7386360877499998</c:v>
                </c:pt>
                <c:pt idx="704">
                  <c:v>1.17420514305</c:v>
                </c:pt>
                <c:pt idx="705">
                  <c:v>7.2657853784500004</c:v>
                </c:pt>
                <c:pt idx="706">
                  <c:v>2.79150018118</c:v>
                </c:pt>
                <c:pt idx="707">
                  <c:v>4.06682170852</c:v>
                </c:pt>
                <c:pt idx="708">
                  <c:v>5.36325093623</c:v>
                </c:pt>
                <c:pt idx="709">
                  <c:v>2.6700475574600002</c:v>
                </c:pt>
                <c:pt idx="710">
                  <c:v>1.9046481448000001</c:v>
                </c:pt>
                <c:pt idx="711">
                  <c:v>7.3217857177100001</c:v>
                </c:pt>
                <c:pt idx="712">
                  <c:v>7.2493600821799999</c:v>
                </c:pt>
                <c:pt idx="713">
                  <c:v>2.8785118943799999</c:v>
                </c:pt>
                <c:pt idx="714">
                  <c:v>33.5598509593</c:v>
                </c:pt>
                <c:pt idx="715">
                  <c:v>1.9161689046899999</c:v>
                </c:pt>
                <c:pt idx="716">
                  <c:v>2.33623190456</c:v>
                </c:pt>
                <c:pt idx="717">
                  <c:v>2.84486042162</c:v>
                </c:pt>
                <c:pt idx="718">
                  <c:v>2.4134653163299999</c:v>
                </c:pt>
                <c:pt idx="719">
                  <c:v>2.4092319518399998</c:v>
                </c:pt>
                <c:pt idx="720">
                  <c:v>1.4285315222099999</c:v>
                </c:pt>
                <c:pt idx="721">
                  <c:v>5.1282813812499999</c:v>
                </c:pt>
                <c:pt idx="722">
                  <c:v>3.0351552932099999</c:v>
                </c:pt>
                <c:pt idx="723">
                  <c:v>1.90767567294</c:v>
                </c:pt>
                <c:pt idx="724">
                  <c:v>2.3943507144399998</c:v>
                </c:pt>
                <c:pt idx="725">
                  <c:v>5.0925553207899998</c:v>
                </c:pt>
                <c:pt idx="726">
                  <c:v>3.02452477794</c:v>
                </c:pt>
                <c:pt idx="727">
                  <c:v>24.384699477200002</c:v>
                </c:pt>
                <c:pt idx="728">
                  <c:v>2.0906933974199999</c:v>
                </c:pt>
                <c:pt idx="729">
                  <c:v>2.9553363695299999</c:v>
                </c:pt>
                <c:pt idx="730">
                  <c:v>1.31451950995</c:v>
                </c:pt>
                <c:pt idx="731">
                  <c:v>2.6404891318499999</c:v>
                </c:pt>
                <c:pt idx="732">
                  <c:v>1.64254019703</c:v>
                </c:pt>
                <c:pt idx="733">
                  <c:v>6.7969983150199997</c:v>
                </c:pt>
                <c:pt idx="734">
                  <c:v>1.91143281857</c:v>
                </c:pt>
                <c:pt idx="735">
                  <c:v>3.2349822057600002</c:v>
                </c:pt>
                <c:pt idx="736">
                  <c:v>3.3953966055599998</c:v>
                </c:pt>
                <c:pt idx="737">
                  <c:v>1.7654229318000001</c:v>
                </c:pt>
                <c:pt idx="738">
                  <c:v>2.1509712373099998</c:v>
                </c:pt>
                <c:pt idx="739">
                  <c:v>4.5278276027100004</c:v>
                </c:pt>
                <c:pt idx="740">
                  <c:v>3.5910187002999998</c:v>
                </c:pt>
                <c:pt idx="741">
                  <c:v>1.6477301812</c:v>
                </c:pt>
                <c:pt idx="742">
                  <c:v>1.40725954742</c:v>
                </c:pt>
                <c:pt idx="743">
                  <c:v>1.0722770318099999</c:v>
                </c:pt>
                <c:pt idx="744">
                  <c:v>2.1756119570100001</c:v>
                </c:pt>
                <c:pt idx="745">
                  <c:v>7.6461823511900002</c:v>
                </c:pt>
                <c:pt idx="746">
                  <c:v>1.1523466923000001</c:v>
                </c:pt>
                <c:pt idx="747">
                  <c:v>4.3820219333899999</c:v>
                </c:pt>
                <c:pt idx="748">
                  <c:v>6.5449606276900001</c:v>
                </c:pt>
                <c:pt idx="749">
                  <c:v>3.3478263830200001</c:v>
                </c:pt>
                <c:pt idx="750">
                  <c:v>7.1993917133899998</c:v>
                </c:pt>
                <c:pt idx="751">
                  <c:v>1.9458400974300001</c:v>
                </c:pt>
                <c:pt idx="752">
                  <c:v>0.95398844562600005</c:v>
                </c:pt>
                <c:pt idx="753">
                  <c:v>2.16941787787</c:v>
                </c:pt>
                <c:pt idx="754">
                  <c:v>1.6516493322700001</c:v>
                </c:pt>
                <c:pt idx="755">
                  <c:v>3.8295568497499999</c:v>
                </c:pt>
                <c:pt idx="756">
                  <c:v>1.9836858026999999</c:v>
                </c:pt>
                <c:pt idx="757">
                  <c:v>1.8288167633500001</c:v>
                </c:pt>
                <c:pt idx="758">
                  <c:v>1.22958806238</c:v>
                </c:pt>
                <c:pt idx="759">
                  <c:v>20.815742724300001</c:v>
                </c:pt>
                <c:pt idx="760">
                  <c:v>1.75406142285</c:v>
                </c:pt>
                <c:pt idx="761">
                  <c:v>3.89518683356</c:v>
                </c:pt>
                <c:pt idx="762">
                  <c:v>3.4300166872900002</c:v>
                </c:pt>
                <c:pt idx="763">
                  <c:v>1.4441045515499999</c:v>
                </c:pt>
                <c:pt idx="764">
                  <c:v>53.376409256000002</c:v>
                </c:pt>
                <c:pt idx="765">
                  <c:v>0.70043368626000002</c:v>
                </c:pt>
                <c:pt idx="766">
                  <c:v>3.2521037157300001</c:v>
                </c:pt>
                <c:pt idx="767">
                  <c:v>2.5348019849000001</c:v>
                </c:pt>
                <c:pt idx="768">
                  <c:v>1.27179191646</c:v>
                </c:pt>
                <c:pt idx="769">
                  <c:v>21.4577007</c:v>
                </c:pt>
                <c:pt idx="770">
                  <c:v>1.8605040696199999</c:v>
                </c:pt>
                <c:pt idx="771">
                  <c:v>1.6901652808600001</c:v>
                </c:pt>
                <c:pt idx="772">
                  <c:v>6.2925448768500001</c:v>
                </c:pt>
                <c:pt idx="773">
                  <c:v>0.965101192251</c:v>
                </c:pt>
                <c:pt idx="774">
                  <c:v>1.5409460778899999</c:v>
                </c:pt>
                <c:pt idx="775">
                  <c:v>0.53881483586099999</c:v>
                </c:pt>
                <c:pt idx="776">
                  <c:v>1.26365411484</c:v>
                </c:pt>
                <c:pt idx="777">
                  <c:v>1.80573255436</c:v>
                </c:pt>
                <c:pt idx="778">
                  <c:v>1.7090388534000001</c:v>
                </c:pt>
                <c:pt idx="779">
                  <c:v>3.0183048712699998</c:v>
                </c:pt>
                <c:pt idx="780">
                  <c:v>1.76548786638</c:v>
                </c:pt>
                <c:pt idx="781">
                  <c:v>1.03793784173</c:v>
                </c:pt>
                <c:pt idx="782">
                  <c:v>2.0084831041700002</c:v>
                </c:pt>
                <c:pt idx="783">
                  <c:v>1.5398771798299999</c:v>
                </c:pt>
                <c:pt idx="784">
                  <c:v>3.65528015207</c:v>
                </c:pt>
                <c:pt idx="785">
                  <c:v>1.2859934293999999</c:v>
                </c:pt>
                <c:pt idx="786">
                  <c:v>2.9248543316700002</c:v>
                </c:pt>
                <c:pt idx="787">
                  <c:v>1.2692476205400001</c:v>
                </c:pt>
                <c:pt idx="788">
                  <c:v>3.70706567081</c:v>
                </c:pt>
                <c:pt idx="789">
                  <c:v>1.50421147032</c:v>
                </c:pt>
                <c:pt idx="790">
                  <c:v>1.0748995884500001</c:v>
                </c:pt>
                <c:pt idx="791">
                  <c:v>1.4738190148200001</c:v>
                </c:pt>
                <c:pt idx="792">
                  <c:v>13.7655638389</c:v>
                </c:pt>
                <c:pt idx="793">
                  <c:v>5.4670187542099997</c:v>
                </c:pt>
                <c:pt idx="794">
                  <c:v>2.9407264853799999</c:v>
                </c:pt>
                <c:pt idx="795">
                  <c:v>1.82551377623</c:v>
                </c:pt>
                <c:pt idx="796">
                  <c:v>5.8589676359</c:v>
                </c:pt>
                <c:pt idx="797">
                  <c:v>1.89817198171</c:v>
                </c:pt>
                <c:pt idx="798">
                  <c:v>3.7213845549400002</c:v>
                </c:pt>
                <c:pt idx="799">
                  <c:v>1.7784860902699999</c:v>
                </c:pt>
                <c:pt idx="800">
                  <c:v>3.3107327686699999</c:v>
                </c:pt>
                <c:pt idx="801">
                  <c:v>2.09907168295</c:v>
                </c:pt>
                <c:pt idx="802">
                  <c:v>2.5173656362800001</c:v>
                </c:pt>
                <c:pt idx="803">
                  <c:v>1.3419024179200001</c:v>
                </c:pt>
                <c:pt idx="804">
                  <c:v>2.03930299609</c:v>
                </c:pt>
                <c:pt idx="805">
                  <c:v>1.7555487223299999</c:v>
                </c:pt>
                <c:pt idx="806">
                  <c:v>3.7546348733900001</c:v>
                </c:pt>
                <c:pt idx="807">
                  <c:v>2.3147646232299999</c:v>
                </c:pt>
                <c:pt idx="808">
                  <c:v>2.63239587154</c:v>
                </c:pt>
                <c:pt idx="809">
                  <c:v>2.8442215862200002</c:v>
                </c:pt>
                <c:pt idx="810">
                  <c:v>2.27283647922</c:v>
                </c:pt>
                <c:pt idx="811">
                  <c:v>2.14119901806</c:v>
                </c:pt>
                <c:pt idx="812">
                  <c:v>1.2180003428199999</c:v>
                </c:pt>
                <c:pt idx="813">
                  <c:v>0.94843550712199998</c:v>
                </c:pt>
                <c:pt idx="814">
                  <c:v>1.1155750137</c:v>
                </c:pt>
                <c:pt idx="815">
                  <c:v>8.8302880661599996</c:v>
                </c:pt>
                <c:pt idx="816">
                  <c:v>1.86087352922</c:v>
                </c:pt>
                <c:pt idx="817">
                  <c:v>1.86606295394</c:v>
                </c:pt>
                <c:pt idx="818">
                  <c:v>2.03609964304</c:v>
                </c:pt>
                <c:pt idx="819">
                  <c:v>2.5654555015799998</c:v>
                </c:pt>
                <c:pt idx="820">
                  <c:v>1.8460589648600001</c:v>
                </c:pt>
                <c:pt idx="821">
                  <c:v>1.76142199456</c:v>
                </c:pt>
                <c:pt idx="822">
                  <c:v>1.9710770984599999</c:v>
                </c:pt>
                <c:pt idx="823">
                  <c:v>1.65548123957</c:v>
                </c:pt>
                <c:pt idx="824">
                  <c:v>1.55667312941</c:v>
                </c:pt>
                <c:pt idx="825">
                  <c:v>3.26411472241</c:v>
                </c:pt>
                <c:pt idx="826">
                  <c:v>4.2389028950199998</c:v>
                </c:pt>
                <c:pt idx="827">
                  <c:v>1.7652433590900001</c:v>
                </c:pt>
                <c:pt idx="828">
                  <c:v>1.09430203857</c:v>
                </c:pt>
                <c:pt idx="829">
                  <c:v>1.7677963061099999</c:v>
                </c:pt>
                <c:pt idx="830">
                  <c:v>3.08674641104</c:v>
                </c:pt>
                <c:pt idx="831">
                  <c:v>1.6700690433700001</c:v>
                </c:pt>
                <c:pt idx="832">
                  <c:v>1.3130668408199999</c:v>
                </c:pt>
                <c:pt idx="833">
                  <c:v>2.59298083434</c:v>
                </c:pt>
                <c:pt idx="834">
                  <c:v>3.7963858558500001</c:v>
                </c:pt>
                <c:pt idx="835">
                  <c:v>1.9435383631900001</c:v>
                </c:pt>
                <c:pt idx="836">
                  <c:v>4.8061283081799999</c:v>
                </c:pt>
                <c:pt idx="837">
                  <c:v>4.6724445681700004</c:v>
                </c:pt>
                <c:pt idx="838">
                  <c:v>2.2240148036099998</c:v>
                </c:pt>
                <c:pt idx="839">
                  <c:v>9.4686473459599991</c:v>
                </c:pt>
                <c:pt idx="840">
                  <c:v>2.9867957017700002</c:v>
                </c:pt>
                <c:pt idx="841">
                  <c:v>3.1155052300300001</c:v>
                </c:pt>
                <c:pt idx="842">
                  <c:v>1.1942814097100001</c:v>
                </c:pt>
                <c:pt idx="843">
                  <c:v>1.30278272919</c:v>
                </c:pt>
                <c:pt idx="844">
                  <c:v>2.2206554399699998</c:v>
                </c:pt>
                <c:pt idx="845">
                  <c:v>14.9837102949</c:v>
                </c:pt>
                <c:pt idx="846">
                  <c:v>2.25328348716</c:v>
                </c:pt>
                <c:pt idx="847">
                  <c:v>2.1678084540999998</c:v>
                </c:pt>
                <c:pt idx="848">
                  <c:v>2.9905537555500001</c:v>
                </c:pt>
                <c:pt idx="849">
                  <c:v>2.7379980991399999</c:v>
                </c:pt>
                <c:pt idx="850">
                  <c:v>2.2236989917000001</c:v>
                </c:pt>
                <c:pt idx="851">
                  <c:v>1.3279527151599999</c:v>
                </c:pt>
                <c:pt idx="852">
                  <c:v>2.58318220532</c:v>
                </c:pt>
                <c:pt idx="853">
                  <c:v>3.5514828309499999</c:v>
                </c:pt>
                <c:pt idx="854">
                  <c:v>2.0429690949300001</c:v>
                </c:pt>
                <c:pt idx="855">
                  <c:v>2.22034652453</c:v>
                </c:pt>
                <c:pt idx="856">
                  <c:v>0.905251317946</c:v>
                </c:pt>
                <c:pt idx="857">
                  <c:v>1.5941594076900001</c:v>
                </c:pt>
                <c:pt idx="858">
                  <c:v>1.4650543315</c:v>
                </c:pt>
                <c:pt idx="859">
                  <c:v>1.51287834201</c:v>
                </c:pt>
                <c:pt idx="860">
                  <c:v>12.825515705700001</c:v>
                </c:pt>
                <c:pt idx="861">
                  <c:v>1.3160511000199999</c:v>
                </c:pt>
                <c:pt idx="862">
                  <c:v>4.6794650869299996</c:v>
                </c:pt>
                <c:pt idx="863">
                  <c:v>1.1244979714500001</c:v>
                </c:pt>
                <c:pt idx="864">
                  <c:v>2.31411653847</c:v>
                </c:pt>
                <c:pt idx="865">
                  <c:v>2.2147325429200002</c:v>
                </c:pt>
                <c:pt idx="866">
                  <c:v>1.95113246049</c:v>
                </c:pt>
                <c:pt idx="867">
                  <c:v>2.8763392908999998</c:v>
                </c:pt>
                <c:pt idx="868">
                  <c:v>4.3946373675499997</c:v>
                </c:pt>
                <c:pt idx="869">
                  <c:v>22.0732302515</c:v>
                </c:pt>
                <c:pt idx="870">
                  <c:v>1.9676723918900001</c:v>
                </c:pt>
                <c:pt idx="871">
                  <c:v>2.7493459326099998</c:v>
                </c:pt>
                <c:pt idx="872">
                  <c:v>5.9428928967100001</c:v>
                </c:pt>
                <c:pt idx="873">
                  <c:v>2.5866595584500001</c:v>
                </c:pt>
                <c:pt idx="874">
                  <c:v>1.6215796071499999</c:v>
                </c:pt>
                <c:pt idx="875">
                  <c:v>2.0389783081399999</c:v>
                </c:pt>
                <c:pt idx="876">
                  <c:v>1.5868914033699999</c:v>
                </c:pt>
                <c:pt idx="877">
                  <c:v>0.67836298345000001</c:v>
                </c:pt>
                <c:pt idx="878">
                  <c:v>4.8107377018599999</c:v>
                </c:pt>
                <c:pt idx="879">
                  <c:v>2.3620239495800002</c:v>
                </c:pt>
                <c:pt idx="880">
                  <c:v>1.19581600296</c:v>
                </c:pt>
                <c:pt idx="881">
                  <c:v>1.9193170241199999</c:v>
                </c:pt>
                <c:pt idx="882">
                  <c:v>1.4447220998400001</c:v>
                </c:pt>
                <c:pt idx="883">
                  <c:v>2.2106001179099999</c:v>
                </c:pt>
                <c:pt idx="884">
                  <c:v>8.2487889132899994</c:v>
                </c:pt>
                <c:pt idx="885">
                  <c:v>1.8713615264200001</c:v>
                </c:pt>
                <c:pt idx="886">
                  <c:v>1.39793427949</c:v>
                </c:pt>
                <c:pt idx="887">
                  <c:v>1.7711146313899999</c:v>
                </c:pt>
                <c:pt idx="888">
                  <c:v>1.2577911048399999</c:v>
                </c:pt>
                <c:pt idx="889">
                  <c:v>3.8784712454500001</c:v>
                </c:pt>
                <c:pt idx="890">
                  <c:v>2.4160304722400001</c:v>
                </c:pt>
                <c:pt idx="891">
                  <c:v>2.27790371688</c:v>
                </c:pt>
                <c:pt idx="892">
                  <c:v>1.6496158328099999</c:v>
                </c:pt>
                <c:pt idx="893">
                  <c:v>2.6052831995900001</c:v>
                </c:pt>
                <c:pt idx="894">
                  <c:v>14.393122894799999</c:v>
                </c:pt>
                <c:pt idx="895">
                  <c:v>4.1263127160200002</c:v>
                </c:pt>
                <c:pt idx="896">
                  <c:v>5.4940780284999997</c:v>
                </c:pt>
                <c:pt idx="897">
                  <c:v>2.0244307090200002</c:v>
                </c:pt>
                <c:pt idx="898">
                  <c:v>2.3298044767600001</c:v>
                </c:pt>
                <c:pt idx="899">
                  <c:v>4.5800048124700004</c:v>
                </c:pt>
                <c:pt idx="900">
                  <c:v>1.65930907097</c:v>
                </c:pt>
                <c:pt idx="901">
                  <c:v>5.9506268794899997</c:v>
                </c:pt>
                <c:pt idx="902">
                  <c:v>2.3843840697199998</c:v>
                </c:pt>
                <c:pt idx="903">
                  <c:v>1.0464442217000001</c:v>
                </c:pt>
                <c:pt idx="904">
                  <c:v>1.7167563023700001</c:v>
                </c:pt>
                <c:pt idx="905">
                  <c:v>2.4514843588100002</c:v>
                </c:pt>
                <c:pt idx="906">
                  <c:v>1.19519353416</c:v>
                </c:pt>
                <c:pt idx="907">
                  <c:v>4.0459181735199996</c:v>
                </c:pt>
                <c:pt idx="908">
                  <c:v>1.37043509085</c:v>
                </c:pt>
                <c:pt idx="909">
                  <c:v>3.3506345262699999</c:v>
                </c:pt>
                <c:pt idx="910">
                  <c:v>2.74656070205</c:v>
                </c:pt>
                <c:pt idx="911">
                  <c:v>3.6030037909299999</c:v>
                </c:pt>
                <c:pt idx="912">
                  <c:v>1.07360567206</c:v>
                </c:pt>
                <c:pt idx="913">
                  <c:v>3.0915844024700001</c:v>
                </c:pt>
                <c:pt idx="914">
                  <c:v>3.9416702103199999</c:v>
                </c:pt>
                <c:pt idx="915">
                  <c:v>1.7554046788</c:v>
                </c:pt>
                <c:pt idx="916">
                  <c:v>1.58908835575</c:v>
                </c:pt>
                <c:pt idx="917">
                  <c:v>2.7981101530700001</c:v>
                </c:pt>
                <c:pt idx="918">
                  <c:v>3.8823393719900001</c:v>
                </c:pt>
                <c:pt idx="919">
                  <c:v>4.4698779897399996</c:v>
                </c:pt>
                <c:pt idx="920">
                  <c:v>1.95219245428</c:v>
                </c:pt>
                <c:pt idx="921">
                  <c:v>2.35827883376</c:v>
                </c:pt>
                <c:pt idx="922">
                  <c:v>2.2225548633300001</c:v>
                </c:pt>
                <c:pt idx="923">
                  <c:v>2.0693797028400001</c:v>
                </c:pt>
                <c:pt idx="924">
                  <c:v>0.86012087124699999</c:v>
                </c:pt>
                <c:pt idx="925">
                  <c:v>3.4745650075099999</c:v>
                </c:pt>
                <c:pt idx="926">
                  <c:v>15.821141877000001</c:v>
                </c:pt>
                <c:pt idx="927">
                  <c:v>1.88268942844</c:v>
                </c:pt>
                <c:pt idx="928">
                  <c:v>1.6648655375700001</c:v>
                </c:pt>
                <c:pt idx="929">
                  <c:v>7.0731193490499997</c:v>
                </c:pt>
                <c:pt idx="930">
                  <c:v>2.8312142309200001</c:v>
                </c:pt>
                <c:pt idx="931">
                  <c:v>2.0692625734000001</c:v>
                </c:pt>
                <c:pt idx="932">
                  <c:v>2.7565498387499998</c:v>
                </c:pt>
                <c:pt idx="933">
                  <c:v>0.82789126686000003</c:v>
                </c:pt>
                <c:pt idx="934">
                  <c:v>0.60306233933599995</c:v>
                </c:pt>
                <c:pt idx="935">
                  <c:v>3.6342530108500002</c:v>
                </c:pt>
                <c:pt idx="936">
                  <c:v>19.394887140000002</c:v>
                </c:pt>
                <c:pt idx="937">
                  <c:v>2.2698640749800001</c:v>
                </c:pt>
                <c:pt idx="938">
                  <c:v>2.59070712713</c:v>
                </c:pt>
                <c:pt idx="939">
                  <c:v>1.27569921042</c:v>
                </c:pt>
                <c:pt idx="940">
                  <c:v>5.5134424384300003</c:v>
                </c:pt>
                <c:pt idx="941">
                  <c:v>4.2189582681899997</c:v>
                </c:pt>
                <c:pt idx="942">
                  <c:v>1.83192351848</c:v>
                </c:pt>
                <c:pt idx="943">
                  <c:v>1.7034867783000001</c:v>
                </c:pt>
                <c:pt idx="944">
                  <c:v>0.49401891872199999</c:v>
                </c:pt>
                <c:pt idx="945">
                  <c:v>1.10367770877</c:v>
                </c:pt>
                <c:pt idx="946">
                  <c:v>2.3608467199500001</c:v>
                </c:pt>
                <c:pt idx="947">
                  <c:v>9.3579950348099992</c:v>
                </c:pt>
                <c:pt idx="948">
                  <c:v>1.7349615086400001</c:v>
                </c:pt>
                <c:pt idx="949">
                  <c:v>2.7978831287900001</c:v>
                </c:pt>
                <c:pt idx="950">
                  <c:v>1.8900285928</c:v>
                </c:pt>
                <c:pt idx="951">
                  <c:v>2.0245256991299998</c:v>
                </c:pt>
                <c:pt idx="952">
                  <c:v>13.643040450100001</c:v>
                </c:pt>
                <c:pt idx="953">
                  <c:v>10.0327488856</c:v>
                </c:pt>
                <c:pt idx="954">
                  <c:v>2.7048346202900002</c:v>
                </c:pt>
                <c:pt idx="955">
                  <c:v>2.9921087530700001</c:v>
                </c:pt>
                <c:pt idx="956">
                  <c:v>2.9590521598500001</c:v>
                </c:pt>
                <c:pt idx="957">
                  <c:v>1.8764006040600001</c:v>
                </c:pt>
                <c:pt idx="958">
                  <c:v>1.1323877547700001</c:v>
                </c:pt>
                <c:pt idx="959">
                  <c:v>7.9394796628800002</c:v>
                </c:pt>
                <c:pt idx="960">
                  <c:v>1.7993866109800001</c:v>
                </c:pt>
                <c:pt idx="961">
                  <c:v>2.1638690393400002</c:v>
                </c:pt>
                <c:pt idx="962">
                  <c:v>1.67961011492</c:v>
                </c:pt>
                <c:pt idx="963">
                  <c:v>2.82333286158</c:v>
                </c:pt>
                <c:pt idx="964">
                  <c:v>15.784126866099999</c:v>
                </c:pt>
                <c:pt idx="965">
                  <c:v>2.5498942339999999</c:v>
                </c:pt>
                <c:pt idx="966">
                  <c:v>2.2320837329100001</c:v>
                </c:pt>
                <c:pt idx="967">
                  <c:v>3.4931647403900001</c:v>
                </c:pt>
                <c:pt idx="968">
                  <c:v>2.1347251069299999</c:v>
                </c:pt>
                <c:pt idx="969">
                  <c:v>2.2197726227399999</c:v>
                </c:pt>
                <c:pt idx="970">
                  <c:v>45.351320974499998</c:v>
                </c:pt>
                <c:pt idx="971">
                  <c:v>4.0045757248099996</c:v>
                </c:pt>
                <c:pt idx="972">
                  <c:v>2.5735001378</c:v>
                </c:pt>
                <c:pt idx="973">
                  <c:v>0.65197279952999998</c:v>
                </c:pt>
                <c:pt idx="974">
                  <c:v>3.5394020087300002</c:v>
                </c:pt>
                <c:pt idx="975">
                  <c:v>1.41616650161</c:v>
                </c:pt>
                <c:pt idx="976">
                  <c:v>2.6491821363699999</c:v>
                </c:pt>
                <c:pt idx="977">
                  <c:v>1.41382939222</c:v>
                </c:pt>
                <c:pt idx="978">
                  <c:v>1.5549925599500001</c:v>
                </c:pt>
                <c:pt idx="979">
                  <c:v>2.7886379112999999</c:v>
                </c:pt>
                <c:pt idx="980">
                  <c:v>1.23383762469</c:v>
                </c:pt>
                <c:pt idx="981">
                  <c:v>7.0952138396600004</c:v>
                </c:pt>
                <c:pt idx="982">
                  <c:v>8.95322348985</c:v>
                </c:pt>
                <c:pt idx="983">
                  <c:v>1.9256700175200001</c:v>
                </c:pt>
                <c:pt idx="984">
                  <c:v>1.90256102958</c:v>
                </c:pt>
                <c:pt idx="985">
                  <c:v>1.71928213699</c:v>
                </c:pt>
                <c:pt idx="986">
                  <c:v>1.0682353766999999</c:v>
                </c:pt>
                <c:pt idx="987">
                  <c:v>1.38778308031</c:v>
                </c:pt>
                <c:pt idx="988">
                  <c:v>1.9330083337099999</c:v>
                </c:pt>
                <c:pt idx="989">
                  <c:v>3.6822993725700002</c:v>
                </c:pt>
                <c:pt idx="990">
                  <c:v>2.3224256892300001</c:v>
                </c:pt>
                <c:pt idx="991">
                  <c:v>2.3306295636900001</c:v>
                </c:pt>
                <c:pt idx="992">
                  <c:v>2.9567689529300001</c:v>
                </c:pt>
                <c:pt idx="993">
                  <c:v>1.86331414366</c:v>
                </c:pt>
                <c:pt idx="994">
                  <c:v>2.26821426934</c:v>
                </c:pt>
                <c:pt idx="995">
                  <c:v>1.61244848711</c:v>
                </c:pt>
                <c:pt idx="996">
                  <c:v>1.07503817837</c:v>
                </c:pt>
                <c:pt idx="997">
                  <c:v>2.5252707406099999</c:v>
                </c:pt>
                <c:pt idx="998">
                  <c:v>5.4213520815500003</c:v>
                </c:pt>
                <c:pt idx="999">
                  <c:v>3.08543283818</c:v>
                </c:pt>
                <c:pt idx="1000">
                  <c:v>10.037381574699999</c:v>
                </c:pt>
                <c:pt idx="1001">
                  <c:v>3.6656674480100002</c:v>
                </c:pt>
                <c:pt idx="1002">
                  <c:v>2.78374127832</c:v>
                </c:pt>
                <c:pt idx="1003">
                  <c:v>2.9449872796599998</c:v>
                </c:pt>
                <c:pt idx="1004">
                  <c:v>1.57733473994</c:v>
                </c:pt>
                <c:pt idx="1005">
                  <c:v>2.8963413126400002</c:v>
                </c:pt>
                <c:pt idx="1006">
                  <c:v>1.12682983038</c:v>
                </c:pt>
                <c:pt idx="1007">
                  <c:v>2.38819989441</c:v>
                </c:pt>
                <c:pt idx="1008">
                  <c:v>1.5600245903700001</c:v>
                </c:pt>
                <c:pt idx="1009">
                  <c:v>1.9006158066800001</c:v>
                </c:pt>
                <c:pt idx="1010">
                  <c:v>1.85892075253</c:v>
                </c:pt>
                <c:pt idx="1011">
                  <c:v>3.3186238161400001</c:v>
                </c:pt>
                <c:pt idx="1012">
                  <c:v>11.3695654339</c:v>
                </c:pt>
                <c:pt idx="1013">
                  <c:v>1.7642871849499999</c:v>
                </c:pt>
                <c:pt idx="1014">
                  <c:v>1.9777032030199999</c:v>
                </c:pt>
                <c:pt idx="1015">
                  <c:v>2.0821550742000001</c:v>
                </c:pt>
                <c:pt idx="1016">
                  <c:v>3.6427268863700002</c:v>
                </c:pt>
                <c:pt idx="1017">
                  <c:v>1.1472103764799999</c:v>
                </c:pt>
                <c:pt idx="1018">
                  <c:v>3.7703290106599998</c:v>
                </c:pt>
                <c:pt idx="1019">
                  <c:v>1.26627890955</c:v>
                </c:pt>
                <c:pt idx="1020">
                  <c:v>2.3310311385000002</c:v>
                </c:pt>
                <c:pt idx="1021">
                  <c:v>3.41090182124</c:v>
                </c:pt>
                <c:pt idx="1022">
                  <c:v>1.5337074855999999</c:v>
                </c:pt>
                <c:pt idx="1023">
                  <c:v>2.67179579031</c:v>
                </c:pt>
                <c:pt idx="1024">
                  <c:v>2.5922906089</c:v>
                </c:pt>
                <c:pt idx="1025">
                  <c:v>2.40896341929</c:v>
                </c:pt>
                <c:pt idx="1026">
                  <c:v>3.3804572185400001</c:v>
                </c:pt>
                <c:pt idx="1027">
                  <c:v>2.9441429674899999</c:v>
                </c:pt>
                <c:pt idx="1028">
                  <c:v>2.6196279261000002</c:v>
                </c:pt>
                <c:pt idx="1029">
                  <c:v>1.8292601228600001</c:v>
                </c:pt>
                <c:pt idx="1030">
                  <c:v>3.1760768205100001</c:v>
                </c:pt>
                <c:pt idx="1031">
                  <c:v>3.5628197145999998</c:v>
                </c:pt>
                <c:pt idx="1032">
                  <c:v>2.52785238435</c:v>
                </c:pt>
                <c:pt idx="1033">
                  <c:v>2.8536449534299999</c:v>
                </c:pt>
                <c:pt idx="1034">
                  <c:v>3.1490509525900001</c:v>
                </c:pt>
                <c:pt idx="1035">
                  <c:v>3.2069602472600001</c:v>
                </c:pt>
                <c:pt idx="1036">
                  <c:v>2.7579924554300002</c:v>
                </c:pt>
                <c:pt idx="1037">
                  <c:v>1.7970346020200001</c:v>
                </c:pt>
                <c:pt idx="1038">
                  <c:v>2.3977325495200001</c:v>
                </c:pt>
                <c:pt idx="1039">
                  <c:v>2.6589041885700002</c:v>
                </c:pt>
                <c:pt idx="1040">
                  <c:v>1.1577364157400001</c:v>
                </c:pt>
                <c:pt idx="1041">
                  <c:v>11.080589353500001</c:v>
                </c:pt>
                <c:pt idx="1042">
                  <c:v>1.37889079442</c:v>
                </c:pt>
                <c:pt idx="1043">
                  <c:v>1.68016742196</c:v>
                </c:pt>
                <c:pt idx="1044">
                  <c:v>1.59561274016</c:v>
                </c:pt>
                <c:pt idx="1045">
                  <c:v>1.68357851545</c:v>
                </c:pt>
                <c:pt idx="1046">
                  <c:v>2.26133033759</c:v>
                </c:pt>
                <c:pt idx="1047">
                  <c:v>4.9211946370600002</c:v>
                </c:pt>
                <c:pt idx="1048">
                  <c:v>2.4865785316200002</c:v>
                </c:pt>
                <c:pt idx="1049">
                  <c:v>2.28928618045</c:v>
                </c:pt>
                <c:pt idx="1050">
                  <c:v>2.5705332328499999</c:v>
                </c:pt>
                <c:pt idx="1051">
                  <c:v>1.2511701522900001</c:v>
                </c:pt>
                <c:pt idx="1052">
                  <c:v>2.9603410807700001</c:v>
                </c:pt>
                <c:pt idx="1053">
                  <c:v>4.4805293386600002</c:v>
                </c:pt>
                <c:pt idx="1054">
                  <c:v>1.3427841539700001</c:v>
                </c:pt>
                <c:pt idx="1055">
                  <c:v>4.4444239459499997</c:v>
                </c:pt>
                <c:pt idx="1056">
                  <c:v>2.9967937891199998</c:v>
                </c:pt>
                <c:pt idx="1057">
                  <c:v>1.8035741649199999</c:v>
                </c:pt>
                <c:pt idx="1058">
                  <c:v>2.5768213260100001</c:v>
                </c:pt>
                <c:pt idx="1059">
                  <c:v>1.96358060816</c:v>
                </c:pt>
                <c:pt idx="1060">
                  <c:v>2.24062242291</c:v>
                </c:pt>
                <c:pt idx="1061">
                  <c:v>2.27940306672</c:v>
                </c:pt>
                <c:pt idx="1062">
                  <c:v>4.9521518644800002</c:v>
                </c:pt>
                <c:pt idx="1063">
                  <c:v>1.72275403402</c:v>
                </c:pt>
                <c:pt idx="1064">
                  <c:v>0.94214319060499996</c:v>
                </c:pt>
                <c:pt idx="1065">
                  <c:v>1.3063273712200001</c:v>
                </c:pt>
                <c:pt idx="1066">
                  <c:v>2.60724815272</c:v>
                </c:pt>
                <c:pt idx="1067">
                  <c:v>20.222189570299999</c:v>
                </c:pt>
                <c:pt idx="1068">
                  <c:v>0.67620560670999996</c:v>
                </c:pt>
                <c:pt idx="1069">
                  <c:v>2.44245434794</c:v>
                </c:pt>
                <c:pt idx="1070">
                  <c:v>1.6029013056999999</c:v>
                </c:pt>
                <c:pt idx="1071">
                  <c:v>1.1339942939500001</c:v>
                </c:pt>
                <c:pt idx="1072">
                  <c:v>1.12717885379</c:v>
                </c:pt>
                <c:pt idx="1073">
                  <c:v>6.2790593604999998</c:v>
                </c:pt>
                <c:pt idx="1074">
                  <c:v>3.18253345303</c:v>
                </c:pt>
                <c:pt idx="1075">
                  <c:v>5.22099437363</c:v>
                </c:pt>
                <c:pt idx="1076">
                  <c:v>3.8996920373999999</c:v>
                </c:pt>
                <c:pt idx="1077">
                  <c:v>3.5605884891500001</c:v>
                </c:pt>
                <c:pt idx="1078">
                  <c:v>2.9866522843499999</c:v>
                </c:pt>
                <c:pt idx="1079">
                  <c:v>2.45271367989</c:v>
                </c:pt>
                <c:pt idx="1080">
                  <c:v>1.9658798468100001</c:v>
                </c:pt>
                <c:pt idx="1081">
                  <c:v>3.8315016641100001</c:v>
                </c:pt>
                <c:pt idx="1082">
                  <c:v>1.1845641418899999</c:v>
                </c:pt>
                <c:pt idx="1083">
                  <c:v>2.2862534142099999</c:v>
                </c:pt>
                <c:pt idx="1084">
                  <c:v>1.7341705890700001</c:v>
                </c:pt>
                <c:pt idx="1085">
                  <c:v>21.4248025636</c:v>
                </c:pt>
                <c:pt idx="1086">
                  <c:v>3.1324535533</c:v>
                </c:pt>
                <c:pt idx="1087">
                  <c:v>4.4859301156700004</c:v>
                </c:pt>
                <c:pt idx="1088">
                  <c:v>3.6794250934399999</c:v>
                </c:pt>
                <c:pt idx="1089">
                  <c:v>1.15034717107</c:v>
                </c:pt>
                <c:pt idx="1090">
                  <c:v>4.7906418051299999</c:v>
                </c:pt>
                <c:pt idx="1091">
                  <c:v>3.6947788504500001</c:v>
                </c:pt>
                <c:pt idx="1092">
                  <c:v>4.6157471689199996</c:v>
                </c:pt>
                <c:pt idx="1093">
                  <c:v>1.7751146653400001</c:v>
                </c:pt>
                <c:pt idx="1094">
                  <c:v>1.23105578311</c:v>
                </c:pt>
                <c:pt idx="1095">
                  <c:v>1.93696690972</c:v>
                </c:pt>
                <c:pt idx="1096">
                  <c:v>4.44791591125</c:v>
                </c:pt>
                <c:pt idx="1097">
                  <c:v>1.4755307715899999</c:v>
                </c:pt>
                <c:pt idx="1098">
                  <c:v>2.5135318228800001</c:v>
                </c:pt>
                <c:pt idx="1099">
                  <c:v>4.0133392955199998</c:v>
                </c:pt>
                <c:pt idx="1100">
                  <c:v>23.3711494209</c:v>
                </c:pt>
                <c:pt idx="1101">
                  <c:v>0.97176518900599995</c:v>
                </c:pt>
                <c:pt idx="1102">
                  <c:v>3.1371574022900002</c:v>
                </c:pt>
                <c:pt idx="1103">
                  <c:v>1.1179410505</c:v>
                </c:pt>
                <c:pt idx="1104">
                  <c:v>5.9215118017200004</c:v>
                </c:pt>
                <c:pt idx="1105">
                  <c:v>2.7056219806100001</c:v>
                </c:pt>
                <c:pt idx="1106">
                  <c:v>2.3079784773099998</c:v>
                </c:pt>
                <c:pt idx="1107">
                  <c:v>1.8601674967099999</c:v>
                </c:pt>
                <c:pt idx="1108">
                  <c:v>2.1429181696500001</c:v>
                </c:pt>
                <c:pt idx="1109">
                  <c:v>5.0517080729400003</c:v>
                </c:pt>
                <c:pt idx="1110">
                  <c:v>2.5474967882600001</c:v>
                </c:pt>
                <c:pt idx="1111">
                  <c:v>3.5416803847499998</c:v>
                </c:pt>
                <c:pt idx="1112">
                  <c:v>2.5153576333599998</c:v>
                </c:pt>
                <c:pt idx="1113">
                  <c:v>2.2588322983900002</c:v>
                </c:pt>
                <c:pt idx="1114">
                  <c:v>1.92490324327</c:v>
                </c:pt>
                <c:pt idx="1115">
                  <c:v>1.9289990717000001</c:v>
                </c:pt>
                <c:pt idx="1116">
                  <c:v>1.9945555825600001</c:v>
                </c:pt>
                <c:pt idx="1117">
                  <c:v>2.9904368107699999</c:v>
                </c:pt>
                <c:pt idx="1118">
                  <c:v>0.38618182185200001</c:v>
                </c:pt>
                <c:pt idx="1119">
                  <c:v>2.9232647152200002</c:v>
                </c:pt>
                <c:pt idx="1120">
                  <c:v>2.05183504153</c:v>
                </c:pt>
                <c:pt idx="1121">
                  <c:v>2.45490738747</c:v>
                </c:pt>
                <c:pt idx="1122">
                  <c:v>2.2321121271800002</c:v>
                </c:pt>
                <c:pt idx="1123">
                  <c:v>18.4288263999</c:v>
                </c:pt>
                <c:pt idx="1124">
                  <c:v>24.056448599700001</c:v>
                </c:pt>
                <c:pt idx="1125">
                  <c:v>1.29662298784</c:v>
                </c:pt>
                <c:pt idx="1126">
                  <c:v>5.0493491238899999</c:v>
                </c:pt>
                <c:pt idx="1127">
                  <c:v>3.1456029404799999</c:v>
                </c:pt>
                <c:pt idx="1128">
                  <c:v>1.2311232936200001</c:v>
                </c:pt>
                <c:pt idx="1129">
                  <c:v>0.86395703742100005</c:v>
                </c:pt>
                <c:pt idx="1130">
                  <c:v>1.45475883184</c:v>
                </c:pt>
                <c:pt idx="1131">
                  <c:v>3.5651719883399999</c:v>
                </c:pt>
                <c:pt idx="1132">
                  <c:v>2.0296683312499999</c:v>
                </c:pt>
                <c:pt idx="1133">
                  <c:v>6.7207821163999997</c:v>
                </c:pt>
                <c:pt idx="1134">
                  <c:v>3.66852276408</c:v>
                </c:pt>
                <c:pt idx="1135">
                  <c:v>1.8972568841199999</c:v>
                </c:pt>
                <c:pt idx="1136">
                  <c:v>2.9583224498699998</c:v>
                </c:pt>
                <c:pt idx="1137">
                  <c:v>6.6719060132900001</c:v>
                </c:pt>
                <c:pt idx="1138">
                  <c:v>2.7252729418300001</c:v>
                </c:pt>
                <c:pt idx="1139">
                  <c:v>3.99922666842</c:v>
                </c:pt>
                <c:pt idx="1140">
                  <c:v>2.8808632487699999</c:v>
                </c:pt>
                <c:pt idx="1141">
                  <c:v>2.3057197019400002</c:v>
                </c:pt>
                <c:pt idx="1142">
                  <c:v>3.8913489379300001</c:v>
                </c:pt>
                <c:pt idx="1143">
                  <c:v>2.5501856888900001</c:v>
                </c:pt>
                <c:pt idx="1144">
                  <c:v>1.8701619430800001</c:v>
                </c:pt>
                <c:pt idx="1145">
                  <c:v>2.3294236848100001</c:v>
                </c:pt>
                <c:pt idx="1146">
                  <c:v>1.7347321230499999</c:v>
                </c:pt>
                <c:pt idx="1147">
                  <c:v>2.4101796789100001</c:v>
                </c:pt>
                <c:pt idx="1148">
                  <c:v>2.56830840207</c:v>
                </c:pt>
                <c:pt idx="1149">
                  <c:v>0.73195589416999995</c:v>
                </c:pt>
                <c:pt idx="1150">
                  <c:v>1.5114112482299999</c:v>
                </c:pt>
                <c:pt idx="1151">
                  <c:v>3.47684970788</c:v>
                </c:pt>
                <c:pt idx="1152">
                  <c:v>2.71033588891</c:v>
                </c:pt>
                <c:pt idx="1153">
                  <c:v>23.214788878099998</c:v>
                </c:pt>
                <c:pt idx="1154">
                  <c:v>3.90487782215</c:v>
                </c:pt>
                <c:pt idx="1155">
                  <c:v>3.5103660563500001</c:v>
                </c:pt>
                <c:pt idx="1156">
                  <c:v>3.2936126322599999</c:v>
                </c:pt>
                <c:pt idx="1157">
                  <c:v>6.7653557855399997</c:v>
                </c:pt>
                <c:pt idx="1158">
                  <c:v>3.7101180361999999</c:v>
                </c:pt>
                <c:pt idx="1159">
                  <c:v>30.608110823200001</c:v>
                </c:pt>
                <c:pt idx="1160">
                  <c:v>1.3018385139599999</c:v>
                </c:pt>
                <c:pt idx="1161">
                  <c:v>1.28451113789</c:v>
                </c:pt>
                <c:pt idx="1162">
                  <c:v>1.96256999255</c:v>
                </c:pt>
                <c:pt idx="1163">
                  <c:v>2.5444713982499998</c:v>
                </c:pt>
                <c:pt idx="1164">
                  <c:v>2.10927516415</c:v>
                </c:pt>
                <c:pt idx="1165">
                  <c:v>4.5966917094999999</c:v>
                </c:pt>
                <c:pt idx="1166">
                  <c:v>2.0682092466599999</c:v>
                </c:pt>
                <c:pt idx="1167">
                  <c:v>13.776231669</c:v>
                </c:pt>
                <c:pt idx="1168">
                  <c:v>0.94765224632099998</c:v>
                </c:pt>
                <c:pt idx="1169">
                  <c:v>3.9824588313299998</c:v>
                </c:pt>
                <c:pt idx="1170">
                  <c:v>2.5604244759000001</c:v>
                </c:pt>
                <c:pt idx="1171">
                  <c:v>5.3157542210099997</c:v>
                </c:pt>
                <c:pt idx="1172">
                  <c:v>2.6698769005699998</c:v>
                </c:pt>
                <c:pt idx="1173">
                  <c:v>5.5086908942599999</c:v>
                </c:pt>
                <c:pt idx="1174">
                  <c:v>2.37026967081</c:v>
                </c:pt>
                <c:pt idx="1175">
                  <c:v>1.684425176</c:v>
                </c:pt>
                <c:pt idx="1176">
                  <c:v>2.2326118414299998</c:v>
                </c:pt>
                <c:pt idx="1177">
                  <c:v>1.14075743963</c:v>
                </c:pt>
                <c:pt idx="1178">
                  <c:v>1.89528069119</c:v>
                </c:pt>
                <c:pt idx="1179">
                  <c:v>2.7717815249700002</c:v>
                </c:pt>
                <c:pt idx="1180">
                  <c:v>4.8739606633100001</c:v>
                </c:pt>
                <c:pt idx="1181">
                  <c:v>5.0882158636400003</c:v>
                </c:pt>
                <c:pt idx="1182">
                  <c:v>1.70725600677</c:v>
                </c:pt>
                <c:pt idx="1183">
                  <c:v>2.1119970440500002</c:v>
                </c:pt>
                <c:pt idx="1184">
                  <c:v>0.83232401219600005</c:v>
                </c:pt>
                <c:pt idx="1185">
                  <c:v>2.2745847988099999</c:v>
                </c:pt>
                <c:pt idx="1186">
                  <c:v>1.76680186915</c:v>
                </c:pt>
                <c:pt idx="1187">
                  <c:v>4.2514345537400002</c:v>
                </c:pt>
                <c:pt idx="1188">
                  <c:v>1.93368673837</c:v>
                </c:pt>
                <c:pt idx="1189">
                  <c:v>4.8415807372800002</c:v>
                </c:pt>
                <c:pt idx="1190">
                  <c:v>2.2395528152100002</c:v>
                </c:pt>
                <c:pt idx="1191">
                  <c:v>3.5263453948599999</c:v>
                </c:pt>
                <c:pt idx="1192">
                  <c:v>7.0761168324300003</c:v>
                </c:pt>
                <c:pt idx="1193">
                  <c:v>1.2879970971300001</c:v>
                </c:pt>
                <c:pt idx="1194">
                  <c:v>1.9161242868399999</c:v>
                </c:pt>
                <c:pt idx="1195">
                  <c:v>0.51130580732200004</c:v>
                </c:pt>
                <c:pt idx="1196">
                  <c:v>2.6751021132899999</c:v>
                </c:pt>
                <c:pt idx="1197">
                  <c:v>1.7470998329</c:v>
                </c:pt>
                <c:pt idx="1198">
                  <c:v>1.6559049828600001</c:v>
                </c:pt>
                <c:pt idx="1199">
                  <c:v>4.8961886270799999</c:v>
                </c:pt>
                <c:pt idx="1200">
                  <c:v>2.1567522978799998</c:v>
                </c:pt>
                <c:pt idx="1201">
                  <c:v>2.4824552352899998</c:v>
                </c:pt>
                <c:pt idx="1202">
                  <c:v>1.46558661969</c:v>
                </c:pt>
                <c:pt idx="1203">
                  <c:v>0.68304548721299996</c:v>
                </c:pt>
                <c:pt idx="1204">
                  <c:v>2.0004189692800001</c:v>
                </c:pt>
                <c:pt idx="1205">
                  <c:v>2.0523662041100001</c:v>
                </c:pt>
                <c:pt idx="1206">
                  <c:v>46.793781443</c:v>
                </c:pt>
                <c:pt idx="1207">
                  <c:v>2.0649581809000002</c:v>
                </c:pt>
                <c:pt idx="1208">
                  <c:v>1.65957098021</c:v>
                </c:pt>
                <c:pt idx="1209">
                  <c:v>2.55029673652</c:v>
                </c:pt>
                <c:pt idx="1210">
                  <c:v>2.0537099383499999</c:v>
                </c:pt>
                <c:pt idx="1211">
                  <c:v>3.8260006050599999</c:v>
                </c:pt>
                <c:pt idx="1212">
                  <c:v>2.2187205322799999</c:v>
                </c:pt>
                <c:pt idx="1213">
                  <c:v>3.5222672305099998</c:v>
                </c:pt>
                <c:pt idx="1214">
                  <c:v>6.2665880294700003</c:v>
                </c:pt>
                <c:pt idx="1215">
                  <c:v>1.54571872809</c:v>
                </c:pt>
                <c:pt idx="1216">
                  <c:v>0.60654093519499996</c:v>
                </c:pt>
                <c:pt idx="1217">
                  <c:v>3.4132437210100002</c:v>
                </c:pt>
                <c:pt idx="1218">
                  <c:v>1.69385983436</c:v>
                </c:pt>
                <c:pt idx="1219">
                  <c:v>1.88909339864</c:v>
                </c:pt>
                <c:pt idx="1220">
                  <c:v>3.0896801129</c:v>
                </c:pt>
                <c:pt idx="1221">
                  <c:v>2.3340348467499998</c:v>
                </c:pt>
              </c:numCache>
            </c:numRef>
          </c:xVal>
          <c:yVal>
            <c:numRef>
              <c:f>[FPKMs.MLLT11.ICAM1.xlsx]Sheet1!$D$2:$D$1223</c:f>
              <c:numCache>
                <c:formatCode>General</c:formatCode>
                <c:ptCount val="1222"/>
                <c:pt idx="0">
                  <c:v>4.3575590764200003</c:v>
                </c:pt>
                <c:pt idx="1">
                  <c:v>9.6590572167000008</c:v>
                </c:pt>
                <c:pt idx="2">
                  <c:v>23.907397528400001</c:v>
                </c:pt>
                <c:pt idx="3">
                  <c:v>5.5756039999800002</c:v>
                </c:pt>
                <c:pt idx="4">
                  <c:v>2.8978682233700002</c:v>
                </c:pt>
                <c:pt idx="5">
                  <c:v>10.5020633263</c:v>
                </c:pt>
                <c:pt idx="6">
                  <c:v>8.7824713566400003</c:v>
                </c:pt>
                <c:pt idx="7">
                  <c:v>4.2187704895599998</c:v>
                </c:pt>
                <c:pt idx="8">
                  <c:v>8.7667558991500005</c:v>
                </c:pt>
                <c:pt idx="9">
                  <c:v>113.44941052999999</c:v>
                </c:pt>
                <c:pt idx="10">
                  <c:v>6.45304995547</c:v>
                </c:pt>
                <c:pt idx="11">
                  <c:v>27.185177192200001</c:v>
                </c:pt>
                <c:pt idx="12">
                  <c:v>4.8258174142300003</c:v>
                </c:pt>
                <c:pt idx="13">
                  <c:v>12.447457549599999</c:v>
                </c:pt>
                <c:pt idx="14">
                  <c:v>68.882429611099994</c:v>
                </c:pt>
                <c:pt idx="15">
                  <c:v>11.438012390700001</c:v>
                </c:pt>
                <c:pt idx="16">
                  <c:v>3.9687585264999998</c:v>
                </c:pt>
                <c:pt idx="17">
                  <c:v>8.9916849185000007</c:v>
                </c:pt>
                <c:pt idx="18">
                  <c:v>8.2987885604600002</c:v>
                </c:pt>
                <c:pt idx="19">
                  <c:v>5.2829215193700003</c:v>
                </c:pt>
                <c:pt idx="20">
                  <c:v>7.6173373950399998</c:v>
                </c:pt>
                <c:pt idx="21">
                  <c:v>13.609006427000001</c:v>
                </c:pt>
                <c:pt idx="22">
                  <c:v>7.0608494053199999</c:v>
                </c:pt>
                <c:pt idx="23">
                  <c:v>7.0829461869200001</c:v>
                </c:pt>
                <c:pt idx="24">
                  <c:v>6.70740606719</c:v>
                </c:pt>
                <c:pt idx="25">
                  <c:v>13.5306208449</c:v>
                </c:pt>
                <c:pt idx="26">
                  <c:v>29.035669051399999</c:v>
                </c:pt>
                <c:pt idx="27">
                  <c:v>11.700389082499999</c:v>
                </c:pt>
                <c:pt idx="28">
                  <c:v>12.451533491999999</c:v>
                </c:pt>
                <c:pt idx="29">
                  <c:v>12.846625764900001</c:v>
                </c:pt>
                <c:pt idx="30">
                  <c:v>11.893380603400001</c:v>
                </c:pt>
                <c:pt idx="31">
                  <c:v>15.3385322663</c:v>
                </c:pt>
                <c:pt idx="32">
                  <c:v>35.275267375699997</c:v>
                </c:pt>
                <c:pt idx="33">
                  <c:v>2.8337918068399999</c:v>
                </c:pt>
                <c:pt idx="34">
                  <c:v>4.9027776204100002</c:v>
                </c:pt>
                <c:pt idx="35">
                  <c:v>11.216093932</c:v>
                </c:pt>
                <c:pt idx="36">
                  <c:v>6.1677537435699996</c:v>
                </c:pt>
                <c:pt idx="37">
                  <c:v>7.7810177300500003</c:v>
                </c:pt>
                <c:pt idx="38">
                  <c:v>6.7028452596200001</c:v>
                </c:pt>
                <c:pt idx="39">
                  <c:v>8.0322964458299992</c:v>
                </c:pt>
                <c:pt idx="40">
                  <c:v>14.2428503536</c:v>
                </c:pt>
                <c:pt idx="41">
                  <c:v>5.8299335839899999</c:v>
                </c:pt>
                <c:pt idx="42">
                  <c:v>12.0004776394</c:v>
                </c:pt>
                <c:pt idx="43">
                  <c:v>18.693789302900001</c:v>
                </c:pt>
                <c:pt idx="44">
                  <c:v>1.42120020061</c:v>
                </c:pt>
                <c:pt idx="45">
                  <c:v>3.1864229872599998</c:v>
                </c:pt>
                <c:pt idx="46">
                  <c:v>2.1358001148199999</c:v>
                </c:pt>
                <c:pt idx="47">
                  <c:v>4.5743802227900003</c:v>
                </c:pt>
                <c:pt idx="48">
                  <c:v>7.1379971924400003</c:v>
                </c:pt>
                <c:pt idx="49">
                  <c:v>6.5026275269699996</c:v>
                </c:pt>
                <c:pt idx="50">
                  <c:v>34.002014476100001</c:v>
                </c:pt>
                <c:pt idx="51">
                  <c:v>3.3443279295899999</c:v>
                </c:pt>
                <c:pt idx="52">
                  <c:v>16.972823030499999</c:v>
                </c:pt>
                <c:pt idx="53">
                  <c:v>4.2387363328900003</c:v>
                </c:pt>
                <c:pt idx="54">
                  <c:v>10.9556335236</c:v>
                </c:pt>
                <c:pt idx="55">
                  <c:v>4.9334123773299998</c:v>
                </c:pt>
                <c:pt idx="56">
                  <c:v>12.639886431900001</c:v>
                </c:pt>
                <c:pt idx="57">
                  <c:v>15.853475725999999</c:v>
                </c:pt>
                <c:pt idx="58">
                  <c:v>25.948561010199999</c:v>
                </c:pt>
                <c:pt idx="59">
                  <c:v>14.999063616200001</c:v>
                </c:pt>
                <c:pt idx="60">
                  <c:v>5.7332775869799999</c:v>
                </c:pt>
                <c:pt idx="61">
                  <c:v>10.080968396099999</c:v>
                </c:pt>
                <c:pt idx="62">
                  <c:v>9.4142971788400001</c:v>
                </c:pt>
                <c:pt idx="63">
                  <c:v>7.6157260707800001</c:v>
                </c:pt>
                <c:pt idx="64">
                  <c:v>2.52178171061</c:v>
                </c:pt>
                <c:pt idx="65">
                  <c:v>1.42061677662</c:v>
                </c:pt>
                <c:pt idx="66">
                  <c:v>13.271003798100001</c:v>
                </c:pt>
                <c:pt idx="67">
                  <c:v>9.35637468953</c:v>
                </c:pt>
                <c:pt idx="68">
                  <c:v>2.7879814031699999</c:v>
                </c:pt>
                <c:pt idx="69">
                  <c:v>32.298017030899999</c:v>
                </c:pt>
                <c:pt idx="70">
                  <c:v>21.5666252788</c:v>
                </c:pt>
                <c:pt idx="71">
                  <c:v>14.2685765648</c:v>
                </c:pt>
                <c:pt idx="72">
                  <c:v>25.085928958299998</c:v>
                </c:pt>
                <c:pt idx="73">
                  <c:v>52.116203652099998</c:v>
                </c:pt>
                <c:pt idx="74">
                  <c:v>8.1654620527699997</c:v>
                </c:pt>
                <c:pt idx="75">
                  <c:v>9.2246400329099991</c:v>
                </c:pt>
                <c:pt idx="76">
                  <c:v>13.0344456033</c:v>
                </c:pt>
                <c:pt idx="77">
                  <c:v>15.1178076526</c:v>
                </c:pt>
                <c:pt idx="78">
                  <c:v>12.3955944244</c:v>
                </c:pt>
                <c:pt idx="79">
                  <c:v>9.26713390952</c:v>
                </c:pt>
                <c:pt idx="80">
                  <c:v>6.7284568013900001</c:v>
                </c:pt>
                <c:pt idx="81">
                  <c:v>5.3435883052199999</c:v>
                </c:pt>
                <c:pt idx="82">
                  <c:v>15.660422413299999</c:v>
                </c:pt>
                <c:pt idx="83">
                  <c:v>17.539099675900001</c:v>
                </c:pt>
                <c:pt idx="84">
                  <c:v>6.2307841165599998</c:v>
                </c:pt>
                <c:pt idx="85">
                  <c:v>5.7331404218499999</c:v>
                </c:pt>
                <c:pt idx="86">
                  <c:v>22.2597210803</c:v>
                </c:pt>
                <c:pt idx="87">
                  <c:v>6.4804826150499997</c:v>
                </c:pt>
                <c:pt idx="88">
                  <c:v>8.3179157079700001</c:v>
                </c:pt>
                <c:pt idx="89">
                  <c:v>2.0396421685299999</c:v>
                </c:pt>
                <c:pt idx="90">
                  <c:v>2.40844427576</c:v>
                </c:pt>
                <c:pt idx="91">
                  <c:v>17.6198477123</c:v>
                </c:pt>
                <c:pt idx="92">
                  <c:v>22.2915990087</c:v>
                </c:pt>
                <c:pt idx="93">
                  <c:v>12.8372553401</c:v>
                </c:pt>
                <c:pt idx="94">
                  <c:v>6.3722941984799997</c:v>
                </c:pt>
                <c:pt idx="95">
                  <c:v>7.5111776907800003</c:v>
                </c:pt>
                <c:pt idx="96">
                  <c:v>6.2249140898400004</c:v>
                </c:pt>
                <c:pt idx="97">
                  <c:v>5.62871424124</c:v>
                </c:pt>
                <c:pt idx="98">
                  <c:v>11.4342350528</c:v>
                </c:pt>
                <c:pt idx="99">
                  <c:v>6.3178526652300002</c:v>
                </c:pt>
                <c:pt idx="100">
                  <c:v>3.3430268768400002</c:v>
                </c:pt>
                <c:pt idx="101">
                  <c:v>56.970190385899997</c:v>
                </c:pt>
                <c:pt idx="102">
                  <c:v>6.0655947598799997</c:v>
                </c:pt>
                <c:pt idx="103">
                  <c:v>12.9918453849</c:v>
                </c:pt>
                <c:pt idx="104">
                  <c:v>3.8764121283000001</c:v>
                </c:pt>
                <c:pt idx="105">
                  <c:v>8.3980102647900008</c:v>
                </c:pt>
                <c:pt idx="106">
                  <c:v>3.1805072179999998</c:v>
                </c:pt>
                <c:pt idx="107">
                  <c:v>6.8888151619200002</c:v>
                </c:pt>
                <c:pt idx="108">
                  <c:v>21.905052548499999</c:v>
                </c:pt>
                <c:pt idx="109">
                  <c:v>1.1052067560500001</c:v>
                </c:pt>
                <c:pt idx="110">
                  <c:v>9.0348222016099999</c:v>
                </c:pt>
                <c:pt idx="111">
                  <c:v>10.776840805399999</c:v>
                </c:pt>
                <c:pt idx="112">
                  <c:v>20.0464709309</c:v>
                </c:pt>
                <c:pt idx="113">
                  <c:v>2.60248412267</c:v>
                </c:pt>
                <c:pt idx="114">
                  <c:v>7.4999287386400004</c:v>
                </c:pt>
                <c:pt idx="115">
                  <c:v>8.1058429994800001</c:v>
                </c:pt>
                <c:pt idx="116">
                  <c:v>13.202039080500001</c:v>
                </c:pt>
                <c:pt idx="117">
                  <c:v>7.4230819847299996</c:v>
                </c:pt>
                <c:pt idx="118">
                  <c:v>4.4055605238200002</c:v>
                </c:pt>
                <c:pt idx="119">
                  <c:v>16.562476194999999</c:v>
                </c:pt>
                <c:pt idx="120">
                  <c:v>18.9135977221</c:v>
                </c:pt>
                <c:pt idx="121">
                  <c:v>8.2899975606799998</c:v>
                </c:pt>
                <c:pt idx="122">
                  <c:v>3.5712703078499999</c:v>
                </c:pt>
                <c:pt idx="123">
                  <c:v>4.6875023108700002</c:v>
                </c:pt>
                <c:pt idx="124">
                  <c:v>11.4242815535</c:v>
                </c:pt>
                <c:pt idx="125">
                  <c:v>23.067071210200002</c:v>
                </c:pt>
                <c:pt idx="126">
                  <c:v>14.0151534334</c:v>
                </c:pt>
                <c:pt idx="127">
                  <c:v>1.7265887368199999</c:v>
                </c:pt>
                <c:pt idx="128">
                  <c:v>2.4837310868200002</c:v>
                </c:pt>
                <c:pt idx="129">
                  <c:v>8.9955783017600002</c:v>
                </c:pt>
                <c:pt idx="130">
                  <c:v>8.0058167996900007</c:v>
                </c:pt>
                <c:pt idx="131">
                  <c:v>4.9554793115800004</c:v>
                </c:pt>
                <c:pt idx="132">
                  <c:v>10.693025103</c:v>
                </c:pt>
                <c:pt idx="133">
                  <c:v>17.811259457599999</c:v>
                </c:pt>
                <c:pt idx="134">
                  <c:v>9.1970554192799998</c:v>
                </c:pt>
                <c:pt idx="135">
                  <c:v>21.3361379336</c:v>
                </c:pt>
                <c:pt idx="136">
                  <c:v>127.62028971700001</c:v>
                </c:pt>
                <c:pt idx="137">
                  <c:v>11.6903774094</c:v>
                </c:pt>
                <c:pt idx="138">
                  <c:v>10.9062425701</c:v>
                </c:pt>
                <c:pt idx="139">
                  <c:v>3.1463484162099999</c:v>
                </c:pt>
                <c:pt idx="140">
                  <c:v>8.9819287686100004</c:v>
                </c:pt>
                <c:pt idx="141">
                  <c:v>13.694482970099999</c:v>
                </c:pt>
                <c:pt idx="142">
                  <c:v>2.6003048893799998</c:v>
                </c:pt>
                <c:pt idx="143">
                  <c:v>25.614436943299999</c:v>
                </c:pt>
                <c:pt idx="144">
                  <c:v>13.3254431302</c:v>
                </c:pt>
                <c:pt idx="145">
                  <c:v>25.314133479900001</c:v>
                </c:pt>
                <c:pt idx="146">
                  <c:v>6.1269800554199998</c:v>
                </c:pt>
                <c:pt idx="147">
                  <c:v>8.5524282824900002</c:v>
                </c:pt>
                <c:pt idx="148">
                  <c:v>9.92730961004</c:v>
                </c:pt>
                <c:pt idx="149">
                  <c:v>11.095326012999999</c:v>
                </c:pt>
                <c:pt idx="150">
                  <c:v>14.6940658586</c:v>
                </c:pt>
                <c:pt idx="151">
                  <c:v>13.029100912800001</c:v>
                </c:pt>
                <c:pt idx="152">
                  <c:v>2.2306952592</c:v>
                </c:pt>
                <c:pt idx="153">
                  <c:v>2.7826891816399999</c:v>
                </c:pt>
                <c:pt idx="154">
                  <c:v>1.6928995928399999</c:v>
                </c:pt>
                <c:pt idx="155">
                  <c:v>29.164759307499999</c:v>
                </c:pt>
                <c:pt idx="156">
                  <c:v>12.6009756404</c:v>
                </c:pt>
                <c:pt idx="157">
                  <c:v>9.7539852736199997</c:v>
                </c:pt>
                <c:pt idx="158">
                  <c:v>6.8424913743799998</c:v>
                </c:pt>
                <c:pt idx="159">
                  <c:v>50.708876046100002</c:v>
                </c:pt>
                <c:pt idx="160">
                  <c:v>9.1534071773600001</c:v>
                </c:pt>
                <c:pt idx="161">
                  <c:v>3.1404787500900002</c:v>
                </c:pt>
                <c:pt idx="162">
                  <c:v>12.563327618500001</c:v>
                </c:pt>
                <c:pt idx="163">
                  <c:v>6.0092841410000002</c:v>
                </c:pt>
                <c:pt idx="164">
                  <c:v>1.02657688151</c:v>
                </c:pt>
                <c:pt idx="165">
                  <c:v>9.1515922019900007</c:v>
                </c:pt>
                <c:pt idx="166">
                  <c:v>4.3416745976</c:v>
                </c:pt>
                <c:pt idx="167">
                  <c:v>15.714482455900001</c:v>
                </c:pt>
                <c:pt idx="168">
                  <c:v>6.6613822487199998</c:v>
                </c:pt>
                <c:pt idx="169">
                  <c:v>5.6387944144600004</c:v>
                </c:pt>
                <c:pt idx="170">
                  <c:v>5.5599825210200002</c:v>
                </c:pt>
                <c:pt idx="171">
                  <c:v>9.4381707296799995</c:v>
                </c:pt>
                <c:pt idx="172">
                  <c:v>28.957426375699999</c:v>
                </c:pt>
                <c:pt idx="173">
                  <c:v>99.184636883600007</c:v>
                </c:pt>
                <c:pt idx="174">
                  <c:v>8.5690740842899995</c:v>
                </c:pt>
                <c:pt idx="175">
                  <c:v>10.020669097400001</c:v>
                </c:pt>
                <c:pt idx="176">
                  <c:v>4.07033752197</c:v>
                </c:pt>
                <c:pt idx="177">
                  <c:v>15.906116455099999</c:v>
                </c:pt>
                <c:pt idx="178">
                  <c:v>9.0825599289499994</c:v>
                </c:pt>
                <c:pt idx="179">
                  <c:v>6.7124202685699998</c:v>
                </c:pt>
                <c:pt idx="180">
                  <c:v>1.33790624045</c:v>
                </c:pt>
                <c:pt idx="181">
                  <c:v>13.118676794900001</c:v>
                </c:pt>
                <c:pt idx="182">
                  <c:v>8.0489119359999997</c:v>
                </c:pt>
                <c:pt idx="183">
                  <c:v>20.528957984400002</c:v>
                </c:pt>
                <c:pt idx="184">
                  <c:v>6.2695884127900001</c:v>
                </c:pt>
                <c:pt idx="185">
                  <c:v>11.5494623214</c:v>
                </c:pt>
                <c:pt idx="186">
                  <c:v>27.9089412147</c:v>
                </c:pt>
                <c:pt idx="187">
                  <c:v>23.808755218200002</c:v>
                </c:pt>
                <c:pt idx="188">
                  <c:v>3.1531208738999998</c:v>
                </c:pt>
                <c:pt idx="189">
                  <c:v>5.9100847097100004</c:v>
                </c:pt>
                <c:pt idx="190">
                  <c:v>10.3859814585</c:v>
                </c:pt>
                <c:pt idx="191">
                  <c:v>15.659129569499999</c:v>
                </c:pt>
                <c:pt idx="192">
                  <c:v>36.046355605899997</c:v>
                </c:pt>
                <c:pt idx="193">
                  <c:v>45.135508918500001</c:v>
                </c:pt>
                <c:pt idx="194">
                  <c:v>5.3390364000900004</c:v>
                </c:pt>
                <c:pt idx="195">
                  <c:v>19.301366424299999</c:v>
                </c:pt>
                <c:pt idx="196">
                  <c:v>3.59321198091</c:v>
                </c:pt>
                <c:pt idx="197">
                  <c:v>10.0780104618</c:v>
                </c:pt>
                <c:pt idx="198">
                  <c:v>30.381729248799999</c:v>
                </c:pt>
                <c:pt idx="199">
                  <c:v>10.4823623143</c:v>
                </c:pt>
                <c:pt idx="200">
                  <c:v>17.427395805900002</c:v>
                </c:pt>
                <c:pt idx="201">
                  <c:v>1.1044268233300001</c:v>
                </c:pt>
                <c:pt idx="202">
                  <c:v>7.9835722780199996</c:v>
                </c:pt>
                <c:pt idx="203">
                  <c:v>20.226583124499999</c:v>
                </c:pt>
                <c:pt idx="204">
                  <c:v>7.0740267169499997</c:v>
                </c:pt>
                <c:pt idx="205">
                  <c:v>9.5592667865200003</c:v>
                </c:pt>
                <c:pt idx="206">
                  <c:v>24.181088002999999</c:v>
                </c:pt>
                <c:pt idx="207">
                  <c:v>6.2454472294299999</c:v>
                </c:pt>
                <c:pt idx="208">
                  <c:v>11.629718540900001</c:v>
                </c:pt>
                <c:pt idx="209">
                  <c:v>5.3488895040699997</c:v>
                </c:pt>
                <c:pt idx="210">
                  <c:v>8.4971567586500001</c:v>
                </c:pt>
                <c:pt idx="211">
                  <c:v>3.7006605936399999</c:v>
                </c:pt>
                <c:pt idx="212">
                  <c:v>5.2747662282399999</c:v>
                </c:pt>
                <c:pt idx="213">
                  <c:v>2.6964424554700002</c:v>
                </c:pt>
                <c:pt idx="214">
                  <c:v>2.1348622418200001</c:v>
                </c:pt>
                <c:pt idx="215">
                  <c:v>9.0312232717499992</c:v>
                </c:pt>
                <c:pt idx="216">
                  <c:v>11.958869805599999</c:v>
                </c:pt>
                <c:pt idx="217">
                  <c:v>8.3350082499199996</c:v>
                </c:pt>
                <c:pt idx="218">
                  <c:v>124.763570532</c:v>
                </c:pt>
                <c:pt idx="219">
                  <c:v>5.9327402732400003</c:v>
                </c:pt>
                <c:pt idx="220">
                  <c:v>1.77369926399</c:v>
                </c:pt>
                <c:pt idx="221">
                  <c:v>6.2873208891000001</c:v>
                </c:pt>
                <c:pt idx="222">
                  <c:v>7.3057328190800002</c:v>
                </c:pt>
                <c:pt idx="223">
                  <c:v>26.92428035</c:v>
                </c:pt>
                <c:pt idx="224">
                  <c:v>5.0454181988300002</c:v>
                </c:pt>
                <c:pt idx="225">
                  <c:v>4.2638874103799997</c:v>
                </c:pt>
                <c:pt idx="226">
                  <c:v>45.321595813800002</c:v>
                </c:pt>
                <c:pt idx="227">
                  <c:v>4.29841552164</c:v>
                </c:pt>
                <c:pt idx="228">
                  <c:v>24.280459395699999</c:v>
                </c:pt>
                <c:pt idx="229">
                  <c:v>6.1964315705699997</c:v>
                </c:pt>
                <c:pt idx="230">
                  <c:v>7.7023421228400002</c:v>
                </c:pt>
                <c:pt idx="231">
                  <c:v>4.2404842395399998</c:v>
                </c:pt>
                <c:pt idx="232">
                  <c:v>1.3845214909100001</c:v>
                </c:pt>
                <c:pt idx="233">
                  <c:v>6.4006269616299996</c:v>
                </c:pt>
                <c:pt idx="234">
                  <c:v>8.18951172525</c:v>
                </c:pt>
                <c:pt idx="235">
                  <c:v>51.027693566499998</c:v>
                </c:pt>
                <c:pt idx="236">
                  <c:v>3.7350510211199999</c:v>
                </c:pt>
                <c:pt idx="237">
                  <c:v>5.3699461175899996</c:v>
                </c:pt>
                <c:pt idx="238">
                  <c:v>5.63911758353</c:v>
                </c:pt>
                <c:pt idx="239">
                  <c:v>6.52081984363</c:v>
                </c:pt>
                <c:pt idx="240">
                  <c:v>2.1908900240400002</c:v>
                </c:pt>
                <c:pt idx="241">
                  <c:v>3.8293751942499998</c:v>
                </c:pt>
                <c:pt idx="242">
                  <c:v>10.7118178783</c:v>
                </c:pt>
                <c:pt idx="243">
                  <c:v>17.1693392699</c:v>
                </c:pt>
                <c:pt idx="244">
                  <c:v>8.6311846943199999</c:v>
                </c:pt>
                <c:pt idx="245">
                  <c:v>4.9451541357200002</c:v>
                </c:pt>
                <c:pt idx="246">
                  <c:v>8.08799484591</c:v>
                </c:pt>
                <c:pt idx="247">
                  <c:v>8.6206935544099998</c:v>
                </c:pt>
                <c:pt idx="248">
                  <c:v>13.112696184000001</c:v>
                </c:pt>
                <c:pt idx="249">
                  <c:v>4.8395286524000003</c:v>
                </c:pt>
                <c:pt idx="250">
                  <c:v>6.15969197059</c:v>
                </c:pt>
                <c:pt idx="251">
                  <c:v>4.4431373794900004</c:v>
                </c:pt>
                <c:pt idx="252">
                  <c:v>7.1563258127299996</c:v>
                </c:pt>
                <c:pt idx="253">
                  <c:v>8.0152470372300009</c:v>
                </c:pt>
                <c:pt idx="254">
                  <c:v>13.5857823265</c:v>
                </c:pt>
                <c:pt idx="255">
                  <c:v>5.9088694463499998</c:v>
                </c:pt>
                <c:pt idx="256">
                  <c:v>6.4421569461899999</c:v>
                </c:pt>
                <c:pt idx="257">
                  <c:v>10.9499728342</c:v>
                </c:pt>
                <c:pt idx="258">
                  <c:v>66.966225080100003</c:v>
                </c:pt>
                <c:pt idx="259">
                  <c:v>59.909861882599998</c:v>
                </c:pt>
                <c:pt idx="260">
                  <c:v>10.271512380500001</c:v>
                </c:pt>
                <c:pt idx="261">
                  <c:v>39.558180332900001</c:v>
                </c:pt>
                <c:pt idx="262">
                  <c:v>9.4668623241300001</c:v>
                </c:pt>
                <c:pt idx="263">
                  <c:v>5.3361366368800001</c:v>
                </c:pt>
                <c:pt idx="264">
                  <c:v>15.566265696</c:v>
                </c:pt>
                <c:pt idx="265">
                  <c:v>2.4267594610900001</c:v>
                </c:pt>
                <c:pt idx="266">
                  <c:v>16.303537464000001</c:v>
                </c:pt>
                <c:pt idx="267">
                  <c:v>11.676970558600001</c:v>
                </c:pt>
                <c:pt idx="268">
                  <c:v>16.2407939197</c:v>
                </c:pt>
                <c:pt idx="269">
                  <c:v>6.1759484136399996</c:v>
                </c:pt>
                <c:pt idx="270">
                  <c:v>6.7373582133400003</c:v>
                </c:pt>
                <c:pt idx="271">
                  <c:v>4.8487859451500004</c:v>
                </c:pt>
                <c:pt idx="272">
                  <c:v>3.6131623877300001</c:v>
                </c:pt>
                <c:pt idx="273">
                  <c:v>5.0844998440699998</c:v>
                </c:pt>
                <c:pt idx="274">
                  <c:v>6.54762776884</c:v>
                </c:pt>
                <c:pt idx="275">
                  <c:v>3.6017791735300002</c:v>
                </c:pt>
                <c:pt idx="276">
                  <c:v>15.4516426013</c:v>
                </c:pt>
                <c:pt idx="277">
                  <c:v>0.94119909266900004</c:v>
                </c:pt>
                <c:pt idx="278">
                  <c:v>25.995868832300001</c:v>
                </c:pt>
                <c:pt idx="279">
                  <c:v>3.9576993928699999</c:v>
                </c:pt>
                <c:pt idx="280">
                  <c:v>7.8973622356100002</c:v>
                </c:pt>
                <c:pt idx="281">
                  <c:v>29.413993936400001</c:v>
                </c:pt>
                <c:pt idx="282">
                  <c:v>11.4998495239</c:v>
                </c:pt>
                <c:pt idx="283">
                  <c:v>7.8717981728300002</c:v>
                </c:pt>
                <c:pt idx="284">
                  <c:v>2.2280396308600001</c:v>
                </c:pt>
                <c:pt idx="285">
                  <c:v>6.9762143986299998</c:v>
                </c:pt>
                <c:pt idx="286">
                  <c:v>8.0779051828699995</c:v>
                </c:pt>
                <c:pt idx="287">
                  <c:v>8.2733147331199994</c:v>
                </c:pt>
                <c:pt idx="288">
                  <c:v>2.7692192305300001</c:v>
                </c:pt>
                <c:pt idx="289">
                  <c:v>11.411222521399999</c:v>
                </c:pt>
                <c:pt idx="290">
                  <c:v>24.7872929374</c:v>
                </c:pt>
                <c:pt idx="291">
                  <c:v>9.9390734895099992</c:v>
                </c:pt>
                <c:pt idx="292">
                  <c:v>4.44960290665</c:v>
                </c:pt>
                <c:pt idx="293">
                  <c:v>13.960277104499999</c:v>
                </c:pt>
                <c:pt idx="294">
                  <c:v>11.674618843099999</c:v>
                </c:pt>
                <c:pt idx="295">
                  <c:v>13.0079403238</c:v>
                </c:pt>
                <c:pt idx="296">
                  <c:v>5.2676300982599997</c:v>
                </c:pt>
                <c:pt idx="297">
                  <c:v>6.3566595617099999</c:v>
                </c:pt>
                <c:pt idx="298">
                  <c:v>11.2374919195</c:v>
                </c:pt>
                <c:pt idx="299">
                  <c:v>11.837066886800001</c:v>
                </c:pt>
                <c:pt idx="300">
                  <c:v>42.4341647161</c:v>
                </c:pt>
                <c:pt idx="301">
                  <c:v>8.6870569614100006</c:v>
                </c:pt>
                <c:pt idx="302">
                  <c:v>11.7041334612</c:v>
                </c:pt>
                <c:pt idx="303">
                  <c:v>11.4714269908</c:v>
                </c:pt>
                <c:pt idx="304">
                  <c:v>16.161904184800001</c:v>
                </c:pt>
                <c:pt idx="305">
                  <c:v>4.6335232477500004</c:v>
                </c:pt>
                <c:pt idx="306">
                  <c:v>3.0686025996100001</c:v>
                </c:pt>
                <c:pt idx="307">
                  <c:v>16.375610749700002</c:v>
                </c:pt>
                <c:pt idx="308">
                  <c:v>10.703118808099999</c:v>
                </c:pt>
                <c:pt idx="309">
                  <c:v>3.8911101050900001</c:v>
                </c:pt>
                <c:pt idx="310">
                  <c:v>25.1732852966</c:v>
                </c:pt>
                <c:pt idx="311">
                  <c:v>11.457557977700001</c:v>
                </c:pt>
                <c:pt idx="312">
                  <c:v>16.3860292259</c:v>
                </c:pt>
                <c:pt idx="313">
                  <c:v>6.1756198535299998</c:v>
                </c:pt>
                <c:pt idx="314">
                  <c:v>4.7800897865499996</c:v>
                </c:pt>
                <c:pt idx="315">
                  <c:v>87.419516291600004</c:v>
                </c:pt>
                <c:pt idx="316">
                  <c:v>13.898720518099999</c:v>
                </c:pt>
                <c:pt idx="317">
                  <c:v>15.1230528675</c:v>
                </c:pt>
                <c:pt idx="318">
                  <c:v>14.6617986966</c:v>
                </c:pt>
                <c:pt idx="319">
                  <c:v>37.822144255799998</c:v>
                </c:pt>
                <c:pt idx="320">
                  <c:v>2.6701043985099999</c:v>
                </c:pt>
                <c:pt idx="321">
                  <c:v>7.8594219391399998</c:v>
                </c:pt>
                <c:pt idx="322">
                  <c:v>0.810746069106</c:v>
                </c:pt>
                <c:pt idx="323">
                  <c:v>28.8810544171</c:v>
                </c:pt>
                <c:pt idx="324">
                  <c:v>6.7788683329800001</c:v>
                </c:pt>
                <c:pt idx="325">
                  <c:v>24.944787600200002</c:v>
                </c:pt>
                <c:pt idx="326">
                  <c:v>2.7324463087600002</c:v>
                </c:pt>
                <c:pt idx="327">
                  <c:v>14.514215095200001</c:v>
                </c:pt>
                <c:pt idx="328">
                  <c:v>93.232148614400003</c:v>
                </c:pt>
                <c:pt idx="329">
                  <c:v>9.7071201207800009</c:v>
                </c:pt>
                <c:pt idx="330">
                  <c:v>19.405023393699999</c:v>
                </c:pt>
                <c:pt idx="331">
                  <c:v>9.5799243723600007</c:v>
                </c:pt>
                <c:pt idx="332">
                  <c:v>13.190430234100001</c:v>
                </c:pt>
                <c:pt idx="333">
                  <c:v>4.79730025862</c:v>
                </c:pt>
                <c:pt idx="334">
                  <c:v>24.675425939699998</c:v>
                </c:pt>
                <c:pt idx="335">
                  <c:v>12.008533120699999</c:v>
                </c:pt>
                <c:pt idx="336">
                  <c:v>12.353303673799999</c:v>
                </c:pt>
                <c:pt idx="337">
                  <c:v>103.95253001</c:v>
                </c:pt>
                <c:pt idx="338">
                  <c:v>11.269742261699999</c:v>
                </c:pt>
                <c:pt idx="339">
                  <c:v>12.5356159701</c:v>
                </c:pt>
                <c:pt idx="340">
                  <c:v>52.878243001599998</c:v>
                </c:pt>
                <c:pt idx="341">
                  <c:v>15.264767191700001</c:v>
                </c:pt>
                <c:pt idx="342">
                  <c:v>11.0219342809</c:v>
                </c:pt>
                <c:pt idx="343">
                  <c:v>41.711518441499997</c:v>
                </c:pt>
                <c:pt idx="344">
                  <c:v>9.7090597153600005</c:v>
                </c:pt>
                <c:pt idx="345">
                  <c:v>13.8795944594</c:v>
                </c:pt>
                <c:pt idx="346">
                  <c:v>5.1942226416599997</c:v>
                </c:pt>
                <c:pt idx="347">
                  <c:v>29.6930260637</c:v>
                </c:pt>
                <c:pt idx="348">
                  <c:v>9.7646942275399997</c:v>
                </c:pt>
                <c:pt idx="349">
                  <c:v>4.8755351088200003</c:v>
                </c:pt>
                <c:pt idx="350">
                  <c:v>4.0709236947200003</c:v>
                </c:pt>
                <c:pt idx="351">
                  <c:v>4.8283158180400001</c:v>
                </c:pt>
                <c:pt idx="352">
                  <c:v>6.3964973084399999</c:v>
                </c:pt>
                <c:pt idx="353">
                  <c:v>29.4151778998</c:v>
                </c:pt>
                <c:pt idx="354">
                  <c:v>8.6456982953099999</c:v>
                </c:pt>
                <c:pt idx="355">
                  <c:v>8.6123357621499999</c:v>
                </c:pt>
                <c:pt idx="356">
                  <c:v>5.6026658281400001</c:v>
                </c:pt>
                <c:pt idx="357">
                  <c:v>17.017879107900001</c:v>
                </c:pt>
                <c:pt idx="358">
                  <c:v>8.8530067972000008</c:v>
                </c:pt>
                <c:pt idx="359">
                  <c:v>11.220938476900001</c:v>
                </c:pt>
                <c:pt idx="360">
                  <c:v>10.5051921558</c:v>
                </c:pt>
                <c:pt idx="361">
                  <c:v>38.3032200532</c:v>
                </c:pt>
                <c:pt idx="362">
                  <c:v>4.42626743835</c:v>
                </c:pt>
                <c:pt idx="363">
                  <c:v>14.083756581399999</c:v>
                </c:pt>
                <c:pt idx="364">
                  <c:v>35.864538654599997</c:v>
                </c:pt>
                <c:pt idx="365">
                  <c:v>28.326673351299998</c:v>
                </c:pt>
                <c:pt idx="366">
                  <c:v>7.35348905678</c:v>
                </c:pt>
                <c:pt idx="367">
                  <c:v>14.8194735153</c:v>
                </c:pt>
                <c:pt idx="368">
                  <c:v>3.4291356496900001</c:v>
                </c:pt>
                <c:pt idx="369">
                  <c:v>3.76376266168</c:v>
                </c:pt>
                <c:pt idx="370">
                  <c:v>7.5360656403400004</c:v>
                </c:pt>
                <c:pt idx="371">
                  <c:v>10.1201909115</c:v>
                </c:pt>
                <c:pt idx="372">
                  <c:v>9.2534349916099998</c:v>
                </c:pt>
                <c:pt idx="373">
                  <c:v>14.391775152499999</c:v>
                </c:pt>
                <c:pt idx="374">
                  <c:v>8.5222161117099997</c:v>
                </c:pt>
                <c:pt idx="375">
                  <c:v>6.1181881027999996</c:v>
                </c:pt>
                <c:pt idx="376">
                  <c:v>11.9574804271</c:v>
                </c:pt>
                <c:pt idx="377">
                  <c:v>7.6887735918800004</c:v>
                </c:pt>
                <c:pt idx="378">
                  <c:v>3.8796731502699999</c:v>
                </c:pt>
                <c:pt idx="379">
                  <c:v>32.017348268799999</c:v>
                </c:pt>
                <c:pt idx="380">
                  <c:v>7.34445891899</c:v>
                </c:pt>
                <c:pt idx="381">
                  <c:v>4.4068796412199998</c:v>
                </c:pt>
                <c:pt idx="382">
                  <c:v>25.630609717999999</c:v>
                </c:pt>
                <c:pt idx="383">
                  <c:v>5.2974645203700002</c:v>
                </c:pt>
                <c:pt idx="384">
                  <c:v>26.022057091000001</c:v>
                </c:pt>
                <c:pt idx="385">
                  <c:v>5.9949664738099999</c:v>
                </c:pt>
                <c:pt idx="386">
                  <c:v>3.9578055300999999</c:v>
                </c:pt>
                <c:pt idx="387">
                  <c:v>3.9609805524500001</c:v>
                </c:pt>
                <c:pt idx="388">
                  <c:v>24.048039520100001</c:v>
                </c:pt>
                <c:pt idx="389">
                  <c:v>7.5031045236300002</c:v>
                </c:pt>
                <c:pt idx="390">
                  <c:v>6.5433923709000004</c:v>
                </c:pt>
                <c:pt idx="391">
                  <c:v>7.9155453593700003</c:v>
                </c:pt>
                <c:pt idx="392">
                  <c:v>18.272607981699998</c:v>
                </c:pt>
                <c:pt idx="393">
                  <c:v>5.8827115052999996</c:v>
                </c:pt>
                <c:pt idx="394">
                  <c:v>7.8771951305999997</c:v>
                </c:pt>
                <c:pt idx="395">
                  <c:v>7.8829838930799996</c:v>
                </c:pt>
                <c:pt idx="396">
                  <c:v>2.4334731656400002</c:v>
                </c:pt>
                <c:pt idx="397">
                  <c:v>11.3871505318</c:v>
                </c:pt>
                <c:pt idx="398">
                  <c:v>4.5341231962200004</c:v>
                </c:pt>
                <c:pt idx="399">
                  <c:v>7.4361052793600004</c:v>
                </c:pt>
                <c:pt idx="400">
                  <c:v>6.7138463930599999</c:v>
                </c:pt>
                <c:pt idx="401">
                  <c:v>12.2840521773</c:v>
                </c:pt>
                <c:pt idx="402">
                  <c:v>4.80918293564</c:v>
                </c:pt>
                <c:pt idx="403">
                  <c:v>9.4123928696799997</c:v>
                </c:pt>
                <c:pt idx="404">
                  <c:v>5.1198902071700001</c:v>
                </c:pt>
                <c:pt idx="405">
                  <c:v>12.824667294799999</c:v>
                </c:pt>
                <c:pt idx="406">
                  <c:v>15.195982921500001</c:v>
                </c:pt>
                <c:pt idx="407">
                  <c:v>20.897018795299999</c:v>
                </c:pt>
                <c:pt idx="408">
                  <c:v>2.1127883299199999</c:v>
                </c:pt>
                <c:pt idx="409">
                  <c:v>10.4547788006</c:v>
                </c:pt>
                <c:pt idx="410">
                  <c:v>10.9470371079</c:v>
                </c:pt>
                <c:pt idx="411">
                  <c:v>7.9667896022100004</c:v>
                </c:pt>
                <c:pt idx="412">
                  <c:v>7.2251728966100002</c:v>
                </c:pt>
                <c:pt idx="413">
                  <c:v>5.9063914878399997</c:v>
                </c:pt>
                <c:pt idx="414">
                  <c:v>49.141155397399999</c:v>
                </c:pt>
                <c:pt idx="415">
                  <c:v>93.418358096000006</c:v>
                </c:pt>
                <c:pt idx="416">
                  <c:v>14.371821344100001</c:v>
                </c:pt>
                <c:pt idx="417">
                  <c:v>46.757150619800001</c:v>
                </c:pt>
                <c:pt idx="418">
                  <c:v>10.377521399400001</c:v>
                </c:pt>
                <c:pt idx="419">
                  <c:v>6.13708153387</c:v>
                </c:pt>
                <c:pt idx="420">
                  <c:v>10.7465336929</c:v>
                </c:pt>
                <c:pt idx="421">
                  <c:v>41.599928003899997</c:v>
                </c:pt>
                <c:pt idx="422">
                  <c:v>8.8147806527700006</c:v>
                </c:pt>
                <c:pt idx="423">
                  <c:v>9.40179123393</c:v>
                </c:pt>
                <c:pt idx="424">
                  <c:v>7.7176150213700003</c:v>
                </c:pt>
                <c:pt idx="425">
                  <c:v>11.389968914900001</c:v>
                </c:pt>
                <c:pt idx="426">
                  <c:v>9.5697850183399993</c:v>
                </c:pt>
                <c:pt idx="427">
                  <c:v>1.4240820948699999</c:v>
                </c:pt>
                <c:pt idx="428">
                  <c:v>7.5753684187600001</c:v>
                </c:pt>
                <c:pt idx="429">
                  <c:v>6.4758651578200004</c:v>
                </c:pt>
                <c:pt idx="430">
                  <c:v>11.565292770699999</c:v>
                </c:pt>
                <c:pt idx="431">
                  <c:v>179.73736194700001</c:v>
                </c:pt>
                <c:pt idx="432">
                  <c:v>4.9975682470200002</c:v>
                </c:pt>
                <c:pt idx="433">
                  <c:v>29.966338502599999</c:v>
                </c:pt>
                <c:pt idx="434">
                  <c:v>7.2288028448599997</c:v>
                </c:pt>
                <c:pt idx="435">
                  <c:v>9.7061733594900002</c:v>
                </c:pt>
                <c:pt idx="436">
                  <c:v>6.0142814193299996</c:v>
                </c:pt>
                <c:pt idx="437">
                  <c:v>6.3703753283399998</c:v>
                </c:pt>
                <c:pt idx="438">
                  <c:v>21.382996103100002</c:v>
                </c:pt>
                <c:pt idx="439">
                  <c:v>12.8230381493</c:v>
                </c:pt>
                <c:pt idx="440">
                  <c:v>11.9863519815</c:v>
                </c:pt>
                <c:pt idx="441">
                  <c:v>14.4634415425</c:v>
                </c:pt>
                <c:pt idx="442">
                  <c:v>26.179959274800002</c:v>
                </c:pt>
                <c:pt idx="443">
                  <c:v>25.1934061509</c:v>
                </c:pt>
                <c:pt idx="444">
                  <c:v>20.338547967</c:v>
                </c:pt>
                <c:pt idx="445">
                  <c:v>16.500894339399999</c:v>
                </c:pt>
                <c:pt idx="446">
                  <c:v>14.613175850799999</c:v>
                </c:pt>
                <c:pt idx="447">
                  <c:v>3.3137895683499998</c:v>
                </c:pt>
                <c:pt idx="448">
                  <c:v>6.444513207</c:v>
                </c:pt>
                <c:pt idx="449">
                  <c:v>49.604101614800001</c:v>
                </c:pt>
                <c:pt idx="450">
                  <c:v>6.2384460866699998</c:v>
                </c:pt>
                <c:pt idx="451">
                  <c:v>39.603339883499999</c:v>
                </c:pt>
                <c:pt idx="452">
                  <c:v>26.1561124527</c:v>
                </c:pt>
                <c:pt idx="453">
                  <c:v>11.2241752754</c:v>
                </c:pt>
                <c:pt idx="454">
                  <c:v>11.5911791456</c:v>
                </c:pt>
                <c:pt idx="455">
                  <c:v>16.933949973600001</c:v>
                </c:pt>
                <c:pt idx="456">
                  <c:v>7.1872780546200001</c:v>
                </c:pt>
                <c:pt idx="457">
                  <c:v>20.913925767199999</c:v>
                </c:pt>
                <c:pt idx="458">
                  <c:v>9.6419521637100001</c:v>
                </c:pt>
                <c:pt idx="459">
                  <c:v>16.395383023400001</c:v>
                </c:pt>
                <c:pt idx="460">
                  <c:v>7.9890875355700004</c:v>
                </c:pt>
                <c:pt idx="461">
                  <c:v>5.34456894759</c:v>
                </c:pt>
                <c:pt idx="462">
                  <c:v>7.52344752592</c:v>
                </c:pt>
                <c:pt idx="463">
                  <c:v>9.6428391655500008</c:v>
                </c:pt>
                <c:pt idx="464">
                  <c:v>5.2958513034000001</c:v>
                </c:pt>
                <c:pt idx="465">
                  <c:v>12.759474665200001</c:v>
                </c:pt>
                <c:pt idx="466">
                  <c:v>6.09595860645</c:v>
                </c:pt>
                <c:pt idx="467">
                  <c:v>84.166873692199999</c:v>
                </c:pt>
                <c:pt idx="468">
                  <c:v>2.3029765747200002</c:v>
                </c:pt>
                <c:pt idx="469">
                  <c:v>10.7975391468</c:v>
                </c:pt>
                <c:pt idx="470">
                  <c:v>11.1158819488</c:v>
                </c:pt>
                <c:pt idx="471">
                  <c:v>14.7187030031</c:v>
                </c:pt>
                <c:pt idx="472">
                  <c:v>18.227989348000001</c:v>
                </c:pt>
                <c:pt idx="473">
                  <c:v>7.2214294178399996</c:v>
                </c:pt>
                <c:pt idx="474">
                  <c:v>16.833310088200001</c:v>
                </c:pt>
                <c:pt idx="475">
                  <c:v>3.8631350845400001</c:v>
                </c:pt>
                <c:pt idx="476">
                  <c:v>29.2883290485</c:v>
                </c:pt>
                <c:pt idx="477">
                  <c:v>1.99786392432</c:v>
                </c:pt>
                <c:pt idx="478">
                  <c:v>19.449081487200001</c:v>
                </c:pt>
                <c:pt idx="479">
                  <c:v>9.0217603711900001</c:v>
                </c:pt>
                <c:pt idx="480">
                  <c:v>46.813301233700003</c:v>
                </c:pt>
                <c:pt idx="481">
                  <c:v>6.6122258822799997</c:v>
                </c:pt>
                <c:pt idx="482">
                  <c:v>9.8918251412299991</c:v>
                </c:pt>
                <c:pt idx="483">
                  <c:v>9.3083576804200003</c:v>
                </c:pt>
                <c:pt idx="484">
                  <c:v>3.0273623275200001</c:v>
                </c:pt>
                <c:pt idx="485">
                  <c:v>7.4017356279099999</c:v>
                </c:pt>
                <c:pt idx="486">
                  <c:v>6.4252947467499997</c:v>
                </c:pt>
                <c:pt idx="487">
                  <c:v>10.3941210656</c:v>
                </c:pt>
                <c:pt idx="488">
                  <c:v>13.182130241899999</c:v>
                </c:pt>
                <c:pt idx="489">
                  <c:v>10.273747262600001</c:v>
                </c:pt>
                <c:pt idx="490">
                  <c:v>10.047710784</c:v>
                </c:pt>
                <c:pt idx="491">
                  <c:v>7.7533031251800004</c:v>
                </c:pt>
                <c:pt idx="492">
                  <c:v>7.5628340418200004</c:v>
                </c:pt>
                <c:pt idx="493">
                  <c:v>7.33468043404</c:v>
                </c:pt>
                <c:pt idx="494">
                  <c:v>9.5631854429099992</c:v>
                </c:pt>
                <c:pt idx="495">
                  <c:v>2.1724947157300001</c:v>
                </c:pt>
                <c:pt idx="496">
                  <c:v>7.25923980513</c:v>
                </c:pt>
                <c:pt idx="497">
                  <c:v>6.2146396981500001</c:v>
                </c:pt>
                <c:pt idx="498">
                  <c:v>4.0467036261000002</c:v>
                </c:pt>
                <c:pt idx="499">
                  <c:v>15.690174521099999</c:v>
                </c:pt>
                <c:pt idx="500">
                  <c:v>0.970737310686</c:v>
                </c:pt>
                <c:pt idx="501">
                  <c:v>0.85240272249799998</c:v>
                </c:pt>
                <c:pt idx="502">
                  <c:v>15.6350479815</c:v>
                </c:pt>
                <c:pt idx="503">
                  <c:v>30.290144101500001</c:v>
                </c:pt>
                <c:pt idx="504">
                  <c:v>10.2918959412</c:v>
                </c:pt>
                <c:pt idx="505">
                  <c:v>9.9826466217400007</c:v>
                </c:pt>
                <c:pt idx="506">
                  <c:v>44.150802176200003</c:v>
                </c:pt>
                <c:pt idx="507">
                  <c:v>16.452651002</c:v>
                </c:pt>
                <c:pt idx="508">
                  <c:v>56.708212301700001</c:v>
                </c:pt>
                <c:pt idx="509">
                  <c:v>21.070930067700001</c:v>
                </c:pt>
                <c:pt idx="510">
                  <c:v>7.9368637188699998</c:v>
                </c:pt>
                <c:pt idx="511">
                  <c:v>9.9772667231700005</c:v>
                </c:pt>
                <c:pt idx="512">
                  <c:v>8.2542294921499995</c:v>
                </c:pt>
                <c:pt idx="513">
                  <c:v>8.4426603999500003</c:v>
                </c:pt>
                <c:pt idx="514">
                  <c:v>4.6422781940500002</c:v>
                </c:pt>
                <c:pt idx="515">
                  <c:v>14.4433704702</c:v>
                </c:pt>
                <c:pt idx="516">
                  <c:v>9.1046522323799994</c:v>
                </c:pt>
                <c:pt idx="517">
                  <c:v>19.441127203800001</c:v>
                </c:pt>
                <c:pt idx="518">
                  <c:v>13.211257505900001</c:v>
                </c:pt>
                <c:pt idx="519">
                  <c:v>12.6658045654</c:v>
                </c:pt>
                <c:pt idx="520">
                  <c:v>3.0560523181099999</c:v>
                </c:pt>
                <c:pt idx="521">
                  <c:v>12.6323095475</c:v>
                </c:pt>
                <c:pt idx="522">
                  <c:v>9.4570405663300008</c:v>
                </c:pt>
                <c:pt idx="523">
                  <c:v>4.3691532344599997</c:v>
                </c:pt>
                <c:pt idx="524">
                  <c:v>26.100724361400001</c:v>
                </c:pt>
                <c:pt idx="525">
                  <c:v>9.8710227675599995</c:v>
                </c:pt>
                <c:pt idx="526">
                  <c:v>23.557175180800002</c:v>
                </c:pt>
                <c:pt idx="527">
                  <c:v>8.3009711350799993</c:v>
                </c:pt>
                <c:pt idx="528">
                  <c:v>6.71971468953</c:v>
                </c:pt>
                <c:pt idx="529">
                  <c:v>7.1334743000099996</c:v>
                </c:pt>
                <c:pt idx="530">
                  <c:v>4.2383297584299999</c:v>
                </c:pt>
                <c:pt idx="531">
                  <c:v>8.5758036952799994</c:v>
                </c:pt>
                <c:pt idx="532">
                  <c:v>5.6755170138800004</c:v>
                </c:pt>
                <c:pt idx="533">
                  <c:v>5.9504032970500003</c:v>
                </c:pt>
                <c:pt idx="534">
                  <c:v>113.03776456200001</c:v>
                </c:pt>
                <c:pt idx="535">
                  <c:v>2.7012233047500001</c:v>
                </c:pt>
                <c:pt idx="536">
                  <c:v>11.758415447000001</c:v>
                </c:pt>
                <c:pt idx="537">
                  <c:v>23.116152769500001</c:v>
                </c:pt>
                <c:pt idx="538">
                  <c:v>1.6310061551999999</c:v>
                </c:pt>
                <c:pt idx="539">
                  <c:v>7.0211929716699997</c:v>
                </c:pt>
                <c:pt idx="540">
                  <c:v>8.0843945087000009</c:v>
                </c:pt>
                <c:pt idx="541">
                  <c:v>26.308218603099998</c:v>
                </c:pt>
                <c:pt idx="542">
                  <c:v>14.516496203699999</c:v>
                </c:pt>
                <c:pt idx="543">
                  <c:v>15.744213141099999</c:v>
                </c:pt>
                <c:pt idx="544">
                  <c:v>17.5253525848</c:v>
                </c:pt>
                <c:pt idx="545">
                  <c:v>7.2097221847400004</c:v>
                </c:pt>
                <c:pt idx="546">
                  <c:v>12.154146887</c:v>
                </c:pt>
                <c:pt idx="547">
                  <c:v>2.2610144172000002</c:v>
                </c:pt>
                <c:pt idx="548">
                  <c:v>9.2979399374200007</c:v>
                </c:pt>
                <c:pt idx="549">
                  <c:v>4.6130708734599999</c:v>
                </c:pt>
                <c:pt idx="550">
                  <c:v>5.5086169630699997</c:v>
                </c:pt>
                <c:pt idx="551">
                  <c:v>15.8127414599</c:v>
                </c:pt>
                <c:pt idx="552">
                  <c:v>18.869756499499999</c:v>
                </c:pt>
                <c:pt idx="553">
                  <c:v>6.1446237154799999</c:v>
                </c:pt>
                <c:pt idx="554">
                  <c:v>3.69918783426</c:v>
                </c:pt>
                <c:pt idx="555">
                  <c:v>22.089251903400001</c:v>
                </c:pt>
                <c:pt idx="556">
                  <c:v>17.696350538099999</c:v>
                </c:pt>
                <c:pt idx="557">
                  <c:v>11.9073412668</c:v>
                </c:pt>
                <c:pt idx="558">
                  <c:v>20.777586642700001</c:v>
                </c:pt>
                <c:pt idx="559">
                  <c:v>16.775927722300001</c:v>
                </c:pt>
                <c:pt idx="560">
                  <c:v>26.925168943399999</c:v>
                </c:pt>
                <c:pt idx="561">
                  <c:v>2.8150397498299999</c:v>
                </c:pt>
                <c:pt idx="562">
                  <c:v>13.486923967499999</c:v>
                </c:pt>
                <c:pt idx="563">
                  <c:v>7.4519142885000003</c:v>
                </c:pt>
                <c:pt idx="564">
                  <c:v>8.5852235347299999</c:v>
                </c:pt>
                <c:pt idx="565">
                  <c:v>10.0912341536</c:v>
                </c:pt>
                <c:pt idx="566">
                  <c:v>7.1285400428600001</c:v>
                </c:pt>
                <c:pt idx="567">
                  <c:v>8.5922725115399992</c:v>
                </c:pt>
                <c:pt idx="568">
                  <c:v>9.2405224625799995</c:v>
                </c:pt>
                <c:pt idx="569">
                  <c:v>15.7091146888</c:v>
                </c:pt>
                <c:pt idx="570">
                  <c:v>14.6156740847</c:v>
                </c:pt>
                <c:pt idx="571">
                  <c:v>6.0824334750500002</c:v>
                </c:pt>
                <c:pt idx="572">
                  <c:v>24.957891008899999</c:v>
                </c:pt>
                <c:pt idx="573">
                  <c:v>16.2707313051</c:v>
                </c:pt>
                <c:pt idx="574">
                  <c:v>2.2084683478499998</c:v>
                </c:pt>
                <c:pt idx="575">
                  <c:v>3.8054295164699998</c:v>
                </c:pt>
                <c:pt idx="576">
                  <c:v>4.0253695495199997</c:v>
                </c:pt>
                <c:pt idx="577">
                  <c:v>13.3777514901</c:v>
                </c:pt>
                <c:pt idx="578">
                  <c:v>2.4185065119</c:v>
                </c:pt>
                <c:pt idx="579">
                  <c:v>4.4078863781699997</c:v>
                </c:pt>
                <c:pt idx="580">
                  <c:v>3.2710161384199998</c:v>
                </c:pt>
                <c:pt idx="581">
                  <c:v>2.9902314189200001</c:v>
                </c:pt>
                <c:pt idx="582">
                  <c:v>11.2822789</c:v>
                </c:pt>
                <c:pt idx="583">
                  <c:v>11.254380448099999</c:v>
                </c:pt>
                <c:pt idx="584">
                  <c:v>8.9407010007600007</c:v>
                </c:pt>
                <c:pt idx="585">
                  <c:v>47.956541634399997</c:v>
                </c:pt>
                <c:pt idx="586">
                  <c:v>11.662412870400001</c:v>
                </c:pt>
                <c:pt idx="587">
                  <c:v>15.415418328299999</c:v>
                </c:pt>
                <c:pt idx="588">
                  <c:v>14.0870387327</c:v>
                </c:pt>
                <c:pt idx="589">
                  <c:v>11.9418300877</c:v>
                </c:pt>
                <c:pt idx="590">
                  <c:v>9.3422472295799999</c:v>
                </c:pt>
                <c:pt idx="591">
                  <c:v>16.4320138635</c:v>
                </c:pt>
                <c:pt idx="592">
                  <c:v>9.6009131771800007</c:v>
                </c:pt>
                <c:pt idx="593">
                  <c:v>7.05736080392</c:v>
                </c:pt>
                <c:pt idx="594">
                  <c:v>13.483829394900001</c:v>
                </c:pt>
                <c:pt idx="595">
                  <c:v>14.736213516599999</c:v>
                </c:pt>
                <c:pt idx="596">
                  <c:v>6.0662298898799998</c:v>
                </c:pt>
                <c:pt idx="597">
                  <c:v>4.3481541375899999</c:v>
                </c:pt>
                <c:pt idx="598">
                  <c:v>25.8142150129</c:v>
                </c:pt>
                <c:pt idx="599">
                  <c:v>8.0530788245499991</c:v>
                </c:pt>
                <c:pt idx="600">
                  <c:v>4.1876717499799998</c:v>
                </c:pt>
                <c:pt idx="601">
                  <c:v>9.8413250142699997</c:v>
                </c:pt>
                <c:pt idx="602">
                  <c:v>2.48645594621</c:v>
                </c:pt>
                <c:pt idx="603">
                  <c:v>3.8248361264400002</c:v>
                </c:pt>
                <c:pt idx="604">
                  <c:v>2.4842304890200002</c:v>
                </c:pt>
                <c:pt idx="605">
                  <c:v>6.7282447732100001</c:v>
                </c:pt>
                <c:pt idx="606">
                  <c:v>5.84912240289</c:v>
                </c:pt>
                <c:pt idx="607">
                  <c:v>4.6303676306800003</c:v>
                </c:pt>
                <c:pt idx="608">
                  <c:v>2.3790751777499999</c:v>
                </c:pt>
                <c:pt idx="609">
                  <c:v>9.8647800863100006</c:v>
                </c:pt>
                <c:pt idx="610">
                  <c:v>2.2851169764199999</c:v>
                </c:pt>
                <c:pt idx="611">
                  <c:v>7.8374554459399999</c:v>
                </c:pt>
                <c:pt idx="612">
                  <c:v>17.5740610372</c:v>
                </c:pt>
                <c:pt idx="613">
                  <c:v>10.2206409764</c:v>
                </c:pt>
                <c:pt idx="614">
                  <c:v>26.6062014024</c:v>
                </c:pt>
                <c:pt idx="615">
                  <c:v>8.3306763341500005</c:v>
                </c:pt>
                <c:pt idx="616">
                  <c:v>4.5862084144899997</c:v>
                </c:pt>
                <c:pt idx="617">
                  <c:v>2.50779484759</c:v>
                </c:pt>
                <c:pt idx="618">
                  <c:v>26.6271597842</c:v>
                </c:pt>
                <c:pt idx="619">
                  <c:v>4.8540456264099996</c:v>
                </c:pt>
                <c:pt idx="620">
                  <c:v>39.221981660700003</c:v>
                </c:pt>
                <c:pt idx="621">
                  <c:v>6.6170342877600001</c:v>
                </c:pt>
                <c:pt idx="622">
                  <c:v>37.917343056699998</c:v>
                </c:pt>
                <c:pt idx="623">
                  <c:v>9.11895744029</c:v>
                </c:pt>
                <c:pt idx="624">
                  <c:v>70.422516744800006</c:v>
                </c:pt>
                <c:pt idx="625">
                  <c:v>8.6367774537899997</c:v>
                </c:pt>
                <c:pt idx="626">
                  <c:v>19.581328253799999</c:v>
                </c:pt>
                <c:pt idx="627">
                  <c:v>4.0159694012599996</c:v>
                </c:pt>
                <c:pt idx="628">
                  <c:v>3.1841011309899998</c:v>
                </c:pt>
                <c:pt idx="629">
                  <c:v>31.386391777499998</c:v>
                </c:pt>
                <c:pt idx="630">
                  <c:v>7.9958999611700001</c:v>
                </c:pt>
                <c:pt idx="631">
                  <c:v>10.9339783026</c:v>
                </c:pt>
                <c:pt idx="632">
                  <c:v>27.4363406455</c:v>
                </c:pt>
                <c:pt idx="633">
                  <c:v>2.4584897306700002</c:v>
                </c:pt>
                <c:pt idx="634">
                  <c:v>11.285585383400001</c:v>
                </c:pt>
                <c:pt idx="635">
                  <c:v>22.564823771699999</c:v>
                </c:pt>
                <c:pt idx="636">
                  <c:v>7.39926941526</c:v>
                </c:pt>
                <c:pt idx="637">
                  <c:v>2.8938978034099998</c:v>
                </c:pt>
                <c:pt idx="638">
                  <c:v>10.622985693</c:v>
                </c:pt>
                <c:pt idx="639">
                  <c:v>21.920326938799999</c:v>
                </c:pt>
                <c:pt idx="640">
                  <c:v>15.560473685</c:v>
                </c:pt>
                <c:pt idx="641">
                  <c:v>11.151722412</c:v>
                </c:pt>
                <c:pt idx="642">
                  <c:v>4.4469081580200003</c:v>
                </c:pt>
                <c:pt idx="643">
                  <c:v>0.634860803769</c:v>
                </c:pt>
                <c:pt idx="644">
                  <c:v>4.0548228462200004</c:v>
                </c:pt>
                <c:pt idx="645">
                  <c:v>9.4296527552799994</c:v>
                </c:pt>
                <c:pt idx="646">
                  <c:v>4.82582451672</c:v>
                </c:pt>
                <c:pt idx="647">
                  <c:v>3.2643657583999999</c:v>
                </c:pt>
                <c:pt idx="648">
                  <c:v>1.58728621204</c:v>
                </c:pt>
                <c:pt idx="649">
                  <c:v>15.5506360556</c:v>
                </c:pt>
                <c:pt idx="650">
                  <c:v>16.026828841299999</c:v>
                </c:pt>
                <c:pt idx="651">
                  <c:v>6.3542415592500001</c:v>
                </c:pt>
                <c:pt idx="652">
                  <c:v>13.223693325899999</c:v>
                </c:pt>
                <c:pt idx="653">
                  <c:v>46.992897606</c:v>
                </c:pt>
                <c:pt idx="654">
                  <c:v>8.1915530127</c:v>
                </c:pt>
                <c:pt idx="655">
                  <c:v>7.2160156202100003</c:v>
                </c:pt>
                <c:pt idx="656">
                  <c:v>43.726626406900003</c:v>
                </c:pt>
                <c:pt idx="657">
                  <c:v>12.2131123092</c:v>
                </c:pt>
                <c:pt idx="658">
                  <c:v>2.7521695733599998</c:v>
                </c:pt>
                <c:pt idx="659">
                  <c:v>7.9612280236800004</c:v>
                </c:pt>
                <c:pt idx="660">
                  <c:v>19.5735882056</c:v>
                </c:pt>
                <c:pt idx="661">
                  <c:v>35.727586772800002</c:v>
                </c:pt>
                <c:pt idx="662">
                  <c:v>13.6215597389</c:v>
                </c:pt>
                <c:pt idx="663">
                  <c:v>7.32001826675</c:v>
                </c:pt>
                <c:pt idx="664">
                  <c:v>13.5726534449</c:v>
                </c:pt>
                <c:pt idx="665">
                  <c:v>14.5864712812</c:v>
                </c:pt>
                <c:pt idx="666">
                  <c:v>9.0463479397499995</c:v>
                </c:pt>
                <c:pt idx="667">
                  <c:v>7.4538208251300002</c:v>
                </c:pt>
                <c:pt idx="668">
                  <c:v>7.7981330152200004</c:v>
                </c:pt>
                <c:pt idx="669">
                  <c:v>7.5063473104499998</c:v>
                </c:pt>
                <c:pt idx="670">
                  <c:v>10.0060165239</c:v>
                </c:pt>
                <c:pt idx="671">
                  <c:v>0.82931839217000003</c:v>
                </c:pt>
                <c:pt idx="672">
                  <c:v>2.7673212201799999</c:v>
                </c:pt>
                <c:pt idx="673">
                  <c:v>10.398836595700001</c:v>
                </c:pt>
                <c:pt idx="674">
                  <c:v>20.450238678000002</c:v>
                </c:pt>
                <c:pt idx="675">
                  <c:v>32.476213087600001</c:v>
                </c:pt>
                <c:pt idx="676">
                  <c:v>21.5693653075</c:v>
                </c:pt>
                <c:pt idx="677">
                  <c:v>10.9313126264</c:v>
                </c:pt>
                <c:pt idx="678">
                  <c:v>9.9848236783500006</c:v>
                </c:pt>
                <c:pt idx="679">
                  <c:v>17.8291254976</c:v>
                </c:pt>
                <c:pt idx="680">
                  <c:v>13.6390151911</c:v>
                </c:pt>
                <c:pt idx="681">
                  <c:v>120.4667559</c:v>
                </c:pt>
                <c:pt idx="682">
                  <c:v>11.821669418100001</c:v>
                </c:pt>
                <c:pt idx="683">
                  <c:v>8.4700139117600006</c:v>
                </c:pt>
                <c:pt idx="684">
                  <c:v>12.0162255759</c:v>
                </c:pt>
                <c:pt idx="685">
                  <c:v>12.262380354899999</c:v>
                </c:pt>
                <c:pt idx="686">
                  <c:v>11.875658013800001</c:v>
                </c:pt>
                <c:pt idx="687">
                  <c:v>5.5018511496900002</c:v>
                </c:pt>
                <c:pt idx="688">
                  <c:v>3.6176139702399999</c:v>
                </c:pt>
                <c:pt idx="689">
                  <c:v>5.4486255304000002</c:v>
                </c:pt>
                <c:pt idx="690">
                  <c:v>6.2266383640800003</c:v>
                </c:pt>
                <c:pt idx="691">
                  <c:v>15.573124502900001</c:v>
                </c:pt>
                <c:pt idx="692">
                  <c:v>54.623362775700002</c:v>
                </c:pt>
                <c:pt idx="693">
                  <c:v>10.5952926132</c:v>
                </c:pt>
                <c:pt idx="694">
                  <c:v>25.580315741500002</c:v>
                </c:pt>
                <c:pt idx="695">
                  <c:v>48.500938617800003</c:v>
                </c:pt>
                <c:pt idx="696">
                  <c:v>6.8519650145200002</c:v>
                </c:pt>
                <c:pt idx="697">
                  <c:v>21.757555230099999</c:v>
                </c:pt>
                <c:pt idx="698">
                  <c:v>19.7974573955</c:v>
                </c:pt>
                <c:pt idx="699">
                  <c:v>5.8348897663799999</c:v>
                </c:pt>
                <c:pt idx="700">
                  <c:v>10.691282791200001</c:v>
                </c:pt>
                <c:pt idx="701">
                  <c:v>8.9060495888499993</c:v>
                </c:pt>
                <c:pt idx="702">
                  <c:v>3.8915982091400001</c:v>
                </c:pt>
                <c:pt idx="703">
                  <c:v>7.7956532976300004</c:v>
                </c:pt>
                <c:pt idx="704">
                  <c:v>4.0851269396500003</c:v>
                </c:pt>
                <c:pt idx="705">
                  <c:v>2.35702753208</c:v>
                </c:pt>
                <c:pt idx="706">
                  <c:v>18.739769586200001</c:v>
                </c:pt>
                <c:pt idx="707">
                  <c:v>4.6963803069800001</c:v>
                </c:pt>
                <c:pt idx="708">
                  <c:v>8.7589838141299996</c:v>
                </c:pt>
                <c:pt idx="709">
                  <c:v>18.018752975400002</c:v>
                </c:pt>
                <c:pt idx="710">
                  <c:v>22.435684718099999</c:v>
                </c:pt>
                <c:pt idx="711">
                  <c:v>12.3142662429</c:v>
                </c:pt>
                <c:pt idx="712">
                  <c:v>14.324065685900001</c:v>
                </c:pt>
                <c:pt idx="713">
                  <c:v>27.9179845126</c:v>
                </c:pt>
                <c:pt idx="714">
                  <c:v>1.45112054462</c:v>
                </c:pt>
                <c:pt idx="715">
                  <c:v>20.5052213409</c:v>
                </c:pt>
                <c:pt idx="716">
                  <c:v>10.072248095999999</c:v>
                </c:pt>
                <c:pt idx="717">
                  <c:v>7.3046482150500003</c:v>
                </c:pt>
                <c:pt idx="718">
                  <c:v>5.2966188902600004</c:v>
                </c:pt>
                <c:pt idx="719">
                  <c:v>1.37556530627</c:v>
                </c:pt>
                <c:pt idx="720">
                  <c:v>15.7491974071</c:v>
                </c:pt>
                <c:pt idx="721">
                  <c:v>13.1025544554</c:v>
                </c:pt>
                <c:pt idx="722">
                  <c:v>15.6152979647</c:v>
                </c:pt>
                <c:pt idx="723">
                  <c:v>11.083368611899999</c:v>
                </c:pt>
                <c:pt idx="724">
                  <c:v>5.3495840409099999</c:v>
                </c:pt>
                <c:pt idx="725">
                  <c:v>7.9111623531999999</c:v>
                </c:pt>
                <c:pt idx="726">
                  <c:v>17.731229601500001</c:v>
                </c:pt>
                <c:pt idx="727">
                  <c:v>21.10344491</c:v>
                </c:pt>
                <c:pt idx="728">
                  <c:v>11.9413011646</c:v>
                </c:pt>
                <c:pt idx="729">
                  <c:v>37.812489945400003</c:v>
                </c:pt>
                <c:pt idx="730">
                  <c:v>9.5179563820700004</c:v>
                </c:pt>
                <c:pt idx="731">
                  <c:v>11.262978365</c:v>
                </c:pt>
                <c:pt idx="732">
                  <c:v>2.9883198749100002</c:v>
                </c:pt>
                <c:pt idx="733">
                  <c:v>16.962366665899999</c:v>
                </c:pt>
                <c:pt idx="734">
                  <c:v>10.9193004543</c:v>
                </c:pt>
                <c:pt idx="735">
                  <c:v>1.8895315665200001</c:v>
                </c:pt>
                <c:pt idx="736">
                  <c:v>8.8269906454699996</c:v>
                </c:pt>
                <c:pt idx="737">
                  <c:v>16.597523258700001</c:v>
                </c:pt>
                <c:pt idx="738">
                  <c:v>3.97729617754</c:v>
                </c:pt>
                <c:pt idx="739">
                  <c:v>5.1108322495499996</c:v>
                </c:pt>
                <c:pt idx="740">
                  <c:v>1.70748982118</c:v>
                </c:pt>
                <c:pt idx="741">
                  <c:v>9.2618420429399997</c:v>
                </c:pt>
                <c:pt idx="742">
                  <c:v>6.0711570840800002</c:v>
                </c:pt>
                <c:pt idx="743">
                  <c:v>6.2868769863300002</c:v>
                </c:pt>
                <c:pt idx="744">
                  <c:v>6.3336718270199999</c:v>
                </c:pt>
                <c:pt idx="745">
                  <c:v>49.613485955500003</c:v>
                </c:pt>
                <c:pt idx="746">
                  <c:v>7.9408022250699997</c:v>
                </c:pt>
                <c:pt idx="747">
                  <c:v>65.010535192999996</c:v>
                </c:pt>
                <c:pt idx="748">
                  <c:v>9.9955589858299998</c:v>
                </c:pt>
                <c:pt idx="749">
                  <c:v>13.977904284099999</c:v>
                </c:pt>
                <c:pt idx="750">
                  <c:v>33.996412189300003</c:v>
                </c:pt>
                <c:pt idx="751">
                  <c:v>8.5993385817300005</c:v>
                </c:pt>
                <c:pt idx="752">
                  <c:v>4.4018355154300002</c:v>
                </c:pt>
                <c:pt idx="753">
                  <c:v>0.91483966734099997</c:v>
                </c:pt>
                <c:pt idx="754">
                  <c:v>16.568869423300001</c:v>
                </c:pt>
                <c:pt idx="755">
                  <c:v>4.8287570073500001</c:v>
                </c:pt>
                <c:pt idx="756">
                  <c:v>29.8970032792</c:v>
                </c:pt>
                <c:pt idx="757">
                  <c:v>8.2507085183300006</c:v>
                </c:pt>
                <c:pt idx="758">
                  <c:v>5.8769911366000001</c:v>
                </c:pt>
                <c:pt idx="759">
                  <c:v>4.6055984359000002</c:v>
                </c:pt>
                <c:pt idx="760">
                  <c:v>31.148205151900001</c:v>
                </c:pt>
                <c:pt idx="761">
                  <c:v>5.0246481008700004</c:v>
                </c:pt>
                <c:pt idx="762">
                  <c:v>23.924214110400001</c:v>
                </c:pt>
                <c:pt idx="763">
                  <c:v>18.304513501500001</c:v>
                </c:pt>
                <c:pt idx="764">
                  <c:v>18.059763565000001</c:v>
                </c:pt>
                <c:pt idx="765">
                  <c:v>6.0023394309800002</c:v>
                </c:pt>
                <c:pt idx="766">
                  <c:v>8.6967712904500001</c:v>
                </c:pt>
                <c:pt idx="767">
                  <c:v>29.5552615766</c:v>
                </c:pt>
                <c:pt idx="768">
                  <c:v>10.4670931454</c:v>
                </c:pt>
                <c:pt idx="769">
                  <c:v>5.1305715045499998</c:v>
                </c:pt>
                <c:pt idx="770">
                  <c:v>8.8896603430100001</c:v>
                </c:pt>
                <c:pt idx="771">
                  <c:v>15.243369491999999</c:v>
                </c:pt>
                <c:pt idx="772">
                  <c:v>25.758169145899998</c:v>
                </c:pt>
                <c:pt idx="773">
                  <c:v>18.7663895309</c:v>
                </c:pt>
                <c:pt idx="774">
                  <c:v>18.6226203469</c:v>
                </c:pt>
                <c:pt idx="775">
                  <c:v>3.2667034962799999</c:v>
                </c:pt>
                <c:pt idx="776">
                  <c:v>12.7143401465</c:v>
                </c:pt>
                <c:pt idx="777">
                  <c:v>10.102008635400001</c:v>
                </c:pt>
                <c:pt idx="778">
                  <c:v>20.376476567699999</c:v>
                </c:pt>
                <c:pt idx="779">
                  <c:v>12.5869371832</c:v>
                </c:pt>
                <c:pt idx="780">
                  <c:v>4.1336589955600003</c:v>
                </c:pt>
                <c:pt idx="781">
                  <c:v>1.3183792323600001</c:v>
                </c:pt>
                <c:pt idx="782">
                  <c:v>9.2591194198300002</c:v>
                </c:pt>
                <c:pt idx="783">
                  <c:v>36.855502127500003</c:v>
                </c:pt>
                <c:pt idx="784">
                  <c:v>17.925960724300001</c:v>
                </c:pt>
                <c:pt idx="785">
                  <c:v>26.3819009005</c:v>
                </c:pt>
                <c:pt idx="786">
                  <c:v>3.5028328483900002</c:v>
                </c:pt>
                <c:pt idx="787">
                  <c:v>3.9509223330799998</c:v>
                </c:pt>
                <c:pt idx="788">
                  <c:v>7.10042825812</c:v>
                </c:pt>
                <c:pt idx="789">
                  <c:v>18.400133277799998</c:v>
                </c:pt>
                <c:pt idx="790">
                  <c:v>35.342791056400003</c:v>
                </c:pt>
                <c:pt idx="791">
                  <c:v>10.655212383</c:v>
                </c:pt>
                <c:pt idx="792">
                  <c:v>3.0341574690300002</c:v>
                </c:pt>
                <c:pt idx="793">
                  <c:v>16.633268612999998</c:v>
                </c:pt>
                <c:pt idx="794">
                  <c:v>31.405655533200001</c:v>
                </c:pt>
                <c:pt idx="795">
                  <c:v>13.7738930967</c:v>
                </c:pt>
                <c:pt idx="796">
                  <c:v>10.0500424343</c:v>
                </c:pt>
                <c:pt idx="797">
                  <c:v>4.2118334214099997</c:v>
                </c:pt>
                <c:pt idx="798">
                  <c:v>11.9925463752</c:v>
                </c:pt>
                <c:pt idx="799">
                  <c:v>14.484005868600001</c:v>
                </c:pt>
                <c:pt idx="800">
                  <c:v>12.0682584332</c:v>
                </c:pt>
                <c:pt idx="801">
                  <c:v>5.8725272629000003</c:v>
                </c:pt>
                <c:pt idx="802">
                  <c:v>14.354702379100001</c:v>
                </c:pt>
                <c:pt idx="803">
                  <c:v>3.8158519202000001</c:v>
                </c:pt>
                <c:pt idx="804">
                  <c:v>46.919054686700001</c:v>
                </c:pt>
                <c:pt idx="805">
                  <c:v>9.4195323591799998</c:v>
                </c:pt>
                <c:pt idx="806">
                  <c:v>8.9004476960499996</c:v>
                </c:pt>
                <c:pt idx="807">
                  <c:v>50.774309320100002</c:v>
                </c:pt>
                <c:pt idx="808">
                  <c:v>6.0711128457900001</c:v>
                </c:pt>
                <c:pt idx="809">
                  <c:v>3.1088444496999998</c:v>
                </c:pt>
                <c:pt idx="810">
                  <c:v>6.7660509705300003</c:v>
                </c:pt>
                <c:pt idx="811">
                  <c:v>13.049701719</c:v>
                </c:pt>
                <c:pt idx="812">
                  <c:v>8.1061352948500005</c:v>
                </c:pt>
                <c:pt idx="813">
                  <c:v>10.867798859900001</c:v>
                </c:pt>
                <c:pt idx="814">
                  <c:v>8.5792547035400002</c:v>
                </c:pt>
                <c:pt idx="815">
                  <c:v>0.84206322663099997</c:v>
                </c:pt>
                <c:pt idx="816">
                  <c:v>6.9245329479500004</c:v>
                </c:pt>
                <c:pt idx="817">
                  <c:v>9.4554951907899998</c:v>
                </c:pt>
                <c:pt idx="818">
                  <c:v>16.6283095852</c:v>
                </c:pt>
                <c:pt idx="819">
                  <c:v>14.059779887099999</c:v>
                </c:pt>
                <c:pt idx="820">
                  <c:v>18.063702123199999</c:v>
                </c:pt>
                <c:pt idx="821">
                  <c:v>13.119371259499999</c:v>
                </c:pt>
                <c:pt idx="822">
                  <c:v>5.2453121278500001</c:v>
                </c:pt>
                <c:pt idx="823">
                  <c:v>2.5583833893599999</c:v>
                </c:pt>
                <c:pt idx="824">
                  <c:v>17.2750319381</c:v>
                </c:pt>
                <c:pt idx="825">
                  <c:v>44.5638376988</c:v>
                </c:pt>
                <c:pt idx="826">
                  <c:v>10.101908680599999</c:v>
                </c:pt>
                <c:pt idx="827">
                  <c:v>35.426365862200001</c:v>
                </c:pt>
                <c:pt idx="828">
                  <c:v>1.7374423972699999</c:v>
                </c:pt>
                <c:pt idx="829">
                  <c:v>30.095114449800001</c:v>
                </c:pt>
                <c:pt idx="830">
                  <c:v>7.0611983136900003</c:v>
                </c:pt>
                <c:pt idx="831">
                  <c:v>1.0831776407</c:v>
                </c:pt>
                <c:pt idx="832">
                  <c:v>11.810338245700001</c:v>
                </c:pt>
                <c:pt idx="833">
                  <c:v>5.9249974971999997</c:v>
                </c:pt>
                <c:pt idx="834">
                  <c:v>31.274597997600001</c:v>
                </c:pt>
                <c:pt idx="835">
                  <c:v>14.5748120924</c:v>
                </c:pt>
                <c:pt idx="836">
                  <c:v>5.4243489845099999</c:v>
                </c:pt>
                <c:pt idx="837">
                  <c:v>6.4366743340500001</c:v>
                </c:pt>
                <c:pt idx="838">
                  <c:v>18.426442408500002</c:v>
                </c:pt>
                <c:pt idx="839">
                  <c:v>8.4730489985700004</c:v>
                </c:pt>
                <c:pt idx="840">
                  <c:v>8.5803476291800003</c:v>
                </c:pt>
                <c:pt idx="841">
                  <c:v>29.1272650748</c:v>
                </c:pt>
                <c:pt idx="842">
                  <c:v>6.5007448393500002</c:v>
                </c:pt>
                <c:pt idx="843">
                  <c:v>6.1931687254999996</c:v>
                </c:pt>
                <c:pt idx="844">
                  <c:v>4.5894628195099996</c:v>
                </c:pt>
                <c:pt idx="845">
                  <c:v>3.1611744063899998</c:v>
                </c:pt>
                <c:pt idx="846">
                  <c:v>13.447746994899999</c:v>
                </c:pt>
                <c:pt idx="847">
                  <c:v>5.92400025314</c:v>
                </c:pt>
                <c:pt idx="848">
                  <c:v>16.075296409900002</c:v>
                </c:pt>
                <c:pt idx="849">
                  <c:v>24.6799300799</c:v>
                </c:pt>
                <c:pt idx="850">
                  <c:v>2.7565454764899999</c:v>
                </c:pt>
                <c:pt idx="851">
                  <c:v>2.2473000727499999</c:v>
                </c:pt>
                <c:pt idx="852">
                  <c:v>5.6807703651799999</c:v>
                </c:pt>
                <c:pt idx="853">
                  <c:v>7.6454383791399998</c:v>
                </c:pt>
                <c:pt idx="854">
                  <c:v>6.6948154397700002</c:v>
                </c:pt>
                <c:pt idx="855">
                  <c:v>16.983993549499999</c:v>
                </c:pt>
                <c:pt idx="856">
                  <c:v>21.3265894311</c:v>
                </c:pt>
                <c:pt idx="857">
                  <c:v>6.7294746073200002</c:v>
                </c:pt>
                <c:pt idx="858">
                  <c:v>6.5942629622700002</c:v>
                </c:pt>
                <c:pt idx="859">
                  <c:v>11.2767792006</c:v>
                </c:pt>
                <c:pt idx="860">
                  <c:v>2.9373317103300001</c:v>
                </c:pt>
                <c:pt idx="861">
                  <c:v>6.7419245708000002</c:v>
                </c:pt>
                <c:pt idx="862">
                  <c:v>15.667427500300001</c:v>
                </c:pt>
                <c:pt idx="863">
                  <c:v>6.7202074552999997</c:v>
                </c:pt>
                <c:pt idx="864">
                  <c:v>15.6718302537</c:v>
                </c:pt>
                <c:pt idx="865">
                  <c:v>7.3536031270300004</c:v>
                </c:pt>
                <c:pt idx="866">
                  <c:v>14.412951951</c:v>
                </c:pt>
                <c:pt idx="867">
                  <c:v>11.047494371699999</c:v>
                </c:pt>
                <c:pt idx="868">
                  <c:v>5.6817008118799999</c:v>
                </c:pt>
                <c:pt idx="869">
                  <c:v>31.473783612799998</c:v>
                </c:pt>
                <c:pt idx="870">
                  <c:v>10.1282871922</c:v>
                </c:pt>
                <c:pt idx="871">
                  <c:v>3.8981995703500001</c:v>
                </c:pt>
                <c:pt idx="872">
                  <c:v>12.333142974399999</c:v>
                </c:pt>
                <c:pt idx="873">
                  <c:v>10.8173185997</c:v>
                </c:pt>
                <c:pt idx="874">
                  <c:v>4.99120345546</c:v>
                </c:pt>
                <c:pt idx="875">
                  <c:v>19.020579906199998</c:v>
                </c:pt>
                <c:pt idx="876">
                  <c:v>4.5613041136000003</c:v>
                </c:pt>
                <c:pt idx="877">
                  <c:v>9.8922622587400006</c:v>
                </c:pt>
                <c:pt idx="878">
                  <c:v>9.6448869712800001</c:v>
                </c:pt>
                <c:pt idx="879">
                  <c:v>22.951280486000002</c:v>
                </c:pt>
                <c:pt idx="880">
                  <c:v>8.8364482656999996</c:v>
                </c:pt>
                <c:pt idx="881">
                  <c:v>6.2274691337499997</c:v>
                </c:pt>
                <c:pt idx="882">
                  <c:v>6.4318848920000002</c:v>
                </c:pt>
                <c:pt idx="883">
                  <c:v>8.2925601386800007</c:v>
                </c:pt>
                <c:pt idx="884">
                  <c:v>7.6762707585600003</c:v>
                </c:pt>
                <c:pt idx="885">
                  <c:v>6.6744683404899998</c:v>
                </c:pt>
                <c:pt idx="886">
                  <c:v>4.1253700258599997</c:v>
                </c:pt>
                <c:pt idx="887">
                  <c:v>10.5172729032</c:v>
                </c:pt>
                <c:pt idx="888">
                  <c:v>3.75393093409</c:v>
                </c:pt>
                <c:pt idx="889">
                  <c:v>8.1556237794699999</c:v>
                </c:pt>
                <c:pt idx="890">
                  <c:v>10.595153653100001</c:v>
                </c:pt>
                <c:pt idx="891">
                  <c:v>9.4356157289000002</c:v>
                </c:pt>
                <c:pt idx="892">
                  <c:v>8.5831354395599995</c:v>
                </c:pt>
                <c:pt idx="893">
                  <c:v>3.4569951751499999</c:v>
                </c:pt>
                <c:pt idx="894">
                  <c:v>6.3847736746199999</c:v>
                </c:pt>
                <c:pt idx="895">
                  <c:v>49.864086666799999</c:v>
                </c:pt>
                <c:pt idx="896">
                  <c:v>16.506969174000002</c:v>
                </c:pt>
                <c:pt idx="897">
                  <c:v>12.0090801029</c:v>
                </c:pt>
                <c:pt idx="898">
                  <c:v>7.6729013968500004</c:v>
                </c:pt>
                <c:pt idx="899">
                  <c:v>9.9339291290799991</c:v>
                </c:pt>
                <c:pt idx="900">
                  <c:v>11.9577845791</c:v>
                </c:pt>
                <c:pt idx="901">
                  <c:v>120.98701969</c:v>
                </c:pt>
                <c:pt idx="902">
                  <c:v>10.359279899600001</c:v>
                </c:pt>
                <c:pt idx="903">
                  <c:v>5.5004214491300001</c:v>
                </c:pt>
                <c:pt idx="904">
                  <c:v>7.4700924686399999</c:v>
                </c:pt>
                <c:pt idx="905">
                  <c:v>12.485096391500001</c:v>
                </c:pt>
                <c:pt idx="906">
                  <c:v>5.5185362925300003</c:v>
                </c:pt>
                <c:pt idx="907">
                  <c:v>10.983604572699999</c:v>
                </c:pt>
                <c:pt idx="908">
                  <c:v>29.221915248599998</c:v>
                </c:pt>
                <c:pt idx="909">
                  <c:v>21.331892211300001</c:v>
                </c:pt>
                <c:pt idx="910">
                  <c:v>9.6235315977900004</c:v>
                </c:pt>
                <c:pt idx="911">
                  <c:v>5.5017117334299996</c:v>
                </c:pt>
                <c:pt idx="912">
                  <c:v>4.0219020420099998</c:v>
                </c:pt>
                <c:pt idx="913">
                  <c:v>32.141594618200003</c:v>
                </c:pt>
                <c:pt idx="914">
                  <c:v>7.6614550894700004</c:v>
                </c:pt>
                <c:pt idx="915">
                  <c:v>6.5859153984900001</c:v>
                </c:pt>
                <c:pt idx="916">
                  <c:v>9.4466331545600006</c:v>
                </c:pt>
                <c:pt idx="917">
                  <c:v>5.8640535246800001</c:v>
                </c:pt>
                <c:pt idx="918">
                  <c:v>128.666479544</c:v>
                </c:pt>
                <c:pt idx="919">
                  <c:v>3.9093852198799999</c:v>
                </c:pt>
                <c:pt idx="920">
                  <c:v>2.7254764715099999</c:v>
                </c:pt>
                <c:pt idx="921">
                  <c:v>5.1011578464299996</c:v>
                </c:pt>
                <c:pt idx="922">
                  <c:v>16.2211382208</c:v>
                </c:pt>
                <c:pt idx="923">
                  <c:v>14.2214015939</c:v>
                </c:pt>
                <c:pt idx="924">
                  <c:v>9.0624979774799996</c:v>
                </c:pt>
                <c:pt idx="925">
                  <c:v>9.3428233354600003</c:v>
                </c:pt>
                <c:pt idx="926">
                  <c:v>2.9438121326300002</c:v>
                </c:pt>
                <c:pt idx="927">
                  <c:v>9.4257691154599996</c:v>
                </c:pt>
                <c:pt idx="928">
                  <c:v>17.285980155299999</c:v>
                </c:pt>
                <c:pt idx="929">
                  <c:v>19.107820606400001</c:v>
                </c:pt>
                <c:pt idx="930">
                  <c:v>16.1193091373</c:v>
                </c:pt>
                <c:pt idx="931">
                  <c:v>11.5925154711</c:v>
                </c:pt>
                <c:pt idx="932">
                  <c:v>31.872787679200002</c:v>
                </c:pt>
                <c:pt idx="933">
                  <c:v>2.3739794998899999</c:v>
                </c:pt>
                <c:pt idx="934">
                  <c:v>3.7785396918799998</c:v>
                </c:pt>
                <c:pt idx="935">
                  <c:v>9.9538187029100005</c:v>
                </c:pt>
                <c:pt idx="936">
                  <c:v>7.3922808871400001</c:v>
                </c:pt>
                <c:pt idx="937">
                  <c:v>6.3119747879499997</c:v>
                </c:pt>
                <c:pt idx="938">
                  <c:v>19.843132795500001</c:v>
                </c:pt>
                <c:pt idx="939">
                  <c:v>36.642120999100001</c:v>
                </c:pt>
                <c:pt idx="940">
                  <c:v>54.872000996399997</c:v>
                </c:pt>
                <c:pt idx="941">
                  <c:v>6.2953122545699998</c:v>
                </c:pt>
                <c:pt idx="942">
                  <c:v>7.4041039195399998</c:v>
                </c:pt>
                <c:pt idx="943">
                  <c:v>9.3432012195199992</c:v>
                </c:pt>
                <c:pt idx="944">
                  <c:v>9.0162296013500001</c:v>
                </c:pt>
                <c:pt idx="945">
                  <c:v>5.2740861468800002</c:v>
                </c:pt>
                <c:pt idx="946">
                  <c:v>9.4101815006000002</c:v>
                </c:pt>
                <c:pt idx="947">
                  <c:v>48.206913436000001</c:v>
                </c:pt>
                <c:pt idx="948">
                  <c:v>5.75118040015</c:v>
                </c:pt>
                <c:pt idx="949">
                  <c:v>19.334507028200001</c:v>
                </c:pt>
                <c:pt idx="950">
                  <c:v>0.44472100499299999</c:v>
                </c:pt>
                <c:pt idx="951">
                  <c:v>8.2670280494800004</c:v>
                </c:pt>
                <c:pt idx="952">
                  <c:v>9.5177294427600003</c:v>
                </c:pt>
                <c:pt idx="953">
                  <c:v>11.3556693387</c:v>
                </c:pt>
                <c:pt idx="954">
                  <c:v>4.1500998228499997</c:v>
                </c:pt>
                <c:pt idx="955">
                  <c:v>23.954536022799999</c:v>
                </c:pt>
                <c:pt idx="956">
                  <c:v>16.093430232700001</c:v>
                </c:pt>
                <c:pt idx="957">
                  <c:v>22.633784559399999</c:v>
                </c:pt>
                <c:pt idx="958">
                  <c:v>41.8593575696</c:v>
                </c:pt>
                <c:pt idx="959">
                  <c:v>19.4580631555</c:v>
                </c:pt>
                <c:pt idx="960">
                  <c:v>5.4120380824199996</c:v>
                </c:pt>
                <c:pt idx="961">
                  <c:v>2.6398030316800001</c:v>
                </c:pt>
                <c:pt idx="962">
                  <c:v>8.7530593208600003</c:v>
                </c:pt>
                <c:pt idx="963">
                  <c:v>8.7534413666099997</c:v>
                </c:pt>
                <c:pt idx="964">
                  <c:v>17.256339122699998</c:v>
                </c:pt>
                <c:pt idx="965">
                  <c:v>3.93538663485</c:v>
                </c:pt>
                <c:pt idx="966">
                  <c:v>18.118604765299999</c:v>
                </c:pt>
                <c:pt idx="967">
                  <c:v>9.3144680304800005</c:v>
                </c:pt>
                <c:pt idx="968">
                  <c:v>6.1555408647399998</c:v>
                </c:pt>
                <c:pt idx="969">
                  <c:v>6.8376379751599998</c:v>
                </c:pt>
                <c:pt idx="970">
                  <c:v>3.15827717712</c:v>
                </c:pt>
                <c:pt idx="971">
                  <c:v>18.578258951199999</c:v>
                </c:pt>
                <c:pt idx="972">
                  <c:v>11.2544486235</c:v>
                </c:pt>
                <c:pt idx="973">
                  <c:v>7.4245595747699999</c:v>
                </c:pt>
                <c:pt idx="974">
                  <c:v>2.87194669946</c:v>
                </c:pt>
                <c:pt idx="975">
                  <c:v>9.2916951491800006</c:v>
                </c:pt>
                <c:pt idx="976">
                  <c:v>10.2200987553</c:v>
                </c:pt>
                <c:pt idx="977">
                  <c:v>12.704273882200001</c:v>
                </c:pt>
                <c:pt idx="978">
                  <c:v>8.5704751329099995</c:v>
                </c:pt>
                <c:pt idx="979">
                  <c:v>13.5659354362</c:v>
                </c:pt>
                <c:pt idx="980">
                  <c:v>27.539739663599999</c:v>
                </c:pt>
                <c:pt idx="981">
                  <c:v>3.2852502658099998</c:v>
                </c:pt>
                <c:pt idx="982">
                  <c:v>35.127274650499999</c:v>
                </c:pt>
                <c:pt idx="983">
                  <c:v>24.837054988799999</c:v>
                </c:pt>
                <c:pt idx="984">
                  <c:v>10.5598239282</c:v>
                </c:pt>
                <c:pt idx="985">
                  <c:v>35.577055475400002</c:v>
                </c:pt>
                <c:pt idx="986">
                  <c:v>17.880408558399999</c:v>
                </c:pt>
                <c:pt idx="987">
                  <c:v>15.2106848107</c:v>
                </c:pt>
                <c:pt idx="988">
                  <c:v>13.0490630394</c:v>
                </c:pt>
                <c:pt idx="989">
                  <c:v>17.781385821600001</c:v>
                </c:pt>
                <c:pt idx="990">
                  <c:v>1.7897485344999999</c:v>
                </c:pt>
                <c:pt idx="991">
                  <c:v>9.6226358575800006</c:v>
                </c:pt>
                <c:pt idx="992">
                  <c:v>21.3140700483</c:v>
                </c:pt>
                <c:pt idx="993">
                  <c:v>22.918235006</c:v>
                </c:pt>
                <c:pt idx="994">
                  <c:v>24.511557556500001</c:v>
                </c:pt>
                <c:pt idx="995">
                  <c:v>7.4036876975899997</c:v>
                </c:pt>
                <c:pt idx="996">
                  <c:v>4.4020886818099996</c:v>
                </c:pt>
                <c:pt idx="997">
                  <c:v>7.5163451905100001</c:v>
                </c:pt>
                <c:pt idx="998">
                  <c:v>15.53035592</c:v>
                </c:pt>
                <c:pt idx="999">
                  <c:v>8.3646223767199999</c:v>
                </c:pt>
                <c:pt idx="1000">
                  <c:v>8.7587574963900003</c:v>
                </c:pt>
                <c:pt idx="1001">
                  <c:v>10.242988455500001</c:v>
                </c:pt>
                <c:pt idx="1002">
                  <c:v>10.5657127354</c:v>
                </c:pt>
                <c:pt idx="1003">
                  <c:v>8.3460804586300004</c:v>
                </c:pt>
                <c:pt idx="1004">
                  <c:v>6.6199850515899996</c:v>
                </c:pt>
                <c:pt idx="1005">
                  <c:v>8.42625156179</c:v>
                </c:pt>
                <c:pt idx="1006">
                  <c:v>2.0854541916199998</c:v>
                </c:pt>
                <c:pt idx="1007">
                  <c:v>20.3560693694</c:v>
                </c:pt>
                <c:pt idx="1008">
                  <c:v>5.3475283063100001</c:v>
                </c:pt>
                <c:pt idx="1009">
                  <c:v>4.9660486795400001</c:v>
                </c:pt>
                <c:pt idx="1010">
                  <c:v>26.6710372537</c:v>
                </c:pt>
                <c:pt idx="1011">
                  <c:v>8.9930943998899995</c:v>
                </c:pt>
                <c:pt idx="1012">
                  <c:v>16.161273692000002</c:v>
                </c:pt>
                <c:pt idx="1013">
                  <c:v>20.930486861799999</c:v>
                </c:pt>
                <c:pt idx="1014">
                  <c:v>5.8627746705300003</c:v>
                </c:pt>
                <c:pt idx="1015">
                  <c:v>7.8034833643199999</c:v>
                </c:pt>
                <c:pt idx="1016">
                  <c:v>3.0023525760299998</c:v>
                </c:pt>
                <c:pt idx="1017">
                  <c:v>9.4493724281800002</c:v>
                </c:pt>
                <c:pt idx="1018">
                  <c:v>13.3126272067</c:v>
                </c:pt>
                <c:pt idx="1019">
                  <c:v>2.4450178986800002</c:v>
                </c:pt>
                <c:pt idx="1020">
                  <c:v>9.5885687216700006</c:v>
                </c:pt>
                <c:pt idx="1021">
                  <c:v>9.1219154615600004</c:v>
                </c:pt>
                <c:pt idx="1022">
                  <c:v>5.9805311093600002</c:v>
                </c:pt>
                <c:pt idx="1023">
                  <c:v>13.057401910799999</c:v>
                </c:pt>
                <c:pt idx="1024">
                  <c:v>2.0817531698699998</c:v>
                </c:pt>
                <c:pt idx="1025">
                  <c:v>6.3614802291599997</c:v>
                </c:pt>
                <c:pt idx="1026">
                  <c:v>10.6790521904</c:v>
                </c:pt>
                <c:pt idx="1027">
                  <c:v>7.2094401962700001</c:v>
                </c:pt>
                <c:pt idx="1028">
                  <c:v>11.836838505899999</c:v>
                </c:pt>
                <c:pt idx="1029">
                  <c:v>19.8464635578</c:v>
                </c:pt>
                <c:pt idx="1030">
                  <c:v>4.1019973836699997</c:v>
                </c:pt>
                <c:pt idx="1031">
                  <c:v>51.578895633099997</c:v>
                </c:pt>
                <c:pt idx="1032">
                  <c:v>9.2843949596000002</c:v>
                </c:pt>
                <c:pt idx="1033">
                  <c:v>13.005429354</c:v>
                </c:pt>
                <c:pt idx="1034">
                  <c:v>15.3875386693</c:v>
                </c:pt>
                <c:pt idx="1035">
                  <c:v>9.3709209891699992</c:v>
                </c:pt>
                <c:pt idx="1036">
                  <c:v>6.6797700860200004</c:v>
                </c:pt>
                <c:pt idx="1037">
                  <c:v>23.755070088499998</c:v>
                </c:pt>
                <c:pt idx="1038">
                  <c:v>13.036918398699999</c:v>
                </c:pt>
                <c:pt idx="1039">
                  <c:v>14.551151603499999</c:v>
                </c:pt>
                <c:pt idx="1040">
                  <c:v>18.052760945399999</c:v>
                </c:pt>
                <c:pt idx="1041">
                  <c:v>23.528387479999999</c:v>
                </c:pt>
                <c:pt idx="1042">
                  <c:v>9.2961065965799996</c:v>
                </c:pt>
                <c:pt idx="1043">
                  <c:v>9.5081619246999995</c:v>
                </c:pt>
                <c:pt idx="1044">
                  <c:v>20.842206107100001</c:v>
                </c:pt>
                <c:pt idx="1045">
                  <c:v>20.0346875559</c:v>
                </c:pt>
                <c:pt idx="1046">
                  <c:v>4.5087819300599996</c:v>
                </c:pt>
                <c:pt idx="1047">
                  <c:v>13.6743685602</c:v>
                </c:pt>
                <c:pt idx="1048">
                  <c:v>14.8329274749</c:v>
                </c:pt>
                <c:pt idx="1049">
                  <c:v>8.5513778192699998</c:v>
                </c:pt>
                <c:pt idx="1050">
                  <c:v>13.880256833100001</c:v>
                </c:pt>
                <c:pt idx="1051">
                  <c:v>12.260333531300001</c:v>
                </c:pt>
                <c:pt idx="1052">
                  <c:v>22.4778206756</c:v>
                </c:pt>
                <c:pt idx="1053">
                  <c:v>10.3459605547</c:v>
                </c:pt>
                <c:pt idx="1054">
                  <c:v>26.184208446900001</c:v>
                </c:pt>
                <c:pt idx="1055">
                  <c:v>6.1374619521599998</c:v>
                </c:pt>
                <c:pt idx="1056">
                  <c:v>7.7408789600199999</c:v>
                </c:pt>
                <c:pt idx="1057">
                  <c:v>33.9716118845</c:v>
                </c:pt>
                <c:pt idx="1058">
                  <c:v>6.7044069577599998</c:v>
                </c:pt>
                <c:pt idx="1059">
                  <c:v>19.208994019199999</c:v>
                </c:pt>
                <c:pt idx="1060">
                  <c:v>13.7473881586</c:v>
                </c:pt>
                <c:pt idx="1061">
                  <c:v>10.5276748236</c:v>
                </c:pt>
                <c:pt idx="1062">
                  <c:v>2.8318552296299999</c:v>
                </c:pt>
                <c:pt idx="1063">
                  <c:v>18.4830786132</c:v>
                </c:pt>
                <c:pt idx="1064">
                  <c:v>6.3420399940100003</c:v>
                </c:pt>
                <c:pt idx="1065">
                  <c:v>11.353514368100001</c:v>
                </c:pt>
                <c:pt idx="1066">
                  <c:v>17.068937395999999</c:v>
                </c:pt>
                <c:pt idx="1067">
                  <c:v>5.4122031384699998</c:v>
                </c:pt>
                <c:pt idx="1068">
                  <c:v>9.0247813852600007</c:v>
                </c:pt>
                <c:pt idx="1069">
                  <c:v>11.1143154386</c:v>
                </c:pt>
                <c:pt idx="1070">
                  <c:v>8.45624717868</c:v>
                </c:pt>
                <c:pt idx="1071">
                  <c:v>7.6607740738899999</c:v>
                </c:pt>
                <c:pt idx="1072">
                  <c:v>3.6274310241799999</c:v>
                </c:pt>
                <c:pt idx="1073">
                  <c:v>8.1542259380500006</c:v>
                </c:pt>
                <c:pt idx="1074">
                  <c:v>6.9915729225099996</c:v>
                </c:pt>
                <c:pt idx="1075">
                  <c:v>9.1224302701099997</c:v>
                </c:pt>
                <c:pt idx="1076">
                  <c:v>12.0314265612</c:v>
                </c:pt>
                <c:pt idx="1077">
                  <c:v>10.2764815063</c:v>
                </c:pt>
                <c:pt idx="1078">
                  <c:v>9.6238042347599997</c:v>
                </c:pt>
                <c:pt idx="1079">
                  <c:v>8.8123973490100003</c:v>
                </c:pt>
                <c:pt idx="1080">
                  <c:v>37.493312380399999</c:v>
                </c:pt>
                <c:pt idx="1081">
                  <c:v>9.0140285353199996</c:v>
                </c:pt>
                <c:pt idx="1082">
                  <c:v>6.7921419103599998</c:v>
                </c:pt>
                <c:pt idx="1083">
                  <c:v>14.742927401499999</c:v>
                </c:pt>
                <c:pt idx="1084">
                  <c:v>18.7441496832</c:v>
                </c:pt>
                <c:pt idx="1085">
                  <c:v>13.615652859000001</c:v>
                </c:pt>
                <c:pt idx="1086">
                  <c:v>16.614613963499998</c:v>
                </c:pt>
                <c:pt idx="1087">
                  <c:v>14.861200844400001</c:v>
                </c:pt>
                <c:pt idx="1088">
                  <c:v>2.15675722803</c:v>
                </c:pt>
                <c:pt idx="1089">
                  <c:v>8.4850456638900003</c:v>
                </c:pt>
                <c:pt idx="1090">
                  <c:v>9.7668462416500006</c:v>
                </c:pt>
                <c:pt idx="1091">
                  <c:v>8.7990813923900006</c:v>
                </c:pt>
                <c:pt idx="1092">
                  <c:v>10.867073741900001</c:v>
                </c:pt>
                <c:pt idx="1093">
                  <c:v>12.823999449800001</c:v>
                </c:pt>
                <c:pt idx="1094">
                  <c:v>4.8894044617299999</c:v>
                </c:pt>
                <c:pt idx="1095">
                  <c:v>9.65683082312</c:v>
                </c:pt>
                <c:pt idx="1096">
                  <c:v>9.3537227165800001</c:v>
                </c:pt>
                <c:pt idx="1097">
                  <c:v>6.3229070138900001</c:v>
                </c:pt>
                <c:pt idx="1098">
                  <c:v>16.049515468700001</c:v>
                </c:pt>
                <c:pt idx="1099">
                  <c:v>6.1000725495100001</c:v>
                </c:pt>
                <c:pt idx="1100">
                  <c:v>1.6977017509700001</c:v>
                </c:pt>
                <c:pt idx="1101">
                  <c:v>3.5647336108199998</c:v>
                </c:pt>
                <c:pt idx="1102">
                  <c:v>66.462811050799999</c:v>
                </c:pt>
                <c:pt idx="1103">
                  <c:v>31.7971834487</c:v>
                </c:pt>
                <c:pt idx="1104">
                  <c:v>11.3582147322</c:v>
                </c:pt>
                <c:pt idx="1105">
                  <c:v>5.4735000964599996</c:v>
                </c:pt>
                <c:pt idx="1106">
                  <c:v>7.3430826085299996</c:v>
                </c:pt>
                <c:pt idx="1107">
                  <c:v>22.429535728099999</c:v>
                </c:pt>
                <c:pt idx="1108">
                  <c:v>20.1824537195</c:v>
                </c:pt>
                <c:pt idx="1109">
                  <c:v>7.9328244405000001</c:v>
                </c:pt>
                <c:pt idx="1110">
                  <c:v>8.6928298741300001</c:v>
                </c:pt>
                <c:pt idx="1111">
                  <c:v>23.7504734589</c:v>
                </c:pt>
                <c:pt idx="1112">
                  <c:v>163.69255894400001</c:v>
                </c:pt>
                <c:pt idx="1113">
                  <c:v>5.98131508175</c:v>
                </c:pt>
                <c:pt idx="1114">
                  <c:v>3.0395384201</c:v>
                </c:pt>
                <c:pt idx="1115">
                  <c:v>19.1752951516</c:v>
                </c:pt>
                <c:pt idx="1116">
                  <c:v>6.3532093404900003</c:v>
                </c:pt>
                <c:pt idx="1117">
                  <c:v>36.951304502600003</c:v>
                </c:pt>
                <c:pt idx="1118">
                  <c:v>0.97832176531799997</c:v>
                </c:pt>
                <c:pt idx="1119">
                  <c:v>6.4419040994900003</c:v>
                </c:pt>
                <c:pt idx="1120">
                  <c:v>2.8525284369600001</c:v>
                </c:pt>
                <c:pt idx="1121">
                  <c:v>14.311891472199999</c:v>
                </c:pt>
                <c:pt idx="1122">
                  <c:v>12.0470617771</c:v>
                </c:pt>
                <c:pt idx="1123">
                  <c:v>1.50659871522</c:v>
                </c:pt>
                <c:pt idx="1124">
                  <c:v>12.3152212029</c:v>
                </c:pt>
                <c:pt idx="1125">
                  <c:v>21.375040369499999</c:v>
                </c:pt>
                <c:pt idx="1126">
                  <c:v>4.8606482196099998</c:v>
                </c:pt>
                <c:pt idx="1127">
                  <c:v>6.6013767360099997</c:v>
                </c:pt>
                <c:pt idx="1128">
                  <c:v>2.50861250645</c:v>
                </c:pt>
                <c:pt idx="1129">
                  <c:v>12.946966570700001</c:v>
                </c:pt>
                <c:pt idx="1130">
                  <c:v>3.6706205546000001</c:v>
                </c:pt>
                <c:pt idx="1131">
                  <c:v>10.080385681299999</c:v>
                </c:pt>
                <c:pt idx="1132">
                  <c:v>24.456908082999998</c:v>
                </c:pt>
                <c:pt idx="1133">
                  <c:v>14.556803868899999</c:v>
                </c:pt>
                <c:pt idx="1134">
                  <c:v>2.85231684231</c:v>
                </c:pt>
                <c:pt idx="1135">
                  <c:v>10.694530993100001</c:v>
                </c:pt>
                <c:pt idx="1136">
                  <c:v>7.9939338660899999</c:v>
                </c:pt>
                <c:pt idx="1137">
                  <c:v>9.8356636239899995</c:v>
                </c:pt>
                <c:pt idx="1138">
                  <c:v>117.664417761</c:v>
                </c:pt>
                <c:pt idx="1139">
                  <c:v>6.78084969909</c:v>
                </c:pt>
                <c:pt idx="1140">
                  <c:v>12.499049726499999</c:v>
                </c:pt>
                <c:pt idx="1141">
                  <c:v>21.848923518599999</c:v>
                </c:pt>
                <c:pt idx="1142">
                  <c:v>7.3808365076999998</c:v>
                </c:pt>
                <c:pt idx="1143">
                  <c:v>9.4217869542199999</c:v>
                </c:pt>
                <c:pt idx="1144">
                  <c:v>16.370717210399999</c:v>
                </c:pt>
                <c:pt idx="1145">
                  <c:v>7.2791359495499997</c:v>
                </c:pt>
                <c:pt idx="1146">
                  <c:v>4.9643303595799999</c:v>
                </c:pt>
                <c:pt idx="1147">
                  <c:v>38.353847822200002</c:v>
                </c:pt>
                <c:pt idx="1148">
                  <c:v>17.099504196200002</c:v>
                </c:pt>
                <c:pt idx="1149">
                  <c:v>28.075276046799999</c:v>
                </c:pt>
                <c:pt idx="1150">
                  <c:v>41.6049130842</c:v>
                </c:pt>
                <c:pt idx="1151">
                  <c:v>10.8639101821</c:v>
                </c:pt>
                <c:pt idx="1152">
                  <c:v>18.283925669399999</c:v>
                </c:pt>
                <c:pt idx="1153">
                  <c:v>41.3162384707</c:v>
                </c:pt>
                <c:pt idx="1154">
                  <c:v>5.5584343492699997</c:v>
                </c:pt>
                <c:pt idx="1155">
                  <c:v>14.4538246318</c:v>
                </c:pt>
                <c:pt idx="1156">
                  <c:v>5.2878616252299997</c:v>
                </c:pt>
                <c:pt idx="1157">
                  <c:v>26.524407984100002</c:v>
                </c:pt>
                <c:pt idx="1158">
                  <c:v>4.5307415419800003</c:v>
                </c:pt>
                <c:pt idx="1159">
                  <c:v>21.878791205599999</c:v>
                </c:pt>
                <c:pt idx="1160">
                  <c:v>11.0381495754</c:v>
                </c:pt>
                <c:pt idx="1161">
                  <c:v>31.358103053499999</c:v>
                </c:pt>
                <c:pt idx="1162">
                  <c:v>10.2570639439</c:v>
                </c:pt>
                <c:pt idx="1163">
                  <c:v>29.889754117599999</c:v>
                </c:pt>
                <c:pt idx="1164">
                  <c:v>17.896220170199999</c:v>
                </c:pt>
                <c:pt idx="1165">
                  <c:v>23.6509187154</c:v>
                </c:pt>
                <c:pt idx="1166">
                  <c:v>6.3607448133600002</c:v>
                </c:pt>
                <c:pt idx="1167">
                  <c:v>7.2689902131900004</c:v>
                </c:pt>
                <c:pt idx="1168">
                  <c:v>9.0853203258300006</c:v>
                </c:pt>
                <c:pt idx="1169">
                  <c:v>11.1473876167</c:v>
                </c:pt>
                <c:pt idx="1170">
                  <c:v>32.913438300400003</c:v>
                </c:pt>
                <c:pt idx="1171">
                  <c:v>3.91433782496</c:v>
                </c:pt>
                <c:pt idx="1172">
                  <c:v>12.6072749386</c:v>
                </c:pt>
                <c:pt idx="1173">
                  <c:v>24.3274085961</c:v>
                </c:pt>
                <c:pt idx="1174">
                  <c:v>3.7633847312499999</c:v>
                </c:pt>
                <c:pt idx="1175">
                  <c:v>9.9402419572799996</c:v>
                </c:pt>
                <c:pt idx="1176">
                  <c:v>7.17629088252</c:v>
                </c:pt>
                <c:pt idx="1177">
                  <c:v>15.310334791700001</c:v>
                </c:pt>
                <c:pt idx="1178">
                  <c:v>4.8405038454699998</c:v>
                </c:pt>
                <c:pt idx="1179">
                  <c:v>30.836536552599998</c:v>
                </c:pt>
                <c:pt idx="1180">
                  <c:v>12.9651784966</c:v>
                </c:pt>
                <c:pt idx="1181">
                  <c:v>34.344817154799998</c:v>
                </c:pt>
                <c:pt idx="1182">
                  <c:v>34.689139003299999</c:v>
                </c:pt>
                <c:pt idx="1183">
                  <c:v>4.9272828102500004</c:v>
                </c:pt>
                <c:pt idx="1184">
                  <c:v>10.172767456800001</c:v>
                </c:pt>
                <c:pt idx="1185">
                  <c:v>9.5818250208499993</c:v>
                </c:pt>
                <c:pt idx="1186">
                  <c:v>1.5958051151199999</c:v>
                </c:pt>
                <c:pt idx="1187">
                  <c:v>8.0832839337499998</c:v>
                </c:pt>
                <c:pt idx="1188">
                  <c:v>6.24554183439</c:v>
                </c:pt>
                <c:pt idx="1189">
                  <c:v>9.7001664940300003</c:v>
                </c:pt>
                <c:pt idx="1190">
                  <c:v>19.4206336365</c:v>
                </c:pt>
                <c:pt idx="1191">
                  <c:v>10.768651419899999</c:v>
                </c:pt>
                <c:pt idx="1192">
                  <c:v>1.1928177418799999</c:v>
                </c:pt>
                <c:pt idx="1193">
                  <c:v>11.245098975699999</c:v>
                </c:pt>
                <c:pt idx="1194">
                  <c:v>4.4544958490999997</c:v>
                </c:pt>
                <c:pt idx="1195">
                  <c:v>3.9632732210100001</c:v>
                </c:pt>
                <c:pt idx="1196">
                  <c:v>13.2555179547</c:v>
                </c:pt>
                <c:pt idx="1197">
                  <c:v>11.491019699400001</c:v>
                </c:pt>
                <c:pt idx="1198">
                  <c:v>10.1366380936</c:v>
                </c:pt>
                <c:pt idx="1199">
                  <c:v>13.4198960634</c:v>
                </c:pt>
                <c:pt idx="1200">
                  <c:v>6.9995075208999999</c:v>
                </c:pt>
                <c:pt idx="1201">
                  <c:v>4.7529389102600001</c:v>
                </c:pt>
                <c:pt idx="1202">
                  <c:v>9.2028514893699995</c:v>
                </c:pt>
                <c:pt idx="1203">
                  <c:v>4.5063308587000002</c:v>
                </c:pt>
                <c:pt idx="1204">
                  <c:v>15.059592482099999</c:v>
                </c:pt>
                <c:pt idx="1205">
                  <c:v>12.5757859532</c:v>
                </c:pt>
                <c:pt idx="1206">
                  <c:v>15.8376356393</c:v>
                </c:pt>
                <c:pt idx="1207">
                  <c:v>11.8538779367</c:v>
                </c:pt>
                <c:pt idx="1208">
                  <c:v>3.5092530534500002</c:v>
                </c:pt>
                <c:pt idx="1209">
                  <c:v>9.4291439400799995</c:v>
                </c:pt>
                <c:pt idx="1210">
                  <c:v>6.0288862843700004</c:v>
                </c:pt>
                <c:pt idx="1211">
                  <c:v>5.1286125647</c:v>
                </c:pt>
                <c:pt idx="1212">
                  <c:v>60.757666928399999</c:v>
                </c:pt>
                <c:pt idx="1213">
                  <c:v>44.069369977100003</c:v>
                </c:pt>
                <c:pt idx="1214">
                  <c:v>1.4462524966700001</c:v>
                </c:pt>
                <c:pt idx="1215">
                  <c:v>6.3444565817900003</c:v>
                </c:pt>
                <c:pt idx="1216">
                  <c:v>10.029814248499999</c:v>
                </c:pt>
                <c:pt idx="1217">
                  <c:v>17.207291130600002</c:v>
                </c:pt>
                <c:pt idx="1218">
                  <c:v>14.3942480477</c:v>
                </c:pt>
                <c:pt idx="1219">
                  <c:v>12.7553678811</c:v>
                </c:pt>
                <c:pt idx="1220">
                  <c:v>14.7727631406</c:v>
                </c:pt>
                <c:pt idx="1221">
                  <c:v>6.83833124883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591-42F9-B615-933BC7EBC4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766380800"/>
        <c:axId val="-1766375360"/>
      </c:scatterChart>
      <c:valAx>
        <c:axId val="-1766380800"/>
        <c:scaling>
          <c:orientation val="minMax"/>
          <c:max val="8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 smtClean="0">
                    <a:solidFill>
                      <a:sysClr val="windowText" lastClr="000000"/>
                    </a:solidFill>
                  </a:rPr>
                  <a:t>FPKM (AF1q)</a:t>
                </a:r>
                <a:endParaRPr lang="en-US" sz="1400" b="1" dirty="0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766375360"/>
        <c:crosses val="autoZero"/>
        <c:crossBetween val="midCat"/>
      </c:valAx>
      <c:valAx>
        <c:axId val="-1766375360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dirty="0" smtClean="0">
                    <a:solidFill>
                      <a:sysClr val="windowText" lastClr="000000"/>
                    </a:solidFill>
                  </a:rPr>
                  <a:t>FPKM</a:t>
                </a:r>
                <a:r>
                  <a:rPr lang="en-US" sz="1400" b="1" baseline="0" dirty="0" smtClean="0">
                    <a:solidFill>
                      <a:sysClr val="windowText" lastClr="000000"/>
                    </a:solidFill>
                  </a:rPr>
                  <a:t> (ICAM1)</a:t>
                </a:r>
                <a:endParaRPr lang="en-US" sz="1400" b="1" dirty="0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7663808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284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13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730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122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353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52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186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817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307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223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843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0089D-C706-4302-97B7-12B5ABE4C0E1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DC648-305D-4304-B622-3404A5BA9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948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3183" y="5494351"/>
            <a:ext cx="96926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</a:t>
            </a:r>
            <a:r>
              <a:rPr lang="en-US" dirty="0" smtClean="0"/>
              <a:t>upplementary Fig S1. </a:t>
            </a:r>
            <a:r>
              <a:rPr lang="en-US" dirty="0"/>
              <a:t>Scatter plot using FPKM values of AF1q and ICAM-1. Publicly available 1,222 RNA-</a:t>
            </a:r>
            <a:r>
              <a:rPr lang="en-US" dirty="0" err="1"/>
              <a:t>Seq</a:t>
            </a:r>
            <a:r>
              <a:rPr lang="en-US" dirty="0"/>
              <a:t> data of 1,092 breast cancer cases from TCGA database are used. When FPKM of AF1q is high, that of ICAM-1 is low, supporting that overexpression of AF1q attenuates ICAM-1 expression.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0991841"/>
              </p:ext>
            </p:extLst>
          </p:nvPr>
        </p:nvGraphicFramePr>
        <p:xfrm>
          <a:off x="3466755" y="1682159"/>
          <a:ext cx="5258490" cy="3256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49540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6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Brow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,Jino</dc:creator>
  <cp:lastModifiedBy>Park,Jino</cp:lastModifiedBy>
  <cp:revision>2</cp:revision>
  <dcterms:created xsi:type="dcterms:W3CDTF">2019-01-14T15:57:17Z</dcterms:created>
  <dcterms:modified xsi:type="dcterms:W3CDTF">2019-01-14T16:29:45Z</dcterms:modified>
</cp:coreProperties>
</file>